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authors.xml" ContentType="application/vnd.ms-powerpoint.author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1" r:id="rId4"/>
  </p:sldMasterIdLst>
  <p:notesMasterIdLst>
    <p:notesMasterId r:id="rId12"/>
  </p:notesMasterIdLst>
  <p:sldIdLst>
    <p:sldId id="261" r:id="rId5"/>
    <p:sldId id="287" r:id="rId6"/>
    <p:sldId id="262" r:id="rId7"/>
    <p:sldId id="284" r:id="rId8"/>
    <p:sldId id="288" r:id="rId9"/>
    <p:sldId id="277" r:id="rId10"/>
    <p:sldId id="280" r:id="rId11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E902D010-4876-3F42-8712-DBC24F53E2A6}" name="Church, Cameron Lee" initials="CL" userId="S::cchur388@uab.edu::8330908f-7e6c-4f5c-9bd8-4165b5c4168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81BF"/>
    <a:srgbClr val="F1930B"/>
    <a:srgbClr val="984EA3"/>
    <a:srgbClr val="4DAF4A"/>
    <a:srgbClr val="377EB8"/>
    <a:srgbClr val="E41B1D"/>
    <a:srgbClr val="A65628"/>
    <a:srgbClr val="BC9DCC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7FFFDBD-6FF9-48EB-A3AC-23C62812EA00}" v="189" dt="2024-06-02T19:37:50.44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72" autoAdjust="0"/>
    <p:restoredTop sz="92714" autoAdjust="0"/>
  </p:normalViewPr>
  <p:slideViewPr>
    <p:cSldViewPr snapToGrid="0">
      <p:cViewPr varScale="1">
        <p:scale>
          <a:sx n="74" d="100"/>
          <a:sy n="74" d="100"/>
        </p:scale>
        <p:origin x="304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25" Type="http://schemas.microsoft.com/office/2018/10/relationships/authors" Target="authors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microsoft.com/office/2015/10/relationships/revisionInfo" Target="revisionInfo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23" Type="http://schemas.microsoft.com/office/2016/11/relationships/changesInfo" Target="changesInfos/changesInfo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llis, Deeann" userId="624450ec-2436-4aff-8993-592194acd881" providerId="ADAL" clId="{2E8B541E-162D-4ACF-9DDE-9003719A5286}"/>
    <pc:docChg chg="undo redo custSel addSld delSld modSld delMainMaster">
      <pc:chgData name="Wallis, Deeann" userId="624450ec-2436-4aff-8993-592194acd881" providerId="ADAL" clId="{2E8B541E-162D-4ACF-9DDE-9003719A5286}" dt="2024-05-30T20:52:42.788" v="869" actId="166"/>
      <pc:docMkLst>
        <pc:docMk/>
      </pc:docMkLst>
      <pc:sldChg chg="add del">
        <pc:chgData name="Wallis, Deeann" userId="624450ec-2436-4aff-8993-592194acd881" providerId="ADAL" clId="{2E8B541E-162D-4ACF-9DDE-9003719A5286}" dt="2024-05-30T18:56:21.281" v="633" actId="47"/>
        <pc:sldMkLst>
          <pc:docMk/>
          <pc:sldMk cId="0" sldId="256"/>
        </pc:sldMkLst>
      </pc:sldChg>
      <pc:sldChg chg="addSp delSp modSp mod">
        <pc:chgData name="Wallis, Deeann" userId="624450ec-2436-4aff-8993-592194acd881" providerId="ADAL" clId="{2E8B541E-162D-4ACF-9DDE-9003719A5286}" dt="2024-05-23T21:21:26.899" v="581" actId="1076"/>
        <pc:sldMkLst>
          <pc:docMk/>
          <pc:sldMk cId="717591146" sldId="257"/>
        </pc:sldMkLst>
        <pc:spChg chg="del mod">
          <ac:chgData name="Wallis, Deeann" userId="624450ec-2436-4aff-8993-592194acd881" providerId="ADAL" clId="{2E8B541E-162D-4ACF-9DDE-9003719A5286}" dt="2024-05-23T20:30:53.471" v="561" actId="478"/>
          <ac:spMkLst>
            <pc:docMk/>
            <pc:sldMk cId="717591146" sldId="257"/>
            <ac:spMk id="3" creationId="{A5C24C34-7B2E-7434-05EC-FBE4DD969551}"/>
          </ac:spMkLst>
        </pc:spChg>
        <pc:spChg chg="del mod">
          <ac:chgData name="Wallis, Deeann" userId="624450ec-2436-4aff-8993-592194acd881" providerId="ADAL" clId="{2E8B541E-162D-4ACF-9DDE-9003719A5286}" dt="2024-05-23T20:31:02.616" v="565" actId="478"/>
          <ac:spMkLst>
            <pc:docMk/>
            <pc:sldMk cId="717591146" sldId="257"/>
            <ac:spMk id="4" creationId="{5A3B643C-454D-C94D-1D3A-4A69013F6A18}"/>
          </ac:spMkLst>
        </pc:spChg>
        <pc:spChg chg="del mod">
          <ac:chgData name="Wallis, Deeann" userId="624450ec-2436-4aff-8993-592194acd881" providerId="ADAL" clId="{2E8B541E-162D-4ACF-9DDE-9003719A5286}" dt="2024-05-23T20:31:02.616" v="565" actId="478"/>
          <ac:spMkLst>
            <pc:docMk/>
            <pc:sldMk cId="717591146" sldId="257"/>
            <ac:spMk id="5" creationId="{2A7C18F9-99EE-BB42-DD5B-8441460F3BFC}"/>
          </ac:spMkLst>
        </pc:spChg>
        <pc:spChg chg="del mod">
          <ac:chgData name="Wallis, Deeann" userId="624450ec-2436-4aff-8993-592194acd881" providerId="ADAL" clId="{2E8B541E-162D-4ACF-9DDE-9003719A5286}" dt="2024-05-23T20:31:02.616" v="565" actId="478"/>
          <ac:spMkLst>
            <pc:docMk/>
            <pc:sldMk cId="717591146" sldId="257"/>
            <ac:spMk id="6" creationId="{0AF2E6CB-0C08-8E58-63A2-078EDB63A3CA}"/>
          </ac:spMkLst>
        </pc:spChg>
        <pc:spChg chg="del mod">
          <ac:chgData name="Wallis, Deeann" userId="624450ec-2436-4aff-8993-592194acd881" providerId="ADAL" clId="{2E8B541E-162D-4ACF-9DDE-9003719A5286}" dt="2024-05-23T20:31:02.616" v="565" actId="478"/>
          <ac:spMkLst>
            <pc:docMk/>
            <pc:sldMk cId="717591146" sldId="257"/>
            <ac:spMk id="8" creationId="{168F7FAA-D5E7-F830-CF39-79D9BCA5442A}"/>
          </ac:spMkLst>
        </pc:spChg>
        <pc:spChg chg="del mod">
          <ac:chgData name="Wallis, Deeann" userId="624450ec-2436-4aff-8993-592194acd881" providerId="ADAL" clId="{2E8B541E-162D-4ACF-9DDE-9003719A5286}" dt="2024-05-23T20:31:02.616" v="565" actId="478"/>
          <ac:spMkLst>
            <pc:docMk/>
            <pc:sldMk cId="717591146" sldId="257"/>
            <ac:spMk id="9" creationId="{FE7180DB-8105-F1D8-04E9-DD289A3E8930}"/>
          </ac:spMkLst>
        </pc:spChg>
        <pc:spChg chg="del mod">
          <ac:chgData name="Wallis, Deeann" userId="624450ec-2436-4aff-8993-592194acd881" providerId="ADAL" clId="{2E8B541E-162D-4ACF-9DDE-9003719A5286}" dt="2024-05-23T20:30:56.247" v="564" actId="478"/>
          <ac:spMkLst>
            <pc:docMk/>
            <pc:sldMk cId="717591146" sldId="257"/>
            <ac:spMk id="10" creationId="{7C766B51-37D5-ACD0-1A2C-EE6DB0239F3C}"/>
          </ac:spMkLst>
        </pc:spChg>
        <pc:spChg chg="del mod">
          <ac:chgData name="Wallis, Deeann" userId="624450ec-2436-4aff-8993-592194acd881" providerId="ADAL" clId="{2E8B541E-162D-4ACF-9DDE-9003719A5286}" dt="2024-05-23T20:31:02.616" v="565" actId="478"/>
          <ac:spMkLst>
            <pc:docMk/>
            <pc:sldMk cId="717591146" sldId="257"/>
            <ac:spMk id="11" creationId="{6CB0B8A3-2C23-1E1A-8586-4DCACEE9E1B8}"/>
          </ac:spMkLst>
        </pc:spChg>
        <pc:spChg chg="mod">
          <ac:chgData name="Wallis, Deeann" userId="624450ec-2436-4aff-8993-592194acd881" providerId="ADAL" clId="{2E8B541E-162D-4ACF-9DDE-9003719A5286}" dt="2024-05-23T19:31:14.476" v="292" actId="1076"/>
          <ac:spMkLst>
            <pc:docMk/>
            <pc:sldMk cId="717591146" sldId="257"/>
            <ac:spMk id="13" creationId="{AFC909DA-913C-B6F0-3089-22771BA0FD4E}"/>
          </ac:spMkLst>
        </pc:spChg>
        <pc:spChg chg="mod">
          <ac:chgData name="Wallis, Deeann" userId="624450ec-2436-4aff-8993-592194acd881" providerId="ADAL" clId="{2E8B541E-162D-4ACF-9DDE-9003719A5286}" dt="2024-05-23T20:31:03.580" v="566"/>
          <ac:spMkLst>
            <pc:docMk/>
            <pc:sldMk cId="717591146" sldId="257"/>
            <ac:spMk id="14" creationId="{BB874C46-05A9-19CE-964F-F6DDC62238AC}"/>
          </ac:spMkLst>
        </pc:spChg>
        <pc:spChg chg="mod">
          <ac:chgData name="Wallis, Deeann" userId="624450ec-2436-4aff-8993-592194acd881" providerId="ADAL" clId="{2E8B541E-162D-4ACF-9DDE-9003719A5286}" dt="2024-05-23T20:31:03.580" v="566"/>
          <ac:spMkLst>
            <pc:docMk/>
            <pc:sldMk cId="717591146" sldId="257"/>
            <ac:spMk id="15" creationId="{3518CAC1-166B-89C1-2D68-B3751BAABCA8}"/>
          </ac:spMkLst>
        </pc:spChg>
        <pc:spChg chg="mod">
          <ac:chgData name="Wallis, Deeann" userId="624450ec-2436-4aff-8993-592194acd881" providerId="ADAL" clId="{2E8B541E-162D-4ACF-9DDE-9003719A5286}" dt="2024-05-23T20:31:03.580" v="566"/>
          <ac:spMkLst>
            <pc:docMk/>
            <pc:sldMk cId="717591146" sldId="257"/>
            <ac:spMk id="16" creationId="{5D7EAF2F-0428-D78B-D959-9485D530348E}"/>
          </ac:spMkLst>
        </pc:spChg>
        <pc:spChg chg="mod">
          <ac:chgData name="Wallis, Deeann" userId="624450ec-2436-4aff-8993-592194acd881" providerId="ADAL" clId="{2E8B541E-162D-4ACF-9DDE-9003719A5286}" dt="2024-05-23T19:35:59.031" v="352" actId="1076"/>
          <ac:spMkLst>
            <pc:docMk/>
            <pc:sldMk cId="717591146" sldId="257"/>
            <ac:spMk id="17" creationId="{F882A62A-BF8F-B554-5180-FDC68989AABB}"/>
          </ac:spMkLst>
        </pc:spChg>
        <pc:spChg chg="mod">
          <ac:chgData name="Wallis, Deeann" userId="624450ec-2436-4aff-8993-592194acd881" providerId="ADAL" clId="{2E8B541E-162D-4ACF-9DDE-9003719A5286}" dt="2024-05-23T19:30:49.615" v="287" actId="1076"/>
          <ac:spMkLst>
            <pc:docMk/>
            <pc:sldMk cId="717591146" sldId="257"/>
            <ac:spMk id="18" creationId="{748B9BE9-004F-4983-9596-7687D11E86DC}"/>
          </ac:spMkLst>
        </pc:spChg>
        <pc:spChg chg="mod">
          <ac:chgData name="Wallis, Deeann" userId="624450ec-2436-4aff-8993-592194acd881" providerId="ADAL" clId="{2E8B541E-162D-4ACF-9DDE-9003719A5286}" dt="2024-05-23T20:31:03.580" v="566"/>
          <ac:spMkLst>
            <pc:docMk/>
            <pc:sldMk cId="717591146" sldId="257"/>
            <ac:spMk id="19" creationId="{E46443D8-3430-7732-9A69-5856752AB014}"/>
          </ac:spMkLst>
        </pc:spChg>
        <pc:spChg chg="mod">
          <ac:chgData name="Wallis, Deeann" userId="624450ec-2436-4aff-8993-592194acd881" providerId="ADAL" clId="{2E8B541E-162D-4ACF-9DDE-9003719A5286}" dt="2024-05-23T20:31:03.580" v="566"/>
          <ac:spMkLst>
            <pc:docMk/>
            <pc:sldMk cId="717591146" sldId="257"/>
            <ac:spMk id="20" creationId="{38704868-87C7-C3B9-E016-E67EC1591E73}"/>
          </ac:spMkLst>
        </pc:spChg>
        <pc:spChg chg="mod">
          <ac:chgData name="Wallis, Deeann" userId="624450ec-2436-4aff-8993-592194acd881" providerId="ADAL" clId="{2E8B541E-162D-4ACF-9DDE-9003719A5286}" dt="2024-05-23T20:31:03.580" v="566"/>
          <ac:spMkLst>
            <pc:docMk/>
            <pc:sldMk cId="717591146" sldId="257"/>
            <ac:spMk id="21" creationId="{A273C185-3693-A57D-EDDA-D20BF8AF8531}"/>
          </ac:spMkLst>
        </pc:spChg>
        <pc:spChg chg="mod">
          <ac:chgData name="Wallis, Deeann" userId="624450ec-2436-4aff-8993-592194acd881" providerId="ADAL" clId="{2E8B541E-162D-4ACF-9DDE-9003719A5286}" dt="2024-05-23T20:31:03.580" v="566"/>
          <ac:spMkLst>
            <pc:docMk/>
            <pc:sldMk cId="717591146" sldId="257"/>
            <ac:spMk id="22" creationId="{BE7FBF8E-B37A-9854-2177-EAFD56A73243}"/>
          </ac:spMkLst>
        </pc:spChg>
        <pc:spChg chg="mod">
          <ac:chgData name="Wallis, Deeann" userId="624450ec-2436-4aff-8993-592194acd881" providerId="ADAL" clId="{2E8B541E-162D-4ACF-9DDE-9003719A5286}" dt="2024-05-23T20:31:03.580" v="566"/>
          <ac:spMkLst>
            <pc:docMk/>
            <pc:sldMk cId="717591146" sldId="257"/>
            <ac:spMk id="23" creationId="{5D12AB2C-5C3E-F04B-FD32-05AD11B6C9C7}"/>
          </ac:spMkLst>
        </pc:spChg>
        <pc:spChg chg="mod">
          <ac:chgData name="Wallis, Deeann" userId="624450ec-2436-4aff-8993-592194acd881" providerId="ADAL" clId="{2E8B541E-162D-4ACF-9DDE-9003719A5286}" dt="2024-05-23T20:32:20.971" v="570"/>
          <ac:spMkLst>
            <pc:docMk/>
            <pc:sldMk cId="717591146" sldId="257"/>
            <ac:spMk id="26" creationId="{8053E1D2-54EA-527B-C75E-7623E2784300}"/>
          </ac:spMkLst>
        </pc:spChg>
        <pc:spChg chg="mod">
          <ac:chgData name="Wallis, Deeann" userId="624450ec-2436-4aff-8993-592194acd881" providerId="ADAL" clId="{2E8B541E-162D-4ACF-9DDE-9003719A5286}" dt="2024-05-23T19:31:08.323" v="291" actId="1076"/>
          <ac:spMkLst>
            <pc:docMk/>
            <pc:sldMk cId="717591146" sldId="257"/>
            <ac:spMk id="28" creationId="{AFC909DA-913C-B6F0-3089-22771BA0FD4E}"/>
          </ac:spMkLst>
        </pc:spChg>
        <pc:spChg chg="mod">
          <ac:chgData name="Wallis, Deeann" userId="624450ec-2436-4aff-8993-592194acd881" providerId="ADAL" clId="{2E8B541E-162D-4ACF-9DDE-9003719A5286}" dt="2024-05-23T20:32:20.971" v="570"/>
          <ac:spMkLst>
            <pc:docMk/>
            <pc:sldMk cId="717591146" sldId="257"/>
            <ac:spMk id="29" creationId="{AE35DC6F-CED4-142B-2F21-06C294728184}"/>
          </ac:spMkLst>
        </pc:spChg>
        <pc:spChg chg="mod">
          <ac:chgData name="Wallis, Deeann" userId="624450ec-2436-4aff-8993-592194acd881" providerId="ADAL" clId="{2E8B541E-162D-4ACF-9DDE-9003719A5286}" dt="2024-05-23T20:32:20.971" v="570"/>
          <ac:spMkLst>
            <pc:docMk/>
            <pc:sldMk cId="717591146" sldId="257"/>
            <ac:spMk id="30" creationId="{1DFEF1D6-09FB-F6F1-A1FA-693BDCBDF86E}"/>
          </ac:spMkLst>
        </pc:spChg>
        <pc:spChg chg="mod">
          <ac:chgData name="Wallis, Deeann" userId="624450ec-2436-4aff-8993-592194acd881" providerId="ADAL" clId="{2E8B541E-162D-4ACF-9DDE-9003719A5286}" dt="2024-05-23T20:32:20.971" v="570"/>
          <ac:spMkLst>
            <pc:docMk/>
            <pc:sldMk cId="717591146" sldId="257"/>
            <ac:spMk id="31" creationId="{204822B1-0BD8-7530-5AB6-4BDA6BE32080}"/>
          </ac:spMkLst>
        </pc:spChg>
        <pc:spChg chg="mod">
          <ac:chgData name="Wallis, Deeann" userId="624450ec-2436-4aff-8993-592194acd881" providerId="ADAL" clId="{2E8B541E-162D-4ACF-9DDE-9003719A5286}" dt="2024-05-23T20:32:20.971" v="570"/>
          <ac:spMkLst>
            <pc:docMk/>
            <pc:sldMk cId="717591146" sldId="257"/>
            <ac:spMk id="34" creationId="{3F0B4FA1-DF46-514E-91F0-1B1E1E321E8E}"/>
          </ac:spMkLst>
        </pc:spChg>
        <pc:spChg chg="mod">
          <ac:chgData name="Wallis, Deeann" userId="624450ec-2436-4aff-8993-592194acd881" providerId="ADAL" clId="{2E8B541E-162D-4ACF-9DDE-9003719A5286}" dt="2024-05-23T20:32:20.971" v="570"/>
          <ac:spMkLst>
            <pc:docMk/>
            <pc:sldMk cId="717591146" sldId="257"/>
            <ac:spMk id="35" creationId="{C68A6B2C-150C-103D-F1D8-03F78ECE0077}"/>
          </ac:spMkLst>
        </pc:spChg>
        <pc:spChg chg="mod">
          <ac:chgData name="Wallis, Deeann" userId="624450ec-2436-4aff-8993-592194acd881" providerId="ADAL" clId="{2E8B541E-162D-4ACF-9DDE-9003719A5286}" dt="2024-05-23T20:32:20.971" v="570"/>
          <ac:spMkLst>
            <pc:docMk/>
            <pc:sldMk cId="717591146" sldId="257"/>
            <ac:spMk id="36" creationId="{91941DE1-32E2-B75C-C5CC-6FC9C6BD8FF9}"/>
          </ac:spMkLst>
        </pc:spChg>
        <pc:spChg chg="mod">
          <ac:chgData name="Wallis, Deeann" userId="624450ec-2436-4aff-8993-592194acd881" providerId="ADAL" clId="{2E8B541E-162D-4ACF-9DDE-9003719A5286}" dt="2024-05-23T20:32:20.971" v="570"/>
          <ac:spMkLst>
            <pc:docMk/>
            <pc:sldMk cId="717591146" sldId="257"/>
            <ac:spMk id="37" creationId="{B8D1919D-A356-1E45-6B37-0C763B3E985E}"/>
          </ac:spMkLst>
        </pc:spChg>
        <pc:grpChg chg="add del mod">
          <ac:chgData name="Wallis, Deeann" userId="624450ec-2436-4aff-8993-592194acd881" providerId="ADAL" clId="{2E8B541E-162D-4ACF-9DDE-9003719A5286}" dt="2024-05-23T20:32:19.422" v="569" actId="478"/>
          <ac:grpSpMkLst>
            <pc:docMk/>
            <pc:sldMk cId="717591146" sldId="257"/>
            <ac:grpSpMk id="7" creationId="{5642D0F3-F274-56B7-EE0A-446B39FED2B6}"/>
          </ac:grpSpMkLst>
        </pc:grpChg>
        <pc:grpChg chg="add mod">
          <ac:chgData name="Wallis, Deeann" userId="624450ec-2436-4aff-8993-592194acd881" providerId="ADAL" clId="{2E8B541E-162D-4ACF-9DDE-9003719A5286}" dt="2024-05-23T20:32:40.300" v="573" actId="14100"/>
          <ac:grpSpMkLst>
            <pc:docMk/>
            <pc:sldMk cId="717591146" sldId="257"/>
            <ac:grpSpMk id="24" creationId="{2F4E6001-213B-7523-5D96-ED32DE119820}"/>
          </ac:grpSpMkLst>
        </pc:grpChg>
        <pc:grpChg chg="add mod">
          <ac:chgData name="Wallis, Deeann" userId="624450ec-2436-4aff-8993-592194acd881" providerId="ADAL" clId="{2E8B541E-162D-4ACF-9DDE-9003719A5286}" dt="2024-05-23T21:21:26.899" v="581" actId="1076"/>
          <ac:grpSpMkLst>
            <pc:docMk/>
            <pc:sldMk cId="717591146" sldId="257"/>
            <ac:grpSpMk id="38" creationId="{7FDB4023-D0E7-E7A7-ECC8-87A62F38218E}"/>
          </ac:grpSpMkLst>
        </pc:grpChg>
        <pc:graphicFrameChg chg="mod">
          <ac:chgData name="Wallis, Deeann" userId="624450ec-2436-4aff-8993-592194acd881" providerId="ADAL" clId="{2E8B541E-162D-4ACF-9DDE-9003719A5286}" dt="2024-05-23T19:30:45.019" v="286" actId="1076"/>
          <ac:graphicFrameMkLst>
            <pc:docMk/>
            <pc:sldMk cId="717591146" sldId="257"/>
            <ac:graphicFrameMk id="27" creationId="{56A91304-F17F-2C46-3ED2-DF05F4B3E8BD}"/>
          </ac:graphicFrameMkLst>
        </pc:graphicFrameChg>
        <pc:graphicFrameChg chg="mod modGraphic">
          <ac:chgData name="Wallis, Deeann" userId="624450ec-2436-4aff-8993-592194acd881" providerId="ADAL" clId="{2E8B541E-162D-4ACF-9DDE-9003719A5286}" dt="2024-05-23T19:38:02.773" v="392" actId="14100"/>
          <ac:graphicFrameMkLst>
            <pc:docMk/>
            <pc:sldMk cId="717591146" sldId="257"/>
            <ac:graphicFrameMk id="40" creationId="{660597E4-62E4-3A4C-9676-DC2F5E5EE0CC}"/>
          </ac:graphicFrameMkLst>
        </pc:graphicFrameChg>
        <pc:picChg chg="del mod">
          <ac:chgData name="Wallis, Deeann" userId="624450ec-2436-4aff-8993-592194acd881" providerId="ADAL" clId="{2E8B541E-162D-4ACF-9DDE-9003719A5286}" dt="2024-05-23T20:30:49.880" v="559" actId="478"/>
          <ac:picMkLst>
            <pc:docMk/>
            <pc:sldMk cId="717591146" sldId="257"/>
            <ac:picMk id="2" creationId="{B76A0D4F-7AEF-6FA6-4A6C-8D8A3D5A0B3D}"/>
          </ac:picMkLst>
        </pc:picChg>
        <pc:picChg chg="mod">
          <ac:chgData name="Wallis, Deeann" userId="624450ec-2436-4aff-8993-592194acd881" providerId="ADAL" clId="{2E8B541E-162D-4ACF-9DDE-9003719A5286}" dt="2024-05-23T20:31:03.580" v="566"/>
          <ac:picMkLst>
            <pc:docMk/>
            <pc:sldMk cId="717591146" sldId="257"/>
            <ac:picMk id="12" creationId="{363ACF1F-15F2-C2EE-E228-971F84673DCA}"/>
          </ac:picMkLst>
        </pc:picChg>
        <pc:picChg chg="mod">
          <ac:chgData name="Wallis, Deeann" userId="624450ec-2436-4aff-8993-592194acd881" providerId="ADAL" clId="{2E8B541E-162D-4ACF-9DDE-9003719A5286}" dt="2024-05-23T20:32:20.971" v="570"/>
          <ac:picMkLst>
            <pc:docMk/>
            <pc:sldMk cId="717591146" sldId="257"/>
            <ac:picMk id="25" creationId="{34135B7B-E188-C176-1763-1FDE40C06567}"/>
          </ac:picMkLst>
        </pc:picChg>
        <pc:picChg chg="del mod">
          <ac:chgData name="Wallis, Deeann" userId="624450ec-2436-4aff-8993-592194acd881" providerId="ADAL" clId="{2E8B541E-162D-4ACF-9DDE-9003719A5286}" dt="2024-05-23T21:21:09.556" v="576" actId="478"/>
          <ac:picMkLst>
            <pc:docMk/>
            <pc:sldMk cId="717591146" sldId="257"/>
            <ac:picMk id="32" creationId="{F33831D3-4259-49F8-8DD5-9C1894B66A4B}"/>
          </ac:picMkLst>
        </pc:picChg>
        <pc:picChg chg="del mod">
          <ac:chgData name="Wallis, Deeann" userId="624450ec-2436-4aff-8993-592194acd881" providerId="ADAL" clId="{2E8B541E-162D-4ACF-9DDE-9003719A5286}" dt="2024-05-23T21:21:22.827" v="580" actId="478"/>
          <ac:picMkLst>
            <pc:docMk/>
            <pc:sldMk cId="717591146" sldId="257"/>
            <ac:picMk id="33" creationId="{4FBBFBBC-8D3C-DA6E-4906-CB924797FC95}"/>
          </ac:picMkLst>
        </pc:picChg>
        <pc:picChg chg="mod">
          <ac:chgData name="Wallis, Deeann" userId="624450ec-2436-4aff-8993-592194acd881" providerId="ADAL" clId="{2E8B541E-162D-4ACF-9DDE-9003719A5286}" dt="2024-05-23T21:21:10.095" v="577"/>
          <ac:picMkLst>
            <pc:docMk/>
            <pc:sldMk cId="717591146" sldId="257"/>
            <ac:picMk id="39" creationId="{80AC14C1-9B09-31BB-A579-3401ACFA6280}"/>
          </ac:picMkLst>
        </pc:picChg>
        <pc:picChg chg="mod">
          <ac:chgData name="Wallis, Deeann" userId="624450ec-2436-4aff-8993-592194acd881" providerId="ADAL" clId="{2E8B541E-162D-4ACF-9DDE-9003719A5286}" dt="2024-05-23T21:21:10.095" v="577"/>
          <ac:picMkLst>
            <pc:docMk/>
            <pc:sldMk cId="717591146" sldId="257"/>
            <ac:picMk id="41" creationId="{489B8691-3809-0A5C-2F48-72CDC8ED7C08}"/>
          </ac:picMkLst>
        </pc:picChg>
      </pc:sldChg>
      <pc:sldChg chg="addSp delSp modSp mod">
        <pc:chgData name="Wallis, Deeann" userId="624450ec-2436-4aff-8993-592194acd881" providerId="ADAL" clId="{2E8B541E-162D-4ACF-9DDE-9003719A5286}" dt="2024-05-23T21:52:09.616" v="620" actId="1038"/>
        <pc:sldMkLst>
          <pc:docMk/>
          <pc:sldMk cId="3826341855" sldId="259"/>
        </pc:sldMkLst>
        <pc:spChg chg="mod">
          <ac:chgData name="Wallis, Deeann" userId="624450ec-2436-4aff-8993-592194acd881" providerId="ADAL" clId="{2E8B541E-162D-4ACF-9DDE-9003719A5286}" dt="2024-05-23T19:19:41.825" v="105" actId="1076"/>
          <ac:spMkLst>
            <pc:docMk/>
            <pc:sldMk cId="3826341855" sldId="259"/>
            <ac:spMk id="37" creationId="{ECA69FA5-FB1D-FF6E-74C5-D745B500DC9C}"/>
          </ac:spMkLst>
        </pc:spChg>
        <pc:spChg chg="mod">
          <ac:chgData name="Wallis, Deeann" userId="624450ec-2436-4aff-8993-592194acd881" providerId="ADAL" clId="{2E8B541E-162D-4ACF-9DDE-9003719A5286}" dt="2024-05-23T19:12:00.447" v="33"/>
          <ac:spMkLst>
            <pc:docMk/>
            <pc:sldMk cId="3826341855" sldId="259"/>
            <ac:spMk id="43" creationId="{53E8A9C8-08E8-CB34-A808-927D4F5DC7B3}"/>
          </ac:spMkLst>
        </pc:spChg>
        <pc:spChg chg="mod">
          <ac:chgData name="Wallis, Deeann" userId="624450ec-2436-4aff-8993-592194acd881" providerId="ADAL" clId="{2E8B541E-162D-4ACF-9DDE-9003719A5286}" dt="2024-05-23T19:13:09.116" v="45"/>
          <ac:spMkLst>
            <pc:docMk/>
            <pc:sldMk cId="3826341855" sldId="259"/>
            <ac:spMk id="47" creationId="{475976D9-3CA7-4458-9A83-FCCE1EA5F54B}"/>
          </ac:spMkLst>
        </pc:spChg>
        <pc:spChg chg="mod">
          <ac:chgData name="Wallis, Deeann" userId="624450ec-2436-4aff-8993-592194acd881" providerId="ADAL" clId="{2E8B541E-162D-4ACF-9DDE-9003719A5286}" dt="2024-05-23T19:16:31.947" v="77" actId="1076"/>
          <ac:spMkLst>
            <pc:docMk/>
            <pc:sldMk cId="3826341855" sldId="259"/>
            <ac:spMk id="49" creationId="{EAF99483-AF42-1A2E-5064-E5280E93EA99}"/>
          </ac:spMkLst>
        </pc:spChg>
        <pc:spChg chg="mod">
          <ac:chgData name="Wallis, Deeann" userId="624450ec-2436-4aff-8993-592194acd881" providerId="ADAL" clId="{2E8B541E-162D-4ACF-9DDE-9003719A5286}" dt="2024-05-23T19:29:06.575" v="252" actId="1076"/>
          <ac:spMkLst>
            <pc:docMk/>
            <pc:sldMk cId="3826341855" sldId="259"/>
            <ac:spMk id="50" creationId="{30141C23-F3B1-BE0D-2E73-DE71DBF0A87E}"/>
          </ac:spMkLst>
        </pc:spChg>
        <pc:spChg chg="mod">
          <ac:chgData name="Wallis, Deeann" userId="624450ec-2436-4aff-8993-592194acd881" providerId="ADAL" clId="{2E8B541E-162D-4ACF-9DDE-9003719A5286}" dt="2024-05-23T19:13:50.429" v="49"/>
          <ac:spMkLst>
            <pc:docMk/>
            <pc:sldMk cId="3826341855" sldId="259"/>
            <ac:spMk id="53" creationId="{0A350A97-6C50-C01A-62D5-AD37A2D3F21C}"/>
          </ac:spMkLst>
        </pc:spChg>
        <pc:spChg chg="mod">
          <ac:chgData name="Wallis, Deeann" userId="624450ec-2436-4aff-8993-592194acd881" providerId="ADAL" clId="{2E8B541E-162D-4ACF-9DDE-9003719A5286}" dt="2024-05-23T19:29:27.088" v="258" actId="14100"/>
          <ac:spMkLst>
            <pc:docMk/>
            <pc:sldMk cId="3826341855" sldId="259"/>
            <ac:spMk id="63" creationId="{42E88B6F-3BCA-EAF2-5D8B-0F1E3D00D2CF}"/>
          </ac:spMkLst>
        </pc:spChg>
        <pc:spChg chg="mod">
          <ac:chgData name="Wallis, Deeann" userId="624450ec-2436-4aff-8993-592194acd881" providerId="ADAL" clId="{2E8B541E-162D-4ACF-9DDE-9003719A5286}" dt="2024-05-23T19:14:42.636" v="57"/>
          <ac:spMkLst>
            <pc:docMk/>
            <pc:sldMk cId="3826341855" sldId="259"/>
            <ac:spMk id="67" creationId="{C78DD3DD-8A3A-0CDD-956D-47798300CEEF}"/>
          </ac:spMkLst>
        </pc:spChg>
        <pc:spChg chg="add mod ord">
          <ac:chgData name="Wallis, Deeann" userId="624450ec-2436-4aff-8993-592194acd881" providerId="ADAL" clId="{2E8B541E-162D-4ACF-9DDE-9003719A5286}" dt="2024-05-23T19:30:16.717" v="284" actId="1076"/>
          <ac:spMkLst>
            <pc:docMk/>
            <pc:sldMk cId="3826341855" sldId="259"/>
            <ac:spMk id="75" creationId="{51993C9B-9401-D49D-B280-5B4B9AAD0C0F}"/>
          </ac:spMkLst>
        </pc:spChg>
        <pc:spChg chg="add mod">
          <ac:chgData name="Wallis, Deeann" userId="624450ec-2436-4aff-8993-592194acd881" providerId="ADAL" clId="{2E8B541E-162D-4ACF-9DDE-9003719A5286}" dt="2024-05-23T19:52:46.060" v="404" actId="1076"/>
          <ac:spMkLst>
            <pc:docMk/>
            <pc:sldMk cId="3826341855" sldId="259"/>
            <ac:spMk id="78" creationId="{EE94451D-50AA-7BD9-48B4-DCEC003C0AA2}"/>
          </ac:spMkLst>
        </pc:spChg>
        <pc:spChg chg="add mod">
          <ac:chgData name="Wallis, Deeann" userId="624450ec-2436-4aff-8993-592194acd881" providerId="ADAL" clId="{2E8B541E-162D-4ACF-9DDE-9003719A5286}" dt="2024-05-23T19:22:46.527" v="152" actId="1076"/>
          <ac:spMkLst>
            <pc:docMk/>
            <pc:sldMk cId="3826341855" sldId="259"/>
            <ac:spMk id="79" creationId="{06CC1BD1-D0C6-FC83-C217-0BF8BB09ECEB}"/>
          </ac:spMkLst>
        </pc:spChg>
        <pc:spChg chg="add mod">
          <ac:chgData name="Wallis, Deeann" userId="624450ec-2436-4aff-8993-592194acd881" providerId="ADAL" clId="{2E8B541E-162D-4ACF-9DDE-9003719A5286}" dt="2024-05-23T19:23:16.885" v="162" actId="20577"/>
          <ac:spMkLst>
            <pc:docMk/>
            <pc:sldMk cId="3826341855" sldId="259"/>
            <ac:spMk id="80" creationId="{91A274F4-A1E6-0D19-AB2A-C7D3E0810601}"/>
          </ac:spMkLst>
        </pc:spChg>
        <pc:spChg chg="add mod">
          <ac:chgData name="Wallis, Deeann" userId="624450ec-2436-4aff-8993-592194acd881" providerId="ADAL" clId="{2E8B541E-162D-4ACF-9DDE-9003719A5286}" dt="2024-05-23T19:33:31.481" v="320" actId="1076"/>
          <ac:spMkLst>
            <pc:docMk/>
            <pc:sldMk cId="3826341855" sldId="259"/>
            <ac:spMk id="81" creationId="{B825FD78-D5EF-F4C3-CD8D-AB3B93F2962D}"/>
          </ac:spMkLst>
        </pc:spChg>
        <pc:spChg chg="add mod">
          <ac:chgData name="Wallis, Deeann" userId="624450ec-2436-4aff-8993-592194acd881" providerId="ADAL" clId="{2E8B541E-162D-4ACF-9DDE-9003719A5286}" dt="2024-05-23T19:24:07.527" v="183" actId="207"/>
          <ac:spMkLst>
            <pc:docMk/>
            <pc:sldMk cId="3826341855" sldId="259"/>
            <ac:spMk id="82" creationId="{B6B4C9C3-25B9-38E9-9607-16C6A2871390}"/>
          </ac:spMkLst>
        </pc:spChg>
        <pc:spChg chg="add mod">
          <ac:chgData name="Wallis, Deeann" userId="624450ec-2436-4aff-8993-592194acd881" providerId="ADAL" clId="{2E8B541E-162D-4ACF-9DDE-9003719A5286}" dt="2024-05-23T19:26:19.401" v="216" actId="1038"/>
          <ac:spMkLst>
            <pc:docMk/>
            <pc:sldMk cId="3826341855" sldId="259"/>
            <ac:spMk id="83" creationId="{06789627-A52D-87BD-4B24-884E8BCBE75D}"/>
          </ac:spMkLst>
        </pc:spChg>
        <pc:spChg chg="add mod">
          <ac:chgData name="Wallis, Deeann" userId="624450ec-2436-4aff-8993-592194acd881" providerId="ADAL" clId="{2E8B541E-162D-4ACF-9DDE-9003719A5286}" dt="2024-05-23T19:33:26.289" v="319" actId="1076"/>
          <ac:spMkLst>
            <pc:docMk/>
            <pc:sldMk cId="3826341855" sldId="259"/>
            <ac:spMk id="84" creationId="{1889F827-D8AC-55F3-25FE-7CC7E1C0578A}"/>
          </ac:spMkLst>
        </pc:spChg>
        <pc:spChg chg="add mod">
          <ac:chgData name="Wallis, Deeann" userId="624450ec-2436-4aff-8993-592194acd881" providerId="ADAL" clId="{2E8B541E-162D-4ACF-9DDE-9003719A5286}" dt="2024-05-23T19:33:51.068" v="337" actId="1037"/>
          <ac:spMkLst>
            <pc:docMk/>
            <pc:sldMk cId="3826341855" sldId="259"/>
            <ac:spMk id="85" creationId="{B7EB4CAF-E9F6-34E3-B9E6-E108B8AAB674}"/>
          </ac:spMkLst>
        </pc:spChg>
        <pc:spChg chg="add mod">
          <ac:chgData name="Wallis, Deeann" userId="624450ec-2436-4aff-8993-592194acd881" providerId="ADAL" clId="{2E8B541E-162D-4ACF-9DDE-9003719A5286}" dt="2024-05-23T19:52:50.839" v="405" actId="1076"/>
          <ac:spMkLst>
            <pc:docMk/>
            <pc:sldMk cId="3826341855" sldId="259"/>
            <ac:spMk id="86" creationId="{1B93FED9-9D80-B7C0-EFBC-D6743161663C}"/>
          </ac:spMkLst>
        </pc:spChg>
        <pc:spChg chg="add mod">
          <ac:chgData name="Wallis, Deeann" userId="624450ec-2436-4aff-8993-592194acd881" providerId="ADAL" clId="{2E8B541E-162D-4ACF-9DDE-9003719A5286}" dt="2024-05-23T19:27:03.637" v="229" actId="20577"/>
          <ac:spMkLst>
            <pc:docMk/>
            <pc:sldMk cId="3826341855" sldId="259"/>
            <ac:spMk id="87" creationId="{6698E7D1-E0B5-A207-D7A7-7549235E7C0D}"/>
          </ac:spMkLst>
        </pc:spChg>
        <pc:spChg chg="add mod">
          <ac:chgData name="Wallis, Deeann" userId="624450ec-2436-4aff-8993-592194acd881" providerId="ADAL" clId="{2E8B541E-162D-4ACF-9DDE-9003719A5286}" dt="2024-05-23T19:27:43.514" v="237" actId="1076"/>
          <ac:spMkLst>
            <pc:docMk/>
            <pc:sldMk cId="3826341855" sldId="259"/>
            <ac:spMk id="88" creationId="{39FF169B-7B7C-641E-119F-9AAED76A715B}"/>
          </ac:spMkLst>
        </pc:spChg>
        <pc:spChg chg="add mod">
          <ac:chgData name="Wallis, Deeann" userId="624450ec-2436-4aff-8993-592194acd881" providerId="ADAL" clId="{2E8B541E-162D-4ACF-9DDE-9003719A5286}" dt="2024-05-23T19:28:07.013" v="241" actId="20577"/>
          <ac:spMkLst>
            <pc:docMk/>
            <pc:sldMk cId="3826341855" sldId="259"/>
            <ac:spMk id="89" creationId="{7BA686BB-0308-4A7F-649F-2B8F773378A0}"/>
          </ac:spMkLst>
        </pc:spChg>
        <pc:spChg chg="add mod">
          <ac:chgData name="Wallis, Deeann" userId="624450ec-2436-4aff-8993-592194acd881" providerId="ADAL" clId="{2E8B541E-162D-4ACF-9DDE-9003719A5286}" dt="2024-05-23T19:28:21.231" v="244" actId="20577"/>
          <ac:spMkLst>
            <pc:docMk/>
            <pc:sldMk cId="3826341855" sldId="259"/>
            <ac:spMk id="90" creationId="{18AB93FD-02CA-C8A4-7546-479164134B98}"/>
          </ac:spMkLst>
        </pc:spChg>
        <pc:spChg chg="add mod">
          <ac:chgData name="Wallis, Deeann" userId="624450ec-2436-4aff-8993-592194acd881" providerId="ADAL" clId="{2E8B541E-162D-4ACF-9DDE-9003719A5286}" dt="2024-05-23T19:28:55.813" v="249" actId="1076"/>
          <ac:spMkLst>
            <pc:docMk/>
            <pc:sldMk cId="3826341855" sldId="259"/>
            <ac:spMk id="91" creationId="{9C25D327-D174-734A-DE24-11FC6874678E}"/>
          </ac:spMkLst>
        </pc:spChg>
        <pc:spChg chg="mod">
          <ac:chgData name="Wallis, Deeann" userId="624450ec-2436-4aff-8993-592194acd881" providerId="ADAL" clId="{2E8B541E-162D-4ACF-9DDE-9003719A5286}" dt="2024-05-23T21:38:29.556" v="593" actId="1076"/>
          <ac:spMkLst>
            <pc:docMk/>
            <pc:sldMk cId="3826341855" sldId="259"/>
            <ac:spMk id="93" creationId="{1F2D7410-2C9D-297F-39A4-19DF59F8DC72}"/>
          </ac:spMkLst>
        </pc:spChg>
        <pc:spChg chg="mod">
          <ac:chgData name="Wallis, Deeann" userId="624450ec-2436-4aff-8993-592194acd881" providerId="ADAL" clId="{2E8B541E-162D-4ACF-9DDE-9003719A5286}" dt="2024-05-23T21:43:29.932" v="598"/>
          <ac:spMkLst>
            <pc:docMk/>
            <pc:sldMk cId="3826341855" sldId="259"/>
            <ac:spMk id="97" creationId="{56D93006-9EA9-CEF4-DF1F-3A4BA11E2A6A}"/>
          </ac:spMkLst>
        </pc:spChg>
        <pc:spChg chg="add mod">
          <ac:chgData name="Wallis, Deeann" userId="624450ec-2436-4aff-8993-592194acd881" providerId="ADAL" clId="{2E8B541E-162D-4ACF-9DDE-9003719A5286}" dt="2024-05-23T21:51:36.597" v="613" actId="1076"/>
          <ac:spMkLst>
            <pc:docMk/>
            <pc:sldMk cId="3826341855" sldId="259"/>
            <ac:spMk id="98" creationId="{1EE2F91A-373B-15DC-F3B8-49594D3298D5}"/>
          </ac:spMkLst>
        </pc:spChg>
        <pc:spChg chg="add del mod">
          <ac:chgData name="Wallis, Deeann" userId="624450ec-2436-4aff-8993-592194acd881" providerId="ADAL" clId="{2E8B541E-162D-4ACF-9DDE-9003719A5286}" dt="2024-05-23T21:51:49.321" v="615" actId="21"/>
          <ac:spMkLst>
            <pc:docMk/>
            <pc:sldMk cId="3826341855" sldId="259"/>
            <ac:spMk id="99" creationId="{8351FF2C-FC68-1331-0564-FAA68C23C12B}"/>
          </ac:spMkLst>
        </pc:spChg>
        <pc:spChg chg="add mod">
          <ac:chgData name="Wallis, Deeann" userId="624450ec-2436-4aff-8993-592194acd881" providerId="ADAL" clId="{2E8B541E-162D-4ACF-9DDE-9003719A5286}" dt="2024-05-23T21:52:09.616" v="620" actId="1038"/>
          <ac:spMkLst>
            <pc:docMk/>
            <pc:sldMk cId="3826341855" sldId="259"/>
            <ac:spMk id="100" creationId="{676A6E36-8088-28F0-5F67-D85A250363AE}"/>
          </ac:spMkLst>
        </pc:spChg>
        <pc:grpChg chg="add del">
          <ac:chgData name="Wallis, Deeann" userId="624450ec-2436-4aff-8993-592194acd881" providerId="ADAL" clId="{2E8B541E-162D-4ACF-9DDE-9003719A5286}" dt="2024-05-23T19:13:08.483" v="44" actId="478"/>
          <ac:grpSpMkLst>
            <pc:docMk/>
            <pc:sldMk cId="3826341855" sldId="259"/>
            <ac:grpSpMk id="2" creationId="{C15CEBD5-AB34-DCEA-588F-7D926C6C75D9}"/>
          </ac:grpSpMkLst>
        </pc:grpChg>
        <pc:grpChg chg="add del">
          <ac:chgData name="Wallis, Deeann" userId="624450ec-2436-4aff-8993-592194acd881" providerId="ADAL" clId="{2E8B541E-162D-4ACF-9DDE-9003719A5286}" dt="2024-05-23T19:14:41.433" v="56" actId="478"/>
          <ac:grpSpMkLst>
            <pc:docMk/>
            <pc:sldMk cId="3826341855" sldId="259"/>
            <ac:grpSpMk id="13" creationId="{EC72A216-9D9F-0B09-7896-5AF07307F177}"/>
          </ac:grpSpMkLst>
        </pc:grpChg>
        <pc:grpChg chg="add mod">
          <ac:chgData name="Wallis, Deeann" userId="624450ec-2436-4aff-8993-592194acd881" providerId="ADAL" clId="{2E8B541E-162D-4ACF-9DDE-9003719A5286}" dt="2024-05-23T19:20:39.600" v="110" actId="1076"/>
          <ac:grpSpMkLst>
            <pc:docMk/>
            <pc:sldMk cId="3826341855" sldId="259"/>
            <ac:grpSpMk id="16" creationId="{6A28DE0B-F2E5-82BF-A9AC-A625293F309A}"/>
          </ac:grpSpMkLst>
        </pc:grpChg>
        <pc:grpChg chg="mod">
          <ac:chgData name="Wallis, Deeann" userId="624450ec-2436-4aff-8993-592194acd881" providerId="ADAL" clId="{2E8B541E-162D-4ACF-9DDE-9003719A5286}" dt="2024-05-23T19:33:55.715" v="344" actId="1037"/>
          <ac:grpSpMkLst>
            <pc:docMk/>
            <pc:sldMk cId="3826341855" sldId="259"/>
            <ac:grpSpMk id="19" creationId="{12C9978D-C840-9326-BB34-96B93CDE278D}"/>
          </ac:grpSpMkLst>
        </pc:grpChg>
        <pc:grpChg chg="add del">
          <ac:chgData name="Wallis, Deeann" userId="624450ec-2436-4aff-8993-592194acd881" providerId="ADAL" clId="{2E8B541E-162D-4ACF-9DDE-9003719A5286}" dt="2024-05-23T19:14:27.869" v="55" actId="478"/>
          <ac:grpSpMkLst>
            <pc:docMk/>
            <pc:sldMk cId="3826341855" sldId="259"/>
            <ac:grpSpMk id="21" creationId="{10A16E1A-7EFD-81BF-C55F-01D700A1EDC2}"/>
          </ac:grpSpMkLst>
        </pc:grpChg>
        <pc:grpChg chg="del">
          <ac:chgData name="Wallis, Deeann" userId="624450ec-2436-4aff-8993-592194acd881" providerId="ADAL" clId="{2E8B541E-162D-4ACF-9DDE-9003719A5286}" dt="2024-05-23T19:11:54.649" v="32" actId="478"/>
          <ac:grpSpMkLst>
            <pc:docMk/>
            <pc:sldMk cId="3826341855" sldId="259"/>
            <ac:grpSpMk id="22" creationId="{407B3AC3-3B5D-420F-548A-CEB6A515D462}"/>
          </ac:grpSpMkLst>
        </pc:grpChg>
        <pc:grpChg chg="add mod">
          <ac:chgData name="Wallis, Deeann" userId="624450ec-2436-4aff-8993-592194acd881" providerId="ADAL" clId="{2E8B541E-162D-4ACF-9DDE-9003719A5286}" dt="2024-05-23T21:37:45.726" v="583" actId="1076"/>
          <ac:grpSpMkLst>
            <pc:docMk/>
            <pc:sldMk cId="3826341855" sldId="259"/>
            <ac:grpSpMk id="44" creationId="{901BBFCE-0C6A-4C5F-43F3-72CF54E69A1E}"/>
          </ac:grpSpMkLst>
        </pc:grpChg>
        <pc:grpChg chg="add mod">
          <ac:chgData name="Wallis, Deeann" userId="624450ec-2436-4aff-8993-592194acd881" providerId="ADAL" clId="{2E8B541E-162D-4ACF-9DDE-9003719A5286}" dt="2024-05-23T19:18:18.090" v="94" actId="1076"/>
          <ac:grpSpMkLst>
            <pc:docMk/>
            <pc:sldMk cId="3826341855" sldId="259"/>
            <ac:grpSpMk id="51" creationId="{36A06C80-F396-75F6-2EE1-B499C6D95C84}"/>
          </ac:grpSpMkLst>
        </pc:grpChg>
        <pc:grpChg chg="mod">
          <ac:chgData name="Wallis, Deeann" userId="624450ec-2436-4aff-8993-592194acd881" providerId="ADAL" clId="{2E8B541E-162D-4ACF-9DDE-9003719A5286}" dt="2024-05-23T19:29:43.815" v="259" actId="14100"/>
          <ac:grpSpMkLst>
            <pc:docMk/>
            <pc:sldMk cId="3826341855" sldId="259"/>
            <ac:grpSpMk id="58" creationId="{5365F699-8367-15F2-149A-7EDBD877FB52}"/>
          </ac:grpSpMkLst>
        </pc:grpChg>
        <pc:grpChg chg="add del mod">
          <ac:chgData name="Wallis, Deeann" userId="624450ec-2436-4aff-8993-592194acd881" providerId="ADAL" clId="{2E8B541E-162D-4ACF-9DDE-9003719A5286}" dt="2024-05-23T21:37:48.809" v="584" actId="21"/>
          <ac:grpSpMkLst>
            <pc:docMk/>
            <pc:sldMk cId="3826341855" sldId="259"/>
            <ac:grpSpMk id="61" creationId="{818BA70A-E449-BC1C-E43E-D4CCEDD56A4C}"/>
          </ac:grpSpMkLst>
        </pc:grpChg>
        <pc:grpChg chg="mod">
          <ac:chgData name="Wallis, Deeann" userId="624450ec-2436-4aff-8993-592194acd881" providerId="ADAL" clId="{2E8B541E-162D-4ACF-9DDE-9003719A5286}" dt="2024-05-23T19:27:30.235" v="235" actId="1076"/>
          <ac:grpSpMkLst>
            <pc:docMk/>
            <pc:sldMk cId="3826341855" sldId="259"/>
            <ac:grpSpMk id="62" creationId="{BBAFE45A-A257-0396-3085-40E1185BEB08}"/>
          </ac:grpSpMkLst>
        </pc:grpChg>
        <pc:grpChg chg="add del mod">
          <ac:chgData name="Wallis, Deeann" userId="624450ec-2436-4aff-8993-592194acd881" providerId="ADAL" clId="{2E8B541E-162D-4ACF-9DDE-9003719A5286}" dt="2024-05-23T21:43:49.338" v="602" actId="21"/>
          <ac:grpSpMkLst>
            <pc:docMk/>
            <pc:sldMk cId="3826341855" sldId="259"/>
            <ac:grpSpMk id="92" creationId="{BFB65829-2D95-C32C-27EB-702B240015D2}"/>
          </ac:grpSpMkLst>
        </pc:grpChg>
        <pc:grpChg chg="add mod">
          <ac:chgData name="Wallis, Deeann" userId="624450ec-2436-4aff-8993-592194acd881" providerId="ADAL" clId="{2E8B541E-162D-4ACF-9DDE-9003719A5286}" dt="2024-05-23T21:43:46.392" v="601" actId="14100"/>
          <ac:grpSpMkLst>
            <pc:docMk/>
            <pc:sldMk cId="3826341855" sldId="259"/>
            <ac:grpSpMk id="95" creationId="{46BE55C0-B01F-855C-A004-1A1ACEAB27CE}"/>
          </ac:grpSpMkLst>
        </pc:grpChg>
        <pc:picChg chg="mod">
          <ac:chgData name="Wallis, Deeann" userId="624450ec-2436-4aff-8993-592194acd881" providerId="ADAL" clId="{2E8B541E-162D-4ACF-9DDE-9003719A5286}" dt="2024-05-23T19:19:35.192" v="104" actId="1076"/>
          <ac:picMkLst>
            <pc:docMk/>
            <pc:sldMk cId="3826341855" sldId="259"/>
            <ac:picMk id="40" creationId="{6B69E45A-ED8A-6AE9-FBC8-B3ECADE35C34}"/>
          </ac:picMkLst>
        </pc:picChg>
        <pc:picChg chg="mod">
          <ac:chgData name="Wallis, Deeann" userId="624450ec-2436-4aff-8993-592194acd881" providerId="ADAL" clId="{2E8B541E-162D-4ACF-9DDE-9003719A5286}" dt="2024-05-23T19:13:09.116" v="45"/>
          <ac:picMkLst>
            <pc:docMk/>
            <pc:sldMk cId="3826341855" sldId="259"/>
            <ac:picMk id="46" creationId="{47D54499-850A-6724-D502-1E6E8675A6AF}"/>
          </ac:picMkLst>
        </pc:picChg>
        <pc:picChg chg="mod">
          <ac:chgData name="Wallis, Deeann" userId="624450ec-2436-4aff-8993-592194acd881" providerId="ADAL" clId="{2E8B541E-162D-4ACF-9DDE-9003719A5286}" dt="2024-05-23T19:13:50.429" v="49"/>
          <ac:picMkLst>
            <pc:docMk/>
            <pc:sldMk cId="3826341855" sldId="259"/>
            <ac:picMk id="52" creationId="{D5581CD6-4001-6E2C-553A-88A0CDE18456}"/>
          </ac:picMkLst>
        </pc:picChg>
        <pc:picChg chg="mod">
          <ac:chgData name="Wallis, Deeann" userId="624450ec-2436-4aff-8993-592194acd881" providerId="ADAL" clId="{2E8B541E-162D-4ACF-9DDE-9003719A5286}" dt="2024-05-23T19:14:42.636" v="57"/>
          <ac:picMkLst>
            <pc:docMk/>
            <pc:sldMk cId="3826341855" sldId="259"/>
            <ac:picMk id="66" creationId="{80FDE319-613C-F6B6-33B2-44E786BDD785}"/>
          </ac:picMkLst>
        </pc:picChg>
        <pc:picChg chg="add mod">
          <ac:chgData name="Wallis, Deeann" userId="624450ec-2436-4aff-8993-592194acd881" providerId="ADAL" clId="{2E8B541E-162D-4ACF-9DDE-9003719A5286}" dt="2024-05-23T19:52:42.413" v="403" actId="14100"/>
          <ac:picMkLst>
            <pc:docMk/>
            <pc:sldMk cId="3826341855" sldId="259"/>
            <ac:picMk id="73" creationId="{7D719447-77E4-F340-31F7-98192729D4BA}"/>
          </ac:picMkLst>
        </pc:picChg>
        <pc:picChg chg="mod">
          <ac:chgData name="Wallis, Deeann" userId="624450ec-2436-4aff-8993-592194acd881" providerId="ADAL" clId="{2E8B541E-162D-4ACF-9DDE-9003719A5286}" dt="2024-05-23T21:38:06.542" v="588"/>
          <ac:picMkLst>
            <pc:docMk/>
            <pc:sldMk cId="3826341855" sldId="259"/>
            <ac:picMk id="94" creationId="{6C5B53FA-7ABA-44DD-82E2-E4541F94B840}"/>
          </ac:picMkLst>
        </pc:picChg>
        <pc:picChg chg="mod">
          <ac:chgData name="Wallis, Deeann" userId="624450ec-2436-4aff-8993-592194acd881" providerId="ADAL" clId="{2E8B541E-162D-4ACF-9DDE-9003719A5286}" dt="2024-05-23T21:43:29.932" v="598"/>
          <ac:picMkLst>
            <pc:docMk/>
            <pc:sldMk cId="3826341855" sldId="259"/>
            <ac:picMk id="96" creationId="{E44AE754-7149-185A-61B3-73AB74E0E16B}"/>
          </ac:picMkLst>
        </pc:picChg>
      </pc:sldChg>
      <pc:sldChg chg="addSp delSp modSp mod">
        <pc:chgData name="Wallis, Deeann" userId="624450ec-2436-4aff-8993-592194acd881" providerId="ADAL" clId="{2E8B541E-162D-4ACF-9DDE-9003719A5286}" dt="2024-05-23T21:46:34.677" v="608" actId="14100"/>
        <pc:sldMkLst>
          <pc:docMk/>
          <pc:sldMk cId="112906126" sldId="262"/>
        </pc:sldMkLst>
        <pc:spChg chg="del mod">
          <ac:chgData name="Wallis, Deeann" userId="624450ec-2436-4aff-8993-592194acd881" providerId="ADAL" clId="{2E8B541E-162D-4ACF-9DDE-9003719A5286}" dt="2024-05-23T20:24:57.280" v="526" actId="478"/>
          <ac:spMkLst>
            <pc:docMk/>
            <pc:sldMk cId="112906126" sldId="262"/>
            <ac:spMk id="2" creationId="{86E58497-8D50-C4EA-BAEE-5890E84E5BFF}"/>
          </ac:spMkLst>
        </pc:spChg>
        <pc:spChg chg="mod">
          <ac:chgData name="Wallis, Deeann" userId="624450ec-2436-4aff-8993-592194acd881" providerId="ADAL" clId="{2E8B541E-162D-4ACF-9DDE-9003719A5286}" dt="2024-05-23T20:24:58.251" v="527"/>
          <ac:spMkLst>
            <pc:docMk/>
            <pc:sldMk cId="112906126" sldId="262"/>
            <ac:spMk id="4" creationId="{3D02A1D2-81C0-82CB-1398-D09DD9184187}"/>
          </ac:spMkLst>
        </pc:spChg>
        <pc:spChg chg="mod">
          <ac:chgData name="Wallis, Deeann" userId="624450ec-2436-4aff-8993-592194acd881" providerId="ADAL" clId="{2E8B541E-162D-4ACF-9DDE-9003719A5286}" dt="2024-05-23T20:26:31.779" v="537" actId="1076"/>
          <ac:spMkLst>
            <pc:docMk/>
            <pc:sldMk cId="112906126" sldId="262"/>
            <ac:spMk id="7" creationId="{AEFD9C5D-22B8-6EC7-0ED8-4AF0915F0DF6}"/>
          </ac:spMkLst>
        </pc:spChg>
        <pc:spChg chg="mod">
          <ac:chgData name="Wallis, Deeann" userId="624450ec-2436-4aff-8993-592194acd881" providerId="ADAL" clId="{2E8B541E-162D-4ACF-9DDE-9003719A5286}" dt="2024-05-23T20:24:58.251" v="527"/>
          <ac:spMkLst>
            <pc:docMk/>
            <pc:sldMk cId="112906126" sldId="262"/>
            <ac:spMk id="9" creationId="{A9D98A7E-38B5-19CF-7F66-CF0289B70A81}"/>
          </ac:spMkLst>
        </pc:spChg>
        <pc:spChg chg="mod">
          <ac:chgData name="Wallis, Deeann" userId="624450ec-2436-4aff-8993-592194acd881" providerId="ADAL" clId="{2E8B541E-162D-4ACF-9DDE-9003719A5286}" dt="2024-05-23T20:24:58.251" v="527"/>
          <ac:spMkLst>
            <pc:docMk/>
            <pc:sldMk cId="112906126" sldId="262"/>
            <ac:spMk id="12" creationId="{510653BD-8125-1629-E541-9AF016F26175}"/>
          </ac:spMkLst>
        </pc:spChg>
        <pc:spChg chg="mod">
          <ac:chgData name="Wallis, Deeann" userId="624450ec-2436-4aff-8993-592194acd881" providerId="ADAL" clId="{2E8B541E-162D-4ACF-9DDE-9003719A5286}" dt="2024-05-23T20:24:58.251" v="527"/>
          <ac:spMkLst>
            <pc:docMk/>
            <pc:sldMk cId="112906126" sldId="262"/>
            <ac:spMk id="15" creationId="{6A0C9F56-EC76-2AB7-5BA1-6C5A52036AE1}"/>
          </ac:spMkLst>
        </pc:spChg>
        <pc:spChg chg="add mod">
          <ac:chgData name="Wallis, Deeann" userId="624450ec-2436-4aff-8993-592194acd881" providerId="ADAL" clId="{2E8B541E-162D-4ACF-9DDE-9003719A5286}" dt="2024-05-23T20:28:21.740" v="554" actId="20577"/>
          <ac:spMkLst>
            <pc:docMk/>
            <pc:sldMk cId="112906126" sldId="262"/>
            <ac:spMk id="17" creationId="{16155895-9E51-2D71-9FA2-1428D4A89CD2}"/>
          </ac:spMkLst>
        </pc:spChg>
        <pc:spChg chg="add mod">
          <ac:chgData name="Wallis, Deeann" userId="624450ec-2436-4aff-8993-592194acd881" providerId="ADAL" clId="{2E8B541E-162D-4ACF-9DDE-9003719A5286}" dt="2024-05-23T20:28:16.897" v="552" actId="20577"/>
          <ac:spMkLst>
            <pc:docMk/>
            <pc:sldMk cId="112906126" sldId="262"/>
            <ac:spMk id="18" creationId="{9DBB4F3A-6607-8DC8-FC6C-ADD9098772F0}"/>
          </ac:spMkLst>
        </pc:spChg>
        <pc:spChg chg="mod">
          <ac:chgData name="Wallis, Deeann" userId="624450ec-2436-4aff-8993-592194acd881" providerId="ADAL" clId="{2E8B541E-162D-4ACF-9DDE-9003719A5286}" dt="2024-05-23T20:26:31.779" v="537" actId="1076"/>
          <ac:spMkLst>
            <pc:docMk/>
            <pc:sldMk cId="112906126" sldId="262"/>
            <ac:spMk id="20" creationId="{7AF3EBAB-A830-C1F5-CDE6-6E99BE1005F4}"/>
          </ac:spMkLst>
        </pc:spChg>
        <pc:spChg chg="mod">
          <ac:chgData name="Wallis, Deeann" userId="624450ec-2436-4aff-8993-592194acd881" providerId="ADAL" clId="{2E8B541E-162D-4ACF-9DDE-9003719A5286}" dt="2024-05-23T20:26:31.779" v="537" actId="1076"/>
          <ac:spMkLst>
            <pc:docMk/>
            <pc:sldMk cId="112906126" sldId="262"/>
            <ac:spMk id="23" creationId="{18FD9AD9-22F8-AF57-0783-2506C8438A4C}"/>
          </ac:spMkLst>
        </pc:spChg>
        <pc:spChg chg="add mod">
          <ac:chgData name="Wallis, Deeann" userId="624450ec-2436-4aff-8993-592194acd881" providerId="ADAL" clId="{2E8B541E-162D-4ACF-9DDE-9003719A5286}" dt="2024-05-23T20:28:27.440" v="556" actId="20577"/>
          <ac:spMkLst>
            <pc:docMk/>
            <pc:sldMk cId="112906126" sldId="262"/>
            <ac:spMk id="24" creationId="{C982D55B-4296-138A-A654-A29B84237D00}"/>
          </ac:spMkLst>
        </pc:spChg>
        <pc:spChg chg="add mod">
          <ac:chgData name="Wallis, Deeann" userId="624450ec-2436-4aff-8993-592194acd881" providerId="ADAL" clId="{2E8B541E-162D-4ACF-9DDE-9003719A5286}" dt="2024-05-23T20:28:32.100" v="558" actId="20577"/>
          <ac:spMkLst>
            <pc:docMk/>
            <pc:sldMk cId="112906126" sldId="262"/>
            <ac:spMk id="25" creationId="{CB38EFE2-CAC0-B712-55F0-E92A3ACA65A8}"/>
          </ac:spMkLst>
        </pc:spChg>
        <pc:spChg chg="mod">
          <ac:chgData name="Wallis, Deeann" userId="624450ec-2436-4aff-8993-592194acd881" providerId="ADAL" clId="{2E8B541E-162D-4ACF-9DDE-9003719A5286}" dt="2024-05-23T20:27:53.838" v="547" actId="1076"/>
          <ac:spMkLst>
            <pc:docMk/>
            <pc:sldMk cId="112906126" sldId="262"/>
            <ac:spMk id="26" creationId="{15355F5F-3663-B01A-6D55-4B11F28951FD}"/>
          </ac:spMkLst>
        </pc:spChg>
        <pc:spChg chg="mod">
          <ac:chgData name="Wallis, Deeann" userId="624450ec-2436-4aff-8993-592194acd881" providerId="ADAL" clId="{2E8B541E-162D-4ACF-9DDE-9003719A5286}" dt="2024-05-23T20:26:31.779" v="537" actId="1076"/>
          <ac:spMkLst>
            <pc:docMk/>
            <pc:sldMk cId="112906126" sldId="262"/>
            <ac:spMk id="28" creationId="{18FD9AD9-22F8-AF57-0783-2506C8438A4C}"/>
          </ac:spMkLst>
        </pc:spChg>
        <pc:spChg chg="mod">
          <ac:chgData name="Wallis, Deeann" userId="624450ec-2436-4aff-8993-592194acd881" providerId="ADAL" clId="{2E8B541E-162D-4ACF-9DDE-9003719A5286}" dt="2024-05-23T20:27:53.838" v="547" actId="1076"/>
          <ac:spMkLst>
            <pc:docMk/>
            <pc:sldMk cId="112906126" sldId="262"/>
            <ac:spMk id="30" creationId="{15355F5F-3663-B01A-6D55-4B11F28951FD}"/>
          </ac:spMkLst>
        </pc:spChg>
        <pc:spChg chg="mod">
          <ac:chgData name="Wallis, Deeann" userId="624450ec-2436-4aff-8993-592194acd881" providerId="ADAL" clId="{2E8B541E-162D-4ACF-9DDE-9003719A5286}" dt="2024-05-23T21:37:54.962" v="585"/>
          <ac:spMkLst>
            <pc:docMk/>
            <pc:sldMk cId="112906126" sldId="262"/>
            <ac:spMk id="31" creationId="{A97DA2A2-7637-42BD-58A6-3BF0DF367A92}"/>
          </ac:spMkLst>
        </pc:spChg>
        <pc:spChg chg="mod">
          <ac:chgData name="Wallis, Deeann" userId="624450ec-2436-4aff-8993-592194acd881" providerId="ADAL" clId="{2E8B541E-162D-4ACF-9DDE-9003719A5286}" dt="2024-05-23T20:27:53.838" v="547" actId="1076"/>
          <ac:spMkLst>
            <pc:docMk/>
            <pc:sldMk cId="112906126" sldId="262"/>
            <ac:spMk id="33" creationId="{15355F5F-3663-B01A-6D55-4B11F28951FD}"/>
          </ac:spMkLst>
        </pc:spChg>
        <pc:spChg chg="mod">
          <ac:chgData name="Wallis, Deeann" userId="624450ec-2436-4aff-8993-592194acd881" providerId="ADAL" clId="{2E8B541E-162D-4ACF-9DDE-9003719A5286}" dt="2024-05-23T21:43:54.814" v="603"/>
          <ac:spMkLst>
            <pc:docMk/>
            <pc:sldMk cId="112906126" sldId="262"/>
            <ac:spMk id="34" creationId="{CABA4E25-7E2D-49FD-4CCC-F0595CC29BFA}"/>
          </ac:spMkLst>
        </pc:spChg>
        <pc:spChg chg="mod">
          <ac:chgData name="Wallis, Deeann" userId="624450ec-2436-4aff-8993-592194acd881" providerId="ADAL" clId="{2E8B541E-162D-4ACF-9DDE-9003719A5286}" dt="2024-05-23T20:27:53.838" v="547" actId="1076"/>
          <ac:spMkLst>
            <pc:docMk/>
            <pc:sldMk cId="112906126" sldId="262"/>
            <ac:spMk id="35" creationId="{15355F5F-3663-B01A-6D55-4B11F28951FD}"/>
          </ac:spMkLst>
        </pc:spChg>
        <pc:spChg chg="mod">
          <ac:chgData name="Wallis, Deeann" userId="624450ec-2436-4aff-8993-592194acd881" providerId="ADAL" clId="{2E8B541E-162D-4ACF-9DDE-9003719A5286}" dt="2024-05-23T20:26:31.779" v="537" actId="1076"/>
          <ac:spMkLst>
            <pc:docMk/>
            <pc:sldMk cId="112906126" sldId="262"/>
            <ac:spMk id="37" creationId="{18FD9AD9-22F8-AF57-0783-2506C8438A4C}"/>
          </ac:spMkLst>
        </pc:spChg>
        <pc:spChg chg="mod">
          <ac:chgData name="Wallis, Deeann" userId="624450ec-2436-4aff-8993-592194acd881" providerId="ADAL" clId="{2E8B541E-162D-4ACF-9DDE-9003719A5286}" dt="2024-05-23T20:26:31.779" v="537" actId="1076"/>
          <ac:spMkLst>
            <pc:docMk/>
            <pc:sldMk cId="112906126" sldId="262"/>
            <ac:spMk id="39" creationId="{18FD9AD9-22F8-AF57-0783-2506C8438A4C}"/>
          </ac:spMkLst>
        </pc:spChg>
        <pc:grpChg chg="add del mod">
          <ac:chgData name="Wallis, Deeann" userId="624450ec-2436-4aff-8993-592194acd881" providerId="ADAL" clId="{2E8B541E-162D-4ACF-9DDE-9003719A5286}" dt="2024-05-23T21:38:00.621" v="587" actId="21"/>
          <ac:grpSpMkLst>
            <pc:docMk/>
            <pc:sldMk cId="112906126" sldId="262"/>
            <ac:grpSpMk id="3" creationId="{3B3D6E8F-7BC4-B4BF-FD23-0D1144F4199B}"/>
          </ac:grpSpMkLst>
        </pc:grpChg>
        <pc:grpChg chg="add mod">
          <ac:chgData name="Wallis, Deeann" userId="624450ec-2436-4aff-8993-592194acd881" providerId="ADAL" clId="{2E8B541E-162D-4ACF-9DDE-9003719A5286}" dt="2024-05-23T20:27:27.805" v="546" actId="1076"/>
          <ac:grpSpMkLst>
            <pc:docMk/>
            <pc:sldMk cId="112906126" sldId="262"/>
            <ac:grpSpMk id="8" creationId="{17840EB8-9264-C72A-00BE-B25D86437E81}"/>
          </ac:grpSpMkLst>
        </pc:grpChg>
        <pc:grpChg chg="add mod">
          <ac:chgData name="Wallis, Deeann" userId="624450ec-2436-4aff-8993-592194acd881" providerId="ADAL" clId="{2E8B541E-162D-4ACF-9DDE-9003719A5286}" dt="2024-05-23T20:27:15.606" v="544" actId="1076"/>
          <ac:grpSpMkLst>
            <pc:docMk/>
            <pc:sldMk cId="112906126" sldId="262"/>
            <ac:grpSpMk id="11" creationId="{18CE6C1A-A2DC-DFC4-110C-58BEF89FF92C}"/>
          </ac:grpSpMkLst>
        </pc:grpChg>
        <pc:grpChg chg="add mod">
          <ac:chgData name="Wallis, Deeann" userId="624450ec-2436-4aff-8993-592194acd881" providerId="ADAL" clId="{2E8B541E-162D-4ACF-9DDE-9003719A5286}" dt="2024-05-23T21:46:27.519" v="607" actId="1076"/>
          <ac:grpSpMkLst>
            <pc:docMk/>
            <pc:sldMk cId="112906126" sldId="262"/>
            <ac:grpSpMk id="14" creationId="{947CFD3B-7585-9FAE-D2C4-023A8A7ED1FD}"/>
          </ac:grpSpMkLst>
        </pc:grpChg>
        <pc:grpChg chg="add del mod">
          <ac:chgData name="Wallis, Deeann" userId="624450ec-2436-4aff-8993-592194acd881" providerId="ADAL" clId="{2E8B541E-162D-4ACF-9DDE-9003719A5286}" dt="2024-05-23T21:43:21.493" v="596" actId="21"/>
          <ac:grpSpMkLst>
            <pc:docMk/>
            <pc:sldMk cId="112906126" sldId="262"/>
            <ac:grpSpMk id="27" creationId="{4077F842-A929-96F3-B6DD-8473B849877A}"/>
          </ac:grpSpMkLst>
        </pc:grpChg>
        <pc:grpChg chg="add mod">
          <ac:chgData name="Wallis, Deeann" userId="624450ec-2436-4aff-8993-592194acd881" providerId="ADAL" clId="{2E8B541E-162D-4ACF-9DDE-9003719A5286}" dt="2024-05-23T21:46:34.677" v="608" actId="14100"/>
          <ac:grpSpMkLst>
            <pc:docMk/>
            <pc:sldMk cId="112906126" sldId="262"/>
            <ac:grpSpMk id="32" creationId="{69E824D8-0458-7F51-8F55-3A7D4FDF5466}"/>
          </ac:grpSpMkLst>
        </pc:grpChg>
        <pc:picChg chg="mod">
          <ac:chgData name="Wallis, Deeann" userId="624450ec-2436-4aff-8993-592194acd881" providerId="ADAL" clId="{2E8B541E-162D-4ACF-9DDE-9003719A5286}" dt="2024-05-23T20:26:31.779" v="537" actId="1076"/>
          <ac:picMkLst>
            <pc:docMk/>
            <pc:sldMk cId="112906126" sldId="262"/>
            <ac:picMk id="5" creationId="{B6217F3F-6EFA-EC43-7660-68E4810E171B}"/>
          </ac:picMkLst>
        </pc:picChg>
        <pc:picChg chg="mod">
          <ac:chgData name="Wallis, Deeann" userId="624450ec-2436-4aff-8993-592194acd881" providerId="ADAL" clId="{2E8B541E-162D-4ACF-9DDE-9003719A5286}" dt="2024-05-23T20:24:58.251" v="527"/>
          <ac:picMkLst>
            <pc:docMk/>
            <pc:sldMk cId="112906126" sldId="262"/>
            <ac:picMk id="6" creationId="{7F537117-DE6A-69ED-2930-F89EB144BF8C}"/>
          </ac:picMkLst>
        </pc:picChg>
        <pc:picChg chg="mod">
          <ac:chgData name="Wallis, Deeann" userId="624450ec-2436-4aff-8993-592194acd881" providerId="ADAL" clId="{2E8B541E-162D-4ACF-9DDE-9003719A5286}" dt="2024-05-23T20:24:58.251" v="527"/>
          <ac:picMkLst>
            <pc:docMk/>
            <pc:sldMk cId="112906126" sldId="262"/>
            <ac:picMk id="10" creationId="{7A315344-C95A-5163-C29B-02CCBE0A4EFE}"/>
          </ac:picMkLst>
        </pc:picChg>
        <pc:picChg chg="mod">
          <ac:chgData name="Wallis, Deeann" userId="624450ec-2436-4aff-8993-592194acd881" providerId="ADAL" clId="{2E8B541E-162D-4ACF-9DDE-9003719A5286}" dt="2024-05-23T20:24:58.251" v="527"/>
          <ac:picMkLst>
            <pc:docMk/>
            <pc:sldMk cId="112906126" sldId="262"/>
            <ac:picMk id="13" creationId="{9B0AA9C8-0227-1B5C-985B-002AFD67D2C6}"/>
          </ac:picMkLst>
        </pc:picChg>
        <pc:picChg chg="mod">
          <ac:chgData name="Wallis, Deeann" userId="624450ec-2436-4aff-8993-592194acd881" providerId="ADAL" clId="{2E8B541E-162D-4ACF-9DDE-9003719A5286}" dt="2024-05-23T20:24:58.251" v="527"/>
          <ac:picMkLst>
            <pc:docMk/>
            <pc:sldMk cId="112906126" sldId="262"/>
            <ac:picMk id="16" creationId="{36C63BBF-E5C0-B049-5C44-A2FE2945ECF9}"/>
          </ac:picMkLst>
        </pc:picChg>
        <pc:picChg chg="mod">
          <ac:chgData name="Wallis, Deeann" userId="624450ec-2436-4aff-8993-592194acd881" providerId="ADAL" clId="{2E8B541E-162D-4ACF-9DDE-9003719A5286}" dt="2024-05-23T20:26:31.779" v="537" actId="1076"/>
          <ac:picMkLst>
            <pc:docMk/>
            <pc:sldMk cId="112906126" sldId="262"/>
            <ac:picMk id="19" creationId="{EEA934F9-0203-9790-6E8C-08520F51C873}"/>
          </ac:picMkLst>
        </pc:picChg>
        <pc:picChg chg="mod">
          <ac:chgData name="Wallis, Deeann" userId="624450ec-2436-4aff-8993-592194acd881" providerId="ADAL" clId="{2E8B541E-162D-4ACF-9DDE-9003719A5286}" dt="2024-05-23T20:26:31.779" v="537" actId="1076"/>
          <ac:picMkLst>
            <pc:docMk/>
            <pc:sldMk cId="112906126" sldId="262"/>
            <ac:picMk id="21" creationId="{78CB7F82-B8A2-8E0E-E3CD-AF20D596AFF3}"/>
          </ac:picMkLst>
        </pc:picChg>
        <pc:picChg chg="mod">
          <ac:chgData name="Wallis, Deeann" userId="624450ec-2436-4aff-8993-592194acd881" providerId="ADAL" clId="{2E8B541E-162D-4ACF-9DDE-9003719A5286}" dt="2024-05-23T20:26:31.779" v="537" actId="1076"/>
          <ac:picMkLst>
            <pc:docMk/>
            <pc:sldMk cId="112906126" sldId="262"/>
            <ac:picMk id="22" creationId="{5B62EE96-FD58-9E53-CC18-AC61D49E9EF0}"/>
          </ac:picMkLst>
        </pc:picChg>
        <pc:picChg chg="mod">
          <ac:chgData name="Wallis, Deeann" userId="624450ec-2436-4aff-8993-592194acd881" providerId="ADAL" clId="{2E8B541E-162D-4ACF-9DDE-9003719A5286}" dt="2024-05-23T21:37:54.962" v="585"/>
          <ac:picMkLst>
            <pc:docMk/>
            <pc:sldMk cId="112906126" sldId="262"/>
            <ac:picMk id="29" creationId="{98A11ACF-0595-7CB7-C65C-AA3973B85B35}"/>
          </ac:picMkLst>
        </pc:picChg>
        <pc:picChg chg="mod">
          <ac:chgData name="Wallis, Deeann" userId="624450ec-2436-4aff-8993-592194acd881" providerId="ADAL" clId="{2E8B541E-162D-4ACF-9DDE-9003719A5286}" dt="2024-05-23T21:43:54.814" v="603"/>
          <ac:picMkLst>
            <pc:docMk/>
            <pc:sldMk cId="112906126" sldId="262"/>
            <ac:picMk id="36" creationId="{17E94A66-87C5-BAED-0943-FE2A048BFAB3}"/>
          </ac:picMkLst>
        </pc:picChg>
      </pc:sldChg>
      <pc:sldChg chg="modSp mod">
        <pc:chgData name="Wallis, Deeann" userId="624450ec-2436-4aff-8993-592194acd881" providerId="ADAL" clId="{2E8B541E-162D-4ACF-9DDE-9003719A5286}" dt="2024-05-30T20:33:07.968" v="732" actId="1076"/>
        <pc:sldMkLst>
          <pc:docMk/>
          <pc:sldMk cId="1271470338" sldId="271"/>
        </pc:sldMkLst>
        <pc:grpChg chg="mod">
          <ac:chgData name="Wallis, Deeann" userId="624450ec-2436-4aff-8993-592194acd881" providerId="ADAL" clId="{2E8B541E-162D-4ACF-9DDE-9003719A5286}" dt="2024-05-30T20:33:07.968" v="732" actId="1076"/>
          <ac:grpSpMkLst>
            <pc:docMk/>
            <pc:sldMk cId="1271470338" sldId="271"/>
            <ac:grpSpMk id="16" creationId="{EC00E86C-6DCD-6D65-55E7-8CC3A4FA2799}"/>
          </ac:grpSpMkLst>
        </pc:grpChg>
      </pc:sldChg>
      <pc:sldChg chg="addSp delSp modSp mod">
        <pc:chgData name="Wallis, Deeann" userId="624450ec-2436-4aff-8993-592194acd881" providerId="ADAL" clId="{2E8B541E-162D-4ACF-9DDE-9003719A5286}" dt="2024-05-23T20:57:03.563" v="575"/>
        <pc:sldMkLst>
          <pc:docMk/>
          <pc:sldMk cId="3430816546" sldId="276"/>
        </pc:sldMkLst>
        <pc:spChg chg="del">
          <ac:chgData name="Wallis, Deeann" userId="624450ec-2436-4aff-8993-592194acd881" providerId="ADAL" clId="{2E8B541E-162D-4ACF-9DDE-9003719A5286}" dt="2024-05-23T20:57:02.924" v="574" actId="478"/>
          <ac:spMkLst>
            <pc:docMk/>
            <pc:sldMk cId="3430816546" sldId="276"/>
            <ac:spMk id="2" creationId="{00000000-0000-0000-0000-000000000000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31" creationId="{241C51D4-3CB2-7B67-58DD-E67C306368F9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32" creationId="{FCBC18C2-C2C3-5AEA-B1D1-AC29EBB60AA0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53" creationId="{217D1B84-437D-8FA5-01B3-0047FD8EF61F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54" creationId="{3590E8B8-AA9A-4AD9-ED08-AB268C894685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55" creationId="{8E1A16AE-9FD5-0235-7674-B9A424858219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56" creationId="{073B2DA9-F4C9-2FE7-1F7A-6C9444A345C0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57" creationId="{418DDBD3-2731-B181-99A3-586450F0549D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59" creationId="{531E788F-FBDA-23FF-577D-ED7B982BB2D5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60" creationId="{EA80EF57-35C5-CE1E-086D-E547686A9525}"/>
          </ac:spMkLst>
        </pc:spChg>
        <pc:spChg chg="del">
          <ac:chgData name="Wallis, Deeann" userId="624450ec-2436-4aff-8993-592194acd881" providerId="ADAL" clId="{2E8B541E-162D-4ACF-9DDE-9003719A5286}" dt="2024-05-23T20:57:02.924" v="574" actId="478"/>
          <ac:spMkLst>
            <pc:docMk/>
            <pc:sldMk cId="3430816546" sldId="276"/>
            <ac:spMk id="61" creationId="{00000000-0000-0000-0000-000000000000}"/>
          </ac:spMkLst>
        </pc:spChg>
        <pc:spChg chg="del">
          <ac:chgData name="Wallis, Deeann" userId="624450ec-2436-4aff-8993-592194acd881" providerId="ADAL" clId="{2E8B541E-162D-4ACF-9DDE-9003719A5286}" dt="2024-05-23T20:57:02.924" v="574" actId="478"/>
          <ac:spMkLst>
            <pc:docMk/>
            <pc:sldMk cId="3430816546" sldId="276"/>
            <ac:spMk id="62" creationId="{00000000-0000-0000-0000-000000000000}"/>
          </ac:spMkLst>
        </pc:spChg>
        <pc:spChg chg="del">
          <ac:chgData name="Wallis, Deeann" userId="624450ec-2436-4aff-8993-592194acd881" providerId="ADAL" clId="{2E8B541E-162D-4ACF-9DDE-9003719A5286}" dt="2024-05-23T20:57:02.924" v="574" actId="478"/>
          <ac:spMkLst>
            <pc:docMk/>
            <pc:sldMk cId="3430816546" sldId="276"/>
            <ac:spMk id="63" creationId="{00000000-0000-0000-0000-000000000000}"/>
          </ac:spMkLst>
        </pc:spChg>
        <pc:spChg chg="del">
          <ac:chgData name="Wallis, Deeann" userId="624450ec-2436-4aff-8993-592194acd881" providerId="ADAL" clId="{2E8B541E-162D-4ACF-9DDE-9003719A5286}" dt="2024-05-23T20:57:02.924" v="574" actId="478"/>
          <ac:spMkLst>
            <pc:docMk/>
            <pc:sldMk cId="3430816546" sldId="276"/>
            <ac:spMk id="64" creationId="{00000000-0000-0000-0000-000000000000}"/>
          </ac:spMkLst>
        </pc:spChg>
        <pc:spChg chg="del">
          <ac:chgData name="Wallis, Deeann" userId="624450ec-2436-4aff-8993-592194acd881" providerId="ADAL" clId="{2E8B541E-162D-4ACF-9DDE-9003719A5286}" dt="2024-05-23T20:57:02.924" v="574" actId="478"/>
          <ac:spMkLst>
            <pc:docMk/>
            <pc:sldMk cId="3430816546" sldId="276"/>
            <ac:spMk id="65" creationId="{00000000-0000-0000-0000-000000000000}"/>
          </ac:spMkLst>
        </pc:spChg>
        <pc:spChg chg="del">
          <ac:chgData name="Wallis, Deeann" userId="624450ec-2436-4aff-8993-592194acd881" providerId="ADAL" clId="{2E8B541E-162D-4ACF-9DDE-9003719A5286}" dt="2024-05-23T20:57:02.924" v="574" actId="478"/>
          <ac:spMkLst>
            <pc:docMk/>
            <pc:sldMk cId="3430816546" sldId="276"/>
            <ac:spMk id="66" creationId="{00000000-0000-0000-0000-000000000000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67" creationId="{99232883-3564-90F4-EF60-AE8A78EBC13C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69" creationId="{427EA9D2-26FC-042E-115B-597AFF5E7DCF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70" creationId="{A5455AEE-2C87-18D3-E2E3-38E849A763E3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71" creationId="{B02FAFFD-92D9-71D6-51A7-E9EF0E5C8361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73" creationId="{21C0311A-5E27-924A-39F3-BCC2628101C8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74" creationId="{41C64078-10A0-2ED2-8726-1A35B749DFD0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75" creationId="{E86A875B-C463-3AD2-AFD6-43CB3C7352C2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77" creationId="{8EDD2A43-349D-F554-9F38-6BEAAB08E01F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78" creationId="{A9756670-459B-5569-E53C-0DAA6901B4DC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79" creationId="{E4B65F4D-FB9C-1028-DECC-A9B4BF99ECB6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81" creationId="{1FE5AA35-932E-B248-B689-D916E249274F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82" creationId="{17FC7C70-5F9D-36EF-ACED-29F3126388AF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83" creationId="{8A542B02-B617-5609-97BE-3570AEFEB3B0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85" creationId="{523C6455-158C-B941-DBC2-C72DC4C49033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87" creationId="{57CE150E-9FF8-CF5E-EF5F-2AC7823C862B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88" creationId="{96B9F06E-C406-30CB-6B26-FC7880905598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89" creationId="{43C23B53-9B01-C785-A227-68877061B9E8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90" creationId="{A79B8C61-7DBE-D8AA-82AB-B3A7366ED6EE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91" creationId="{8C9047F3-0FE3-EA51-C86D-56AC9036008B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92" creationId="{CD15B503-7EE7-0518-99FD-0CEC76375D34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93" creationId="{F5A1BA0F-486C-08BA-242D-A72103400DA6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94" creationId="{5255B303-02CF-2BF4-0FD0-FBF9911521FE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95" creationId="{B50600C7-D83F-013A-D032-5E9D81412D9F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96" creationId="{218CC905-DA01-1D08-54EA-182F0B0E5971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97" creationId="{E9CC3F99-11EA-6432-6E0D-E8D59C9173D9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98" creationId="{A1561712-41BA-BD6E-3445-364F2A9627E0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99" creationId="{62855FFD-7486-13D9-2D98-D7102C13A977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00" creationId="{9A8F3844-E9AD-3112-BE47-7E25DB5FE1A7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01" creationId="{11ABA85D-049C-2B3C-E332-AE2D977771FC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02" creationId="{D5250351-45B3-4176-5E81-EFCB394D5837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03" creationId="{792A32A1-15EE-8042-8F53-8C4895148A1F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04" creationId="{637A22E9-79D8-ABFE-A811-24B04932D429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05" creationId="{41ECB29B-7C06-8B85-9CF1-1DCD1F40621F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06" creationId="{2CFE0DF4-4190-650C-481C-314EAAF2F63F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07" creationId="{24F28829-ABB8-2085-0E07-94715CA99F7A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08" creationId="{445F431D-C4E7-6D72-9268-6D6B18E3001D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09" creationId="{09BDDFE7-3684-6E76-DF64-CB9C5436E5FC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10" creationId="{216DC0B6-AD40-1609-CC07-121A5C0B256B}"/>
          </ac:spMkLst>
        </pc:spChg>
        <pc:spChg chg="mod">
          <ac:chgData name="Wallis, Deeann" userId="624450ec-2436-4aff-8993-592194acd881" providerId="ADAL" clId="{2E8B541E-162D-4ACF-9DDE-9003719A5286}" dt="2024-05-23T20:57:03.563" v="575"/>
          <ac:spMkLst>
            <pc:docMk/>
            <pc:sldMk cId="3430816546" sldId="276"/>
            <ac:spMk id="111" creationId="{86951CA4-F2BA-8A9A-8B8B-15404BE32C26}"/>
          </ac:spMkLst>
        </pc:spChg>
        <pc:grpChg chg="add mod">
          <ac:chgData name="Wallis, Deeann" userId="624450ec-2436-4aff-8993-592194acd881" providerId="ADAL" clId="{2E8B541E-162D-4ACF-9DDE-9003719A5286}" dt="2024-05-23T20:57:03.563" v="575"/>
          <ac:grpSpMkLst>
            <pc:docMk/>
            <pc:sldMk cId="3430816546" sldId="276"/>
            <ac:grpSpMk id="4" creationId="{0D8F6C2E-CD59-85AC-F48C-5197E88663EC}"/>
          </ac:grpSpMkLst>
        </pc:grpChg>
        <pc:grpChg chg="mod">
          <ac:chgData name="Wallis, Deeann" userId="624450ec-2436-4aff-8993-592194acd881" providerId="ADAL" clId="{2E8B541E-162D-4ACF-9DDE-9003719A5286}" dt="2024-05-23T20:57:03.563" v="575"/>
          <ac:grpSpMkLst>
            <pc:docMk/>
            <pc:sldMk cId="3430816546" sldId="276"/>
            <ac:grpSpMk id="6" creationId="{AF3B0CF1-2B3E-ACF3-1E7E-606AF8BB6C24}"/>
          </ac:grpSpMkLst>
        </pc:grpChg>
        <pc:grpChg chg="mod">
          <ac:chgData name="Wallis, Deeann" userId="624450ec-2436-4aff-8993-592194acd881" providerId="ADAL" clId="{2E8B541E-162D-4ACF-9DDE-9003719A5286}" dt="2024-05-23T20:57:03.563" v="575"/>
          <ac:grpSpMkLst>
            <pc:docMk/>
            <pc:sldMk cId="3430816546" sldId="276"/>
            <ac:grpSpMk id="8" creationId="{EAE4095F-E320-9A5A-3F7F-02D41E9A470F}"/>
          </ac:grpSpMkLst>
        </pc:grpChg>
        <pc:grpChg chg="mod">
          <ac:chgData name="Wallis, Deeann" userId="624450ec-2436-4aff-8993-592194acd881" providerId="ADAL" clId="{2E8B541E-162D-4ACF-9DDE-9003719A5286}" dt="2024-05-23T20:57:03.563" v="575"/>
          <ac:grpSpMkLst>
            <pc:docMk/>
            <pc:sldMk cId="3430816546" sldId="276"/>
            <ac:grpSpMk id="10" creationId="{BD026D2A-F443-D477-6597-9C0285AFB342}"/>
          </ac:grpSpMkLst>
        </pc:grpChg>
        <pc:grpChg chg="mod">
          <ac:chgData name="Wallis, Deeann" userId="624450ec-2436-4aff-8993-592194acd881" providerId="ADAL" clId="{2E8B541E-162D-4ACF-9DDE-9003719A5286}" dt="2024-05-23T20:57:03.563" v="575"/>
          <ac:grpSpMkLst>
            <pc:docMk/>
            <pc:sldMk cId="3430816546" sldId="276"/>
            <ac:grpSpMk id="12" creationId="{A6499087-1F73-2DAC-11FC-BCBF2E601F76}"/>
          </ac:grpSpMkLst>
        </pc:grpChg>
        <pc:grpChg chg="mod">
          <ac:chgData name="Wallis, Deeann" userId="624450ec-2436-4aff-8993-592194acd881" providerId="ADAL" clId="{2E8B541E-162D-4ACF-9DDE-9003719A5286}" dt="2024-05-23T20:57:03.563" v="575"/>
          <ac:grpSpMkLst>
            <pc:docMk/>
            <pc:sldMk cId="3430816546" sldId="276"/>
            <ac:grpSpMk id="14" creationId="{3CC83CD2-0A2E-78C6-B091-173FF1964EA0}"/>
          </ac:grpSpMkLst>
        </pc:grpChg>
        <pc:grpChg chg="del">
          <ac:chgData name="Wallis, Deeann" userId="624450ec-2436-4aff-8993-592194acd881" providerId="ADAL" clId="{2E8B541E-162D-4ACF-9DDE-9003719A5286}" dt="2024-05-23T20:57:02.924" v="574" actId="478"/>
          <ac:grpSpMkLst>
            <pc:docMk/>
            <pc:sldMk cId="3430816546" sldId="276"/>
            <ac:grpSpMk id="21" creationId="{9C00BB17-8D6A-EC96-544C-3915F86E529B}"/>
          </ac:grpSpMkLst>
        </pc:grpChg>
        <pc:grpChg chg="del">
          <ac:chgData name="Wallis, Deeann" userId="624450ec-2436-4aff-8993-592194acd881" providerId="ADAL" clId="{2E8B541E-162D-4ACF-9DDE-9003719A5286}" dt="2024-05-23T20:57:02.924" v="574" actId="478"/>
          <ac:grpSpMkLst>
            <pc:docMk/>
            <pc:sldMk cId="3430816546" sldId="276"/>
            <ac:grpSpMk id="23" creationId="{87277251-A7FE-2792-272B-9D013C32C7D1}"/>
          </ac:grpSpMkLst>
        </pc:grpChg>
        <pc:grpChg chg="mod">
          <ac:chgData name="Wallis, Deeann" userId="624450ec-2436-4aff-8993-592194acd881" providerId="ADAL" clId="{2E8B541E-162D-4ACF-9DDE-9003719A5286}" dt="2024-05-23T20:57:03.563" v="575"/>
          <ac:grpSpMkLst>
            <pc:docMk/>
            <pc:sldMk cId="3430816546" sldId="276"/>
            <ac:grpSpMk id="24" creationId="{A70CB33F-116B-CFF0-F294-B916CF1FEF66}"/>
          </ac:grpSpMkLst>
        </pc:grpChg>
        <pc:grpChg chg="mod">
          <ac:chgData name="Wallis, Deeann" userId="624450ec-2436-4aff-8993-592194acd881" providerId="ADAL" clId="{2E8B541E-162D-4ACF-9DDE-9003719A5286}" dt="2024-05-23T20:57:03.563" v="575"/>
          <ac:grpSpMkLst>
            <pc:docMk/>
            <pc:sldMk cId="3430816546" sldId="276"/>
            <ac:grpSpMk id="25" creationId="{D71C1844-044A-4B8A-75C1-85E03075C86F}"/>
          </ac:grpSpMkLst>
        </pc:grpChg>
        <pc:grpChg chg="del">
          <ac:chgData name="Wallis, Deeann" userId="624450ec-2436-4aff-8993-592194acd881" providerId="ADAL" clId="{2E8B541E-162D-4ACF-9DDE-9003719A5286}" dt="2024-05-23T20:57:02.924" v="574" actId="478"/>
          <ac:grpSpMkLst>
            <pc:docMk/>
            <pc:sldMk cId="3430816546" sldId="276"/>
            <ac:grpSpMk id="27" creationId="{F505330F-8311-7D5B-A150-C94A2AAEBDCA}"/>
          </ac:grpSpMkLst>
        </pc:grpChg>
        <pc:grpChg chg="mod">
          <ac:chgData name="Wallis, Deeann" userId="624450ec-2436-4aff-8993-592194acd881" providerId="ADAL" clId="{2E8B541E-162D-4ACF-9DDE-9003719A5286}" dt="2024-05-23T20:57:03.563" v="575"/>
          <ac:grpSpMkLst>
            <pc:docMk/>
            <pc:sldMk cId="3430816546" sldId="276"/>
            <ac:grpSpMk id="28" creationId="{B3397029-14DC-794E-7447-F960CB095329}"/>
          </ac:grpSpMkLst>
        </pc:grpChg>
        <pc:grpChg chg="mod">
          <ac:chgData name="Wallis, Deeann" userId="624450ec-2436-4aff-8993-592194acd881" providerId="ADAL" clId="{2E8B541E-162D-4ACF-9DDE-9003719A5286}" dt="2024-05-23T20:57:03.563" v="575"/>
          <ac:grpSpMkLst>
            <pc:docMk/>
            <pc:sldMk cId="3430816546" sldId="276"/>
            <ac:grpSpMk id="29" creationId="{6D256740-F608-4D63-8A1B-CA09233508CE}"/>
          </ac:grpSpMkLst>
        </pc:grpChg>
        <pc:grpChg chg="mod">
          <ac:chgData name="Wallis, Deeann" userId="624450ec-2436-4aff-8993-592194acd881" providerId="ADAL" clId="{2E8B541E-162D-4ACF-9DDE-9003719A5286}" dt="2024-05-23T20:57:03.563" v="575"/>
          <ac:grpSpMkLst>
            <pc:docMk/>
            <pc:sldMk cId="3430816546" sldId="276"/>
            <ac:grpSpMk id="30" creationId="{95C2D8FD-A9AA-3576-A801-7EB4B5D2F508}"/>
          </ac:grpSpMkLst>
        </pc:grpChg>
        <pc:grpChg chg="del">
          <ac:chgData name="Wallis, Deeann" userId="624450ec-2436-4aff-8993-592194acd881" providerId="ADAL" clId="{2E8B541E-162D-4ACF-9DDE-9003719A5286}" dt="2024-05-23T20:57:02.924" v="574" actId="478"/>
          <ac:grpSpMkLst>
            <pc:docMk/>
            <pc:sldMk cId="3430816546" sldId="276"/>
            <ac:grpSpMk id="48" creationId="{FCB3EB8B-0E3D-7622-6749-AC0AB604A8DB}"/>
          </ac:grpSpMkLst>
        </pc:grpChg>
        <pc:grpChg chg="del">
          <ac:chgData name="Wallis, Deeann" userId="624450ec-2436-4aff-8993-592194acd881" providerId="ADAL" clId="{2E8B541E-162D-4ACF-9DDE-9003719A5286}" dt="2024-05-23T20:57:02.924" v="574" actId="478"/>
          <ac:grpSpMkLst>
            <pc:docMk/>
            <pc:sldMk cId="3430816546" sldId="276"/>
            <ac:grpSpMk id="49" creationId="{E8045CFF-1CA4-E211-C00C-6503E7BF6FFB}"/>
          </ac:grpSpMkLst>
        </pc:grpChg>
        <pc:grpChg chg="del">
          <ac:chgData name="Wallis, Deeann" userId="624450ec-2436-4aff-8993-592194acd881" providerId="ADAL" clId="{2E8B541E-162D-4ACF-9DDE-9003719A5286}" dt="2024-05-23T20:57:02.924" v="574" actId="478"/>
          <ac:grpSpMkLst>
            <pc:docMk/>
            <pc:sldMk cId="3430816546" sldId="276"/>
            <ac:grpSpMk id="50" creationId="{DF6811F6-F432-128D-38E3-52526605DBB7}"/>
          </ac:grpSpMkLst>
        </pc:grpChg>
        <pc:grpChg chg="del">
          <ac:chgData name="Wallis, Deeann" userId="624450ec-2436-4aff-8993-592194acd881" providerId="ADAL" clId="{2E8B541E-162D-4ACF-9DDE-9003719A5286}" dt="2024-05-23T20:57:02.924" v="574" actId="478"/>
          <ac:grpSpMkLst>
            <pc:docMk/>
            <pc:sldMk cId="3430816546" sldId="276"/>
            <ac:grpSpMk id="51" creationId="{5F1B35EA-A521-E79E-C074-BF9F4847BDF2}"/>
          </ac:grpSpMkLst>
        </pc:grpChg>
        <pc:grpChg chg="del">
          <ac:chgData name="Wallis, Deeann" userId="624450ec-2436-4aff-8993-592194acd881" providerId="ADAL" clId="{2E8B541E-162D-4ACF-9DDE-9003719A5286}" dt="2024-05-23T20:57:02.924" v="574" actId="478"/>
          <ac:grpSpMkLst>
            <pc:docMk/>
            <pc:sldMk cId="3430816546" sldId="276"/>
            <ac:grpSpMk id="52" creationId="{2730CCA4-BFFC-9AB8-22CF-DC736F4C0736}"/>
          </ac:grpSpMkLst>
        </pc:grpChg>
        <pc:grpChg chg="del">
          <ac:chgData name="Wallis, Deeann" userId="624450ec-2436-4aff-8993-592194acd881" providerId="ADAL" clId="{2E8B541E-162D-4ACF-9DDE-9003719A5286}" dt="2024-05-23T20:57:02.924" v="574" actId="478"/>
          <ac:grpSpMkLst>
            <pc:docMk/>
            <pc:sldMk cId="3430816546" sldId="276"/>
            <ac:grpSpMk id="156" creationId="{BE2D56B6-252C-D0A0-79A4-B767B6466F57}"/>
          </ac:grpSpMkLst>
        </pc:grpChg>
        <pc:grpChg chg="del">
          <ac:chgData name="Wallis, Deeann" userId="624450ec-2436-4aff-8993-592194acd881" providerId="ADAL" clId="{2E8B541E-162D-4ACF-9DDE-9003719A5286}" dt="2024-05-23T20:57:02.924" v="574" actId="478"/>
          <ac:grpSpMkLst>
            <pc:docMk/>
            <pc:sldMk cId="3430816546" sldId="276"/>
            <ac:grpSpMk id="184" creationId="{701EA5C2-C9C1-74ED-41C4-98CCFC0C4761}"/>
          </ac:grpSpMkLst>
        </pc:grpChg>
        <pc:picChg chg="mod">
          <ac:chgData name="Wallis, Deeann" userId="624450ec-2436-4aff-8993-592194acd881" providerId="ADAL" clId="{2E8B541E-162D-4ACF-9DDE-9003719A5286}" dt="2024-05-23T20:57:03.563" v="575"/>
          <ac:picMkLst>
            <pc:docMk/>
            <pc:sldMk cId="3430816546" sldId="276"/>
            <ac:picMk id="58" creationId="{ED740292-E55B-7B4F-BDC8-63648B8AD05C}"/>
          </ac:picMkLst>
        </pc:picChg>
        <pc:picChg chg="mod">
          <ac:chgData name="Wallis, Deeann" userId="624450ec-2436-4aff-8993-592194acd881" providerId="ADAL" clId="{2E8B541E-162D-4ACF-9DDE-9003719A5286}" dt="2024-05-23T20:57:03.563" v="575"/>
          <ac:picMkLst>
            <pc:docMk/>
            <pc:sldMk cId="3430816546" sldId="276"/>
            <ac:picMk id="68" creationId="{95557841-E5F5-DF84-7E92-CCB740715A2F}"/>
          </ac:picMkLst>
        </pc:picChg>
        <pc:picChg chg="mod">
          <ac:chgData name="Wallis, Deeann" userId="624450ec-2436-4aff-8993-592194acd881" providerId="ADAL" clId="{2E8B541E-162D-4ACF-9DDE-9003719A5286}" dt="2024-05-23T20:57:03.563" v="575"/>
          <ac:picMkLst>
            <pc:docMk/>
            <pc:sldMk cId="3430816546" sldId="276"/>
            <ac:picMk id="72" creationId="{0E8DB52B-F507-E91C-7739-196CB617F6AB}"/>
          </ac:picMkLst>
        </pc:picChg>
        <pc:picChg chg="mod">
          <ac:chgData name="Wallis, Deeann" userId="624450ec-2436-4aff-8993-592194acd881" providerId="ADAL" clId="{2E8B541E-162D-4ACF-9DDE-9003719A5286}" dt="2024-05-23T20:57:03.563" v="575"/>
          <ac:picMkLst>
            <pc:docMk/>
            <pc:sldMk cId="3430816546" sldId="276"/>
            <ac:picMk id="76" creationId="{C7B35246-DE83-66EA-9260-20F2D834BCEB}"/>
          </ac:picMkLst>
        </pc:picChg>
        <pc:picChg chg="mod">
          <ac:chgData name="Wallis, Deeann" userId="624450ec-2436-4aff-8993-592194acd881" providerId="ADAL" clId="{2E8B541E-162D-4ACF-9DDE-9003719A5286}" dt="2024-05-23T20:57:03.563" v="575"/>
          <ac:picMkLst>
            <pc:docMk/>
            <pc:sldMk cId="3430816546" sldId="276"/>
            <ac:picMk id="80" creationId="{BC99D05E-CD71-1426-DF13-8C54DAF41D7C}"/>
          </ac:picMkLst>
        </pc:picChg>
        <pc:picChg chg="mod">
          <ac:chgData name="Wallis, Deeann" userId="624450ec-2436-4aff-8993-592194acd881" providerId="ADAL" clId="{2E8B541E-162D-4ACF-9DDE-9003719A5286}" dt="2024-05-23T20:57:03.563" v="575"/>
          <ac:picMkLst>
            <pc:docMk/>
            <pc:sldMk cId="3430816546" sldId="276"/>
            <ac:picMk id="84" creationId="{66D9166B-1B2F-85F3-C383-9B63DF6AD939}"/>
          </ac:picMkLst>
        </pc:picChg>
        <pc:picChg chg="mod">
          <ac:chgData name="Wallis, Deeann" userId="624450ec-2436-4aff-8993-592194acd881" providerId="ADAL" clId="{2E8B541E-162D-4ACF-9DDE-9003719A5286}" dt="2024-05-23T20:57:03.563" v="575"/>
          <ac:picMkLst>
            <pc:docMk/>
            <pc:sldMk cId="3430816546" sldId="276"/>
            <ac:picMk id="86" creationId="{5EF18112-3DB0-0CB7-A129-DF1D1EC97F8D}"/>
          </ac:picMkLst>
        </pc:picChg>
      </pc:sldChg>
      <pc:sldChg chg="modSp mod">
        <pc:chgData name="Wallis, Deeann" userId="624450ec-2436-4aff-8993-592194acd881" providerId="ADAL" clId="{2E8B541E-162D-4ACF-9DDE-9003719A5286}" dt="2024-05-23T20:01:49.120" v="523" actId="1076"/>
        <pc:sldMkLst>
          <pc:docMk/>
          <pc:sldMk cId="4106249868" sldId="277"/>
        </pc:sldMkLst>
        <pc:grpChg chg="mod">
          <ac:chgData name="Wallis, Deeann" userId="624450ec-2436-4aff-8993-592194acd881" providerId="ADAL" clId="{2E8B541E-162D-4ACF-9DDE-9003719A5286}" dt="2024-05-23T20:00:53.069" v="498" actId="14100"/>
          <ac:grpSpMkLst>
            <pc:docMk/>
            <pc:sldMk cId="4106249868" sldId="277"/>
            <ac:grpSpMk id="7" creationId="{7D28070D-D6A7-3CA5-D3C1-57179F9960F9}"/>
          </ac:grpSpMkLst>
        </pc:grpChg>
        <pc:grpChg chg="mod">
          <ac:chgData name="Wallis, Deeann" userId="624450ec-2436-4aff-8993-592194acd881" providerId="ADAL" clId="{2E8B541E-162D-4ACF-9DDE-9003719A5286}" dt="2024-05-23T20:01:49.120" v="523" actId="1076"/>
          <ac:grpSpMkLst>
            <pc:docMk/>
            <pc:sldMk cId="4106249868" sldId="277"/>
            <ac:grpSpMk id="11" creationId="{8DA49533-3516-88F8-6105-144292DA4263}"/>
          </ac:grpSpMkLst>
        </pc:grpChg>
        <pc:grpChg chg="mod">
          <ac:chgData name="Wallis, Deeann" userId="624450ec-2436-4aff-8993-592194acd881" providerId="ADAL" clId="{2E8B541E-162D-4ACF-9DDE-9003719A5286}" dt="2024-05-23T20:01:12.097" v="506" actId="1036"/>
          <ac:grpSpMkLst>
            <pc:docMk/>
            <pc:sldMk cId="4106249868" sldId="277"/>
            <ac:grpSpMk id="18" creationId="{C65E8ABB-C079-7E05-9F04-6A3EC72EBF95}"/>
          </ac:grpSpMkLst>
        </pc:grpChg>
        <pc:grpChg chg="mod">
          <ac:chgData name="Wallis, Deeann" userId="624450ec-2436-4aff-8993-592194acd881" providerId="ADAL" clId="{2E8B541E-162D-4ACF-9DDE-9003719A5286}" dt="2024-05-23T20:01:29.819" v="515" actId="14100"/>
          <ac:grpSpMkLst>
            <pc:docMk/>
            <pc:sldMk cId="4106249868" sldId="277"/>
            <ac:grpSpMk id="20" creationId="{56AF93CB-2DBB-D314-279F-35DEA2DE0C8F}"/>
          </ac:grpSpMkLst>
        </pc:grpChg>
      </pc:sldChg>
      <pc:sldChg chg="addSp delSp modSp mod">
        <pc:chgData name="Wallis, Deeann" userId="624450ec-2436-4aff-8993-592194acd881" providerId="ADAL" clId="{2E8B541E-162D-4ACF-9DDE-9003719A5286}" dt="2024-05-30T20:52:42.788" v="869" actId="166"/>
        <pc:sldMkLst>
          <pc:docMk/>
          <pc:sldMk cId="580318421" sldId="282"/>
        </pc:sldMkLst>
        <pc:spChg chg="add del mod">
          <ac:chgData name="Wallis, Deeann" userId="624450ec-2436-4aff-8993-592194acd881" providerId="ADAL" clId="{2E8B541E-162D-4ACF-9DDE-9003719A5286}" dt="2024-05-30T20:47:02.399" v="797" actId="478"/>
          <ac:spMkLst>
            <pc:docMk/>
            <pc:sldMk cId="580318421" sldId="282"/>
            <ac:spMk id="4" creationId="{D1AEEAA9-1965-772F-1066-80E84B512533}"/>
          </ac:spMkLst>
        </pc:spChg>
        <pc:spChg chg="add mod">
          <ac:chgData name="Wallis, Deeann" userId="624450ec-2436-4aff-8993-592194acd881" providerId="ADAL" clId="{2E8B541E-162D-4ACF-9DDE-9003719A5286}" dt="2024-05-30T20:47:08.657" v="799" actId="1076"/>
          <ac:spMkLst>
            <pc:docMk/>
            <pc:sldMk cId="580318421" sldId="282"/>
            <ac:spMk id="7" creationId="{F22BC9C6-9783-3EFF-9A49-B7C4F1031D8B}"/>
          </ac:spMkLst>
        </pc:spChg>
        <pc:spChg chg="add mod">
          <ac:chgData name="Wallis, Deeann" userId="624450ec-2436-4aff-8993-592194acd881" providerId="ADAL" clId="{2E8B541E-162D-4ACF-9DDE-9003719A5286}" dt="2024-05-30T20:47:53.397" v="804" actId="207"/>
          <ac:spMkLst>
            <pc:docMk/>
            <pc:sldMk cId="580318421" sldId="282"/>
            <ac:spMk id="8" creationId="{BA5CE44B-17E3-098F-5B36-430A135451E0}"/>
          </ac:spMkLst>
        </pc:spChg>
        <pc:spChg chg="add mod">
          <ac:chgData name="Wallis, Deeann" userId="624450ec-2436-4aff-8993-592194acd881" providerId="ADAL" clId="{2E8B541E-162D-4ACF-9DDE-9003719A5286}" dt="2024-05-30T20:49:26.416" v="835" actId="1076"/>
          <ac:spMkLst>
            <pc:docMk/>
            <pc:sldMk cId="580318421" sldId="282"/>
            <ac:spMk id="9" creationId="{AF8B6B90-8325-1E7D-EC45-9BC5BAEF9BEB}"/>
          </ac:spMkLst>
        </pc:spChg>
        <pc:spChg chg="add mod ord">
          <ac:chgData name="Wallis, Deeann" userId="624450ec-2436-4aff-8993-592194acd881" providerId="ADAL" clId="{2E8B541E-162D-4ACF-9DDE-9003719A5286}" dt="2024-05-30T20:51:12.634" v="855" actId="1076"/>
          <ac:spMkLst>
            <pc:docMk/>
            <pc:sldMk cId="580318421" sldId="282"/>
            <ac:spMk id="13" creationId="{99B5F20B-9D7D-9588-03FD-22999ECA7B6E}"/>
          </ac:spMkLst>
        </pc:spChg>
        <pc:spChg chg="add mod">
          <ac:chgData name="Wallis, Deeann" userId="624450ec-2436-4aff-8993-592194acd881" providerId="ADAL" clId="{2E8B541E-162D-4ACF-9DDE-9003719A5286}" dt="2024-05-30T20:49:59.991" v="843" actId="207"/>
          <ac:spMkLst>
            <pc:docMk/>
            <pc:sldMk cId="580318421" sldId="282"/>
            <ac:spMk id="14" creationId="{80A27DB7-AF03-E365-8941-9F177B4EFB60}"/>
          </ac:spMkLst>
        </pc:spChg>
        <pc:spChg chg="mod">
          <ac:chgData name="Wallis, Deeann" userId="624450ec-2436-4aff-8993-592194acd881" providerId="ADAL" clId="{2E8B541E-162D-4ACF-9DDE-9003719A5286}" dt="2024-05-23T18:48:42.152" v="21" actId="1076"/>
          <ac:spMkLst>
            <pc:docMk/>
            <pc:sldMk cId="580318421" sldId="282"/>
            <ac:spMk id="15" creationId="{00000000-0000-0000-0000-000000000000}"/>
          </ac:spMkLst>
        </pc:spChg>
        <pc:spChg chg="mod">
          <ac:chgData name="Wallis, Deeann" userId="624450ec-2436-4aff-8993-592194acd881" providerId="ADAL" clId="{2E8B541E-162D-4ACF-9DDE-9003719A5286}" dt="2024-05-23T18:48:48.498" v="22" actId="1076"/>
          <ac:spMkLst>
            <pc:docMk/>
            <pc:sldMk cId="580318421" sldId="282"/>
            <ac:spMk id="16" creationId="{00000000-0000-0000-0000-000000000000}"/>
          </ac:spMkLst>
        </pc:spChg>
        <pc:spChg chg="add mod ord">
          <ac:chgData name="Wallis, Deeann" userId="624450ec-2436-4aff-8993-592194acd881" providerId="ADAL" clId="{2E8B541E-162D-4ACF-9DDE-9003719A5286}" dt="2024-05-30T20:52:12.836" v="864" actId="166"/>
          <ac:spMkLst>
            <pc:docMk/>
            <pc:sldMk cId="580318421" sldId="282"/>
            <ac:spMk id="22" creationId="{F3E0A759-2118-6253-9BCE-7C6AB55F17F8}"/>
          </ac:spMkLst>
        </pc:spChg>
        <pc:spChg chg="add mod ord">
          <ac:chgData name="Wallis, Deeann" userId="624450ec-2436-4aff-8993-592194acd881" providerId="ADAL" clId="{2E8B541E-162D-4ACF-9DDE-9003719A5286}" dt="2024-05-30T20:52:42.788" v="869" actId="166"/>
          <ac:spMkLst>
            <pc:docMk/>
            <pc:sldMk cId="580318421" sldId="282"/>
            <ac:spMk id="23" creationId="{59E75A4F-9B80-4FEB-7D20-338824DFF703}"/>
          </ac:spMkLst>
        </pc:spChg>
        <pc:spChg chg="add mod">
          <ac:chgData name="Wallis, Deeann" userId="624450ec-2436-4aff-8993-592194acd881" providerId="ADAL" clId="{2E8B541E-162D-4ACF-9DDE-9003719A5286}" dt="2024-05-30T20:52:00.274" v="862" actId="207"/>
          <ac:spMkLst>
            <pc:docMk/>
            <pc:sldMk cId="580318421" sldId="282"/>
            <ac:spMk id="24" creationId="{E43D8D91-962D-CCA5-B8F7-A20BFC3BE830}"/>
          </ac:spMkLst>
        </pc:spChg>
        <pc:spChg chg="add mod">
          <ac:chgData name="Wallis, Deeann" userId="624450ec-2436-4aff-8993-592194acd881" providerId="ADAL" clId="{2E8B541E-162D-4ACF-9DDE-9003719A5286}" dt="2024-05-30T20:52:31.487" v="867" actId="207"/>
          <ac:spMkLst>
            <pc:docMk/>
            <pc:sldMk cId="580318421" sldId="282"/>
            <ac:spMk id="25" creationId="{5FBA2DE1-8677-180A-3EBA-0D94FB791368}"/>
          </ac:spMkLst>
        </pc:spChg>
        <pc:spChg chg="mod">
          <ac:chgData name="Wallis, Deeann" userId="624450ec-2436-4aff-8993-592194acd881" providerId="ADAL" clId="{2E8B541E-162D-4ACF-9DDE-9003719A5286}" dt="2024-05-23T18:48:59.906" v="24" actId="1076"/>
          <ac:spMkLst>
            <pc:docMk/>
            <pc:sldMk cId="580318421" sldId="282"/>
            <ac:spMk id="40" creationId="{6F8C0534-F5CD-AC24-E04E-FCB475CB9CB7}"/>
          </ac:spMkLst>
        </pc:spChg>
        <pc:spChg chg="mod">
          <ac:chgData name="Wallis, Deeann" userId="624450ec-2436-4aff-8993-592194acd881" providerId="ADAL" clId="{2E8B541E-162D-4ACF-9DDE-9003719A5286}" dt="2024-05-23T18:48:54.581" v="23" actId="1076"/>
          <ac:spMkLst>
            <pc:docMk/>
            <pc:sldMk cId="580318421" sldId="282"/>
            <ac:spMk id="41" creationId="{4F0A157D-B17F-E991-2ABE-FD2154687A1A}"/>
          </ac:spMkLst>
        </pc:spChg>
        <pc:spChg chg="mod">
          <ac:chgData name="Wallis, Deeann" userId="624450ec-2436-4aff-8993-592194acd881" providerId="ADAL" clId="{2E8B541E-162D-4ACF-9DDE-9003719A5286}" dt="2024-05-30T20:46:54.782" v="796" actId="20577"/>
          <ac:spMkLst>
            <pc:docMk/>
            <pc:sldMk cId="580318421" sldId="282"/>
            <ac:spMk id="46" creationId="{1186B7D1-DE06-2201-9FCE-C85C77CF3363}"/>
          </ac:spMkLst>
        </pc:spChg>
        <pc:spChg chg="del">
          <ac:chgData name="Wallis, Deeann" userId="624450ec-2436-4aff-8993-592194acd881" providerId="ADAL" clId="{2E8B541E-162D-4ACF-9DDE-9003719A5286}" dt="2024-05-30T20:45:25.555" v="783" actId="478"/>
          <ac:spMkLst>
            <pc:docMk/>
            <pc:sldMk cId="580318421" sldId="282"/>
            <ac:spMk id="47" creationId="{9BC60E49-5A2E-8BBF-1A6E-9BE2014C8E84}"/>
          </ac:spMkLst>
        </pc:spChg>
        <pc:spChg chg="mod">
          <ac:chgData name="Wallis, Deeann" userId="624450ec-2436-4aff-8993-592194acd881" providerId="ADAL" clId="{2E8B541E-162D-4ACF-9DDE-9003719A5286}" dt="2024-05-23T18:50:33.973" v="29" actId="1076"/>
          <ac:spMkLst>
            <pc:docMk/>
            <pc:sldMk cId="580318421" sldId="282"/>
            <ac:spMk id="76" creationId="{3816C047-42BE-AAC7-3144-0630041D9094}"/>
          </ac:spMkLst>
        </pc:spChg>
        <pc:spChg chg="mod">
          <ac:chgData name="Wallis, Deeann" userId="624450ec-2436-4aff-8993-592194acd881" providerId="ADAL" clId="{2E8B541E-162D-4ACF-9DDE-9003719A5286}" dt="2024-05-23T18:50:37.987" v="30" actId="1076"/>
          <ac:spMkLst>
            <pc:docMk/>
            <pc:sldMk cId="580318421" sldId="282"/>
            <ac:spMk id="77" creationId="{F3B89F95-B236-F793-E151-B1E50034CEA7}"/>
          </ac:spMkLst>
        </pc:spChg>
        <pc:spChg chg="mod">
          <ac:chgData name="Wallis, Deeann" userId="624450ec-2436-4aff-8993-592194acd881" providerId="ADAL" clId="{2E8B541E-162D-4ACF-9DDE-9003719A5286}" dt="2024-05-23T18:50:47.180" v="31" actId="1076"/>
          <ac:spMkLst>
            <pc:docMk/>
            <pc:sldMk cId="580318421" sldId="282"/>
            <ac:spMk id="78" creationId="{838CECB4-680C-8DDD-2DFB-B06EB0816F4D}"/>
          </ac:spMkLst>
        </pc:spChg>
        <pc:picChg chg="mod">
          <ac:chgData name="Wallis, Deeann" userId="624450ec-2436-4aff-8993-592194acd881" providerId="ADAL" clId="{2E8B541E-162D-4ACF-9DDE-9003719A5286}" dt="2024-05-23T18:50:12.204" v="27" actId="1076"/>
          <ac:picMkLst>
            <pc:docMk/>
            <pc:sldMk cId="580318421" sldId="282"/>
            <ac:picMk id="73" creationId="{A2DC0D8E-FFC2-A3AC-294F-078BFAD91B2D}"/>
          </ac:picMkLst>
        </pc:picChg>
        <pc:picChg chg="mod">
          <ac:chgData name="Wallis, Deeann" userId="624450ec-2436-4aff-8993-592194acd881" providerId="ADAL" clId="{2E8B541E-162D-4ACF-9DDE-9003719A5286}" dt="2024-05-23T18:48:28.966" v="18" actId="14100"/>
          <ac:picMkLst>
            <pc:docMk/>
            <pc:sldMk cId="580318421" sldId="282"/>
            <ac:picMk id="75" creationId="{87A3FB5E-6787-1D46-0CE2-EE7656682696}"/>
          </ac:picMkLst>
        </pc:picChg>
      </pc:sldChg>
      <pc:sldChg chg="del">
        <pc:chgData name="Wallis, Deeann" userId="624450ec-2436-4aff-8993-592194acd881" providerId="ADAL" clId="{2E8B541E-162D-4ACF-9DDE-9003719A5286}" dt="2024-05-23T19:35:01.162" v="346" actId="47"/>
        <pc:sldMkLst>
          <pc:docMk/>
          <pc:sldMk cId="3796534110" sldId="285"/>
        </pc:sldMkLst>
      </pc:sldChg>
      <pc:sldChg chg="del">
        <pc:chgData name="Wallis, Deeann" userId="624450ec-2436-4aff-8993-592194acd881" providerId="ADAL" clId="{2E8B541E-162D-4ACF-9DDE-9003719A5286}" dt="2024-05-23T19:35:05.801" v="347" actId="47"/>
        <pc:sldMkLst>
          <pc:docMk/>
          <pc:sldMk cId="1324626067" sldId="286"/>
        </pc:sldMkLst>
      </pc:sldChg>
      <pc:sldChg chg="modSp mod">
        <pc:chgData name="Wallis, Deeann" userId="624450ec-2436-4aff-8993-592194acd881" providerId="ADAL" clId="{2E8B541E-162D-4ACF-9DDE-9003719A5286}" dt="2024-05-23T19:39:50.653" v="394" actId="1076"/>
        <pc:sldMkLst>
          <pc:docMk/>
          <pc:sldMk cId="1228655777" sldId="287"/>
        </pc:sldMkLst>
        <pc:spChg chg="mod">
          <ac:chgData name="Wallis, Deeann" userId="624450ec-2436-4aff-8993-592194acd881" providerId="ADAL" clId="{2E8B541E-162D-4ACF-9DDE-9003719A5286}" dt="2024-05-23T19:39:44.492" v="393" actId="1076"/>
          <ac:spMkLst>
            <pc:docMk/>
            <pc:sldMk cId="1228655777" sldId="287"/>
            <ac:spMk id="4" creationId="{3720F012-AF40-95C4-F9F6-FA2B4FDDD75C}"/>
          </ac:spMkLst>
        </pc:spChg>
        <pc:spChg chg="mod">
          <ac:chgData name="Wallis, Deeann" userId="624450ec-2436-4aff-8993-592194acd881" providerId="ADAL" clId="{2E8B541E-162D-4ACF-9DDE-9003719A5286}" dt="2024-05-23T19:39:50.653" v="394" actId="1076"/>
          <ac:spMkLst>
            <pc:docMk/>
            <pc:sldMk cId="1228655777" sldId="287"/>
            <ac:spMk id="5" creationId="{D6A12B45-879D-DB78-A0BC-DF964FED4F59}"/>
          </ac:spMkLst>
        </pc:spChg>
        <pc:spChg chg="mod">
          <ac:chgData name="Wallis, Deeann" userId="624450ec-2436-4aff-8993-592194acd881" providerId="ADAL" clId="{2E8B541E-162D-4ACF-9DDE-9003719A5286}" dt="2024-05-23T19:39:44.492" v="393" actId="1076"/>
          <ac:spMkLst>
            <pc:docMk/>
            <pc:sldMk cId="1228655777" sldId="287"/>
            <ac:spMk id="16" creationId="{17832723-45AF-7E5A-DBDB-B87187A8520E}"/>
          </ac:spMkLst>
        </pc:spChg>
        <pc:picChg chg="mod">
          <ac:chgData name="Wallis, Deeann" userId="624450ec-2436-4aff-8993-592194acd881" providerId="ADAL" clId="{2E8B541E-162D-4ACF-9DDE-9003719A5286}" dt="2024-05-23T19:39:44.492" v="393" actId="1076"/>
          <ac:picMkLst>
            <pc:docMk/>
            <pc:sldMk cId="1228655777" sldId="287"/>
            <ac:picMk id="2" creationId="{09B959CA-4795-EE0B-1D6D-EEBD54555072}"/>
          </ac:picMkLst>
        </pc:picChg>
        <pc:picChg chg="mod">
          <ac:chgData name="Wallis, Deeann" userId="624450ec-2436-4aff-8993-592194acd881" providerId="ADAL" clId="{2E8B541E-162D-4ACF-9DDE-9003719A5286}" dt="2024-05-23T19:39:44.492" v="393" actId="1076"/>
          <ac:picMkLst>
            <pc:docMk/>
            <pc:sldMk cId="1228655777" sldId="287"/>
            <ac:picMk id="3" creationId="{3D62B572-7438-0A93-0B28-1499319699B3}"/>
          </ac:picMkLst>
        </pc:picChg>
        <pc:picChg chg="mod">
          <ac:chgData name="Wallis, Deeann" userId="624450ec-2436-4aff-8993-592194acd881" providerId="ADAL" clId="{2E8B541E-162D-4ACF-9DDE-9003719A5286}" dt="2024-05-23T19:39:50.653" v="394" actId="1076"/>
          <ac:picMkLst>
            <pc:docMk/>
            <pc:sldMk cId="1228655777" sldId="287"/>
            <ac:picMk id="7" creationId="{59AB397A-28B7-C346-154C-5B74F97E6AA6}"/>
          </ac:picMkLst>
        </pc:picChg>
        <pc:picChg chg="mod">
          <ac:chgData name="Wallis, Deeann" userId="624450ec-2436-4aff-8993-592194acd881" providerId="ADAL" clId="{2E8B541E-162D-4ACF-9DDE-9003719A5286}" dt="2024-05-23T19:39:44.492" v="393" actId="1076"/>
          <ac:picMkLst>
            <pc:docMk/>
            <pc:sldMk cId="1228655777" sldId="287"/>
            <ac:picMk id="21" creationId="{CB39AEA8-4779-B1EC-670D-4874FBD00E91}"/>
          </ac:picMkLst>
        </pc:picChg>
        <pc:picChg chg="mod">
          <ac:chgData name="Wallis, Deeann" userId="624450ec-2436-4aff-8993-592194acd881" providerId="ADAL" clId="{2E8B541E-162D-4ACF-9DDE-9003719A5286}" dt="2024-05-23T19:39:44.492" v="393" actId="1076"/>
          <ac:picMkLst>
            <pc:docMk/>
            <pc:sldMk cId="1228655777" sldId="287"/>
            <ac:picMk id="23" creationId="{48E8F549-56FA-6725-6C96-62A9105ABC6A}"/>
          </ac:picMkLst>
        </pc:picChg>
      </pc:sldChg>
      <pc:sldChg chg="addSp delSp modSp new mod">
        <pc:chgData name="Wallis, Deeann" userId="624450ec-2436-4aff-8993-592194acd881" providerId="ADAL" clId="{2E8B541E-162D-4ACF-9DDE-9003719A5286}" dt="2024-05-30T20:00:00.361" v="711" actId="14100"/>
        <pc:sldMkLst>
          <pc:docMk/>
          <pc:sldMk cId="390193927" sldId="288"/>
        </pc:sldMkLst>
        <pc:spChg chg="del">
          <ac:chgData name="Wallis, Deeann" userId="624450ec-2436-4aff-8993-592194acd881" providerId="ADAL" clId="{2E8B541E-162D-4ACF-9DDE-9003719A5286}" dt="2024-05-30T18:54:41.912" v="622" actId="478"/>
          <ac:spMkLst>
            <pc:docMk/>
            <pc:sldMk cId="390193927" sldId="288"/>
            <ac:spMk id="2" creationId="{46C1FBB9-8EED-0274-F865-5EF9858815D3}"/>
          </ac:spMkLst>
        </pc:spChg>
        <pc:spChg chg="del">
          <ac:chgData name="Wallis, Deeann" userId="624450ec-2436-4aff-8993-592194acd881" providerId="ADAL" clId="{2E8B541E-162D-4ACF-9DDE-9003719A5286}" dt="2024-05-30T18:54:44.676" v="623" actId="478"/>
          <ac:spMkLst>
            <pc:docMk/>
            <pc:sldMk cId="390193927" sldId="288"/>
            <ac:spMk id="3" creationId="{FED1E628-783E-ED30-487D-1DAADD0CEBD5}"/>
          </ac:spMkLst>
        </pc:spChg>
        <pc:spChg chg="add mod">
          <ac:chgData name="Wallis, Deeann" userId="624450ec-2436-4aff-8993-592194acd881" providerId="ADAL" clId="{2E8B541E-162D-4ACF-9DDE-9003719A5286}" dt="2024-05-30T19:59:28.419" v="706" actId="1076"/>
          <ac:spMkLst>
            <pc:docMk/>
            <pc:sldMk cId="390193927" sldId="288"/>
            <ac:spMk id="8" creationId="{46135CD6-50F6-1748-3C7D-EF1408E10B06}"/>
          </ac:spMkLst>
        </pc:spChg>
        <pc:spChg chg="add mod">
          <ac:chgData name="Wallis, Deeann" userId="624450ec-2436-4aff-8993-592194acd881" providerId="ADAL" clId="{2E8B541E-162D-4ACF-9DDE-9003719A5286}" dt="2024-05-30T19:59:21.165" v="704" actId="1076"/>
          <ac:spMkLst>
            <pc:docMk/>
            <pc:sldMk cId="390193927" sldId="288"/>
            <ac:spMk id="9" creationId="{509A5B7D-FEA3-F67B-7CA3-33900C29DA88}"/>
          </ac:spMkLst>
        </pc:spChg>
        <pc:spChg chg="add mod">
          <ac:chgData name="Wallis, Deeann" userId="624450ec-2436-4aff-8993-592194acd881" providerId="ADAL" clId="{2E8B541E-162D-4ACF-9DDE-9003719A5286}" dt="2024-05-30T19:59:00.180" v="702" actId="1076"/>
          <ac:spMkLst>
            <pc:docMk/>
            <pc:sldMk cId="390193927" sldId="288"/>
            <ac:spMk id="10" creationId="{303871C3-F862-DE82-470C-BFF14891FE8D}"/>
          </ac:spMkLst>
        </pc:spChg>
        <pc:spChg chg="add mod">
          <ac:chgData name="Wallis, Deeann" userId="624450ec-2436-4aff-8993-592194acd881" providerId="ADAL" clId="{2E8B541E-162D-4ACF-9DDE-9003719A5286}" dt="2024-05-30T19:58:56.218" v="701" actId="1076"/>
          <ac:spMkLst>
            <pc:docMk/>
            <pc:sldMk cId="390193927" sldId="288"/>
            <ac:spMk id="11" creationId="{CC4B8E0E-9BBB-32AB-199C-EBC9ADFE6A8F}"/>
          </ac:spMkLst>
        </pc:spChg>
        <pc:picChg chg="add del">
          <ac:chgData name="Wallis, Deeann" userId="624450ec-2436-4aff-8993-592194acd881" providerId="ADAL" clId="{2E8B541E-162D-4ACF-9DDE-9003719A5286}" dt="2024-05-30T18:56:08.497" v="629" actId="478"/>
          <ac:picMkLst>
            <pc:docMk/>
            <pc:sldMk cId="390193927" sldId="288"/>
            <ac:picMk id="4" creationId="{3E2F7C90-4144-DB13-2959-E8CD759925E9}"/>
          </ac:picMkLst>
        </pc:picChg>
        <pc:picChg chg="add del">
          <ac:chgData name="Wallis, Deeann" userId="624450ec-2436-4aff-8993-592194acd881" providerId="ADAL" clId="{2E8B541E-162D-4ACF-9DDE-9003719A5286}" dt="2024-05-30T18:57:03.538" v="635" actId="478"/>
          <ac:picMkLst>
            <pc:docMk/>
            <pc:sldMk cId="390193927" sldId="288"/>
            <ac:picMk id="5" creationId="{35BF2112-4BF1-DC5D-8B4E-3163D8E52FD8}"/>
          </ac:picMkLst>
        </pc:picChg>
        <pc:picChg chg="add mod">
          <ac:chgData name="Wallis, Deeann" userId="624450ec-2436-4aff-8993-592194acd881" providerId="ADAL" clId="{2E8B541E-162D-4ACF-9DDE-9003719A5286}" dt="2024-05-30T19:59:50.622" v="709" actId="14100"/>
          <ac:picMkLst>
            <pc:docMk/>
            <pc:sldMk cId="390193927" sldId="288"/>
            <ac:picMk id="7" creationId="{0C419375-0AEA-CD9E-18D4-7B97D28B7C29}"/>
          </ac:picMkLst>
        </pc:picChg>
        <pc:picChg chg="add mod">
          <ac:chgData name="Wallis, Deeann" userId="624450ec-2436-4aff-8993-592194acd881" providerId="ADAL" clId="{2E8B541E-162D-4ACF-9DDE-9003719A5286}" dt="2024-05-30T20:00:00.361" v="711" actId="14100"/>
          <ac:picMkLst>
            <pc:docMk/>
            <pc:sldMk cId="390193927" sldId="288"/>
            <ac:picMk id="13" creationId="{A4DEBE30-019A-021B-98CD-48B4B7DEAF4F}"/>
          </ac:picMkLst>
        </pc:picChg>
        <pc:picChg chg="add mod">
          <ac:chgData name="Wallis, Deeann" userId="624450ec-2436-4aff-8993-592194acd881" providerId="ADAL" clId="{2E8B541E-162D-4ACF-9DDE-9003719A5286}" dt="2024-05-30T19:59:39.327" v="707" actId="1076"/>
          <ac:picMkLst>
            <pc:docMk/>
            <pc:sldMk cId="390193927" sldId="288"/>
            <ac:picMk id="15" creationId="{5D2CFD5E-CE1C-73D8-EC09-DBCBFDFA1D36}"/>
          </ac:picMkLst>
        </pc:picChg>
        <pc:picChg chg="add mod">
          <ac:chgData name="Wallis, Deeann" userId="624450ec-2436-4aff-8993-592194acd881" providerId="ADAL" clId="{2E8B541E-162D-4ACF-9DDE-9003719A5286}" dt="2024-05-30T19:58:42.988" v="700" actId="1076"/>
          <ac:picMkLst>
            <pc:docMk/>
            <pc:sldMk cId="390193927" sldId="288"/>
            <ac:picMk id="17" creationId="{20A035A1-E9CA-7558-807A-3AC5E5A13D42}"/>
          </ac:picMkLst>
        </pc:picChg>
      </pc:sldChg>
      <pc:sldChg chg="addSp delSp modSp new mod">
        <pc:chgData name="Wallis, Deeann" userId="624450ec-2436-4aff-8993-592194acd881" providerId="ADAL" clId="{2E8B541E-162D-4ACF-9DDE-9003719A5286}" dt="2024-05-30T20:32:49.744" v="731" actId="1076"/>
        <pc:sldMkLst>
          <pc:docMk/>
          <pc:sldMk cId="1009493001" sldId="289"/>
        </pc:sldMkLst>
        <pc:spChg chg="del">
          <ac:chgData name="Wallis, Deeann" userId="624450ec-2436-4aff-8993-592194acd881" providerId="ADAL" clId="{2E8B541E-162D-4ACF-9DDE-9003719A5286}" dt="2024-05-30T20:31:14.539" v="713"/>
          <ac:spMkLst>
            <pc:docMk/>
            <pc:sldMk cId="1009493001" sldId="289"/>
            <ac:spMk id="3" creationId="{544D7D84-3493-B75B-5E98-49C52A6EF98B}"/>
          </ac:spMkLst>
        </pc:spChg>
        <pc:spChg chg="add mod">
          <ac:chgData name="Wallis, Deeann" userId="624450ec-2436-4aff-8993-592194acd881" providerId="ADAL" clId="{2E8B541E-162D-4ACF-9DDE-9003719A5286}" dt="2024-05-30T20:31:16.383" v="714" actId="478"/>
          <ac:spMkLst>
            <pc:docMk/>
            <pc:sldMk cId="1009493001" sldId="289"/>
            <ac:spMk id="7" creationId="{5C099A3E-C1BB-1026-8298-5EF9E975E77E}"/>
          </ac:spMkLst>
        </pc:spChg>
        <pc:picChg chg="add del mod">
          <ac:chgData name="Wallis, Deeann" userId="624450ec-2436-4aff-8993-592194acd881" providerId="ADAL" clId="{2E8B541E-162D-4ACF-9DDE-9003719A5286}" dt="2024-05-30T20:31:16.383" v="714" actId="478"/>
          <ac:picMkLst>
            <pc:docMk/>
            <pc:sldMk cId="1009493001" sldId="289"/>
            <ac:picMk id="5" creationId="{5E4629F1-8FF1-58E3-5833-60077C5DE418}"/>
          </ac:picMkLst>
        </pc:picChg>
        <pc:picChg chg="add mod">
          <ac:chgData name="Wallis, Deeann" userId="624450ec-2436-4aff-8993-592194acd881" providerId="ADAL" clId="{2E8B541E-162D-4ACF-9DDE-9003719A5286}" dt="2024-05-30T20:32:49.744" v="731" actId="1076"/>
          <ac:picMkLst>
            <pc:docMk/>
            <pc:sldMk cId="1009493001" sldId="289"/>
            <ac:picMk id="1026" creationId="{FAECDFA1-A42A-7C9E-3E84-7A6320D64AD2}"/>
          </ac:picMkLst>
        </pc:picChg>
        <pc:picChg chg="add mod">
          <ac:chgData name="Wallis, Deeann" userId="624450ec-2436-4aff-8993-592194acd881" providerId="ADAL" clId="{2E8B541E-162D-4ACF-9DDE-9003719A5286}" dt="2024-05-30T20:32:44.022" v="729" actId="14100"/>
          <ac:picMkLst>
            <pc:docMk/>
            <pc:sldMk cId="1009493001" sldId="289"/>
            <ac:picMk id="1027" creationId="{CE7B45A4-11CB-2ACD-7F40-E905583E0582}"/>
          </ac:picMkLst>
        </pc:picChg>
      </pc:sldChg>
      <pc:sldMasterChg chg="del delSldLayout">
        <pc:chgData name="Wallis, Deeann" userId="624450ec-2436-4aff-8993-592194acd881" providerId="ADAL" clId="{2E8B541E-162D-4ACF-9DDE-9003719A5286}" dt="2024-05-30T18:56:21.281" v="633" actId="47"/>
        <pc:sldMasterMkLst>
          <pc:docMk/>
          <pc:sldMasterMk cId="1074965888" sldId="2147483663"/>
        </pc:sldMasterMkLst>
        <pc:sldLayoutChg chg="del">
          <pc:chgData name="Wallis, Deeann" userId="624450ec-2436-4aff-8993-592194acd881" providerId="ADAL" clId="{2E8B541E-162D-4ACF-9DDE-9003719A5286}" dt="2024-05-30T18:56:21.281" v="633" actId="47"/>
          <pc:sldLayoutMkLst>
            <pc:docMk/>
            <pc:sldMasterMk cId="1074965888" sldId="2147483663"/>
            <pc:sldLayoutMk cId="614253696" sldId="2147483664"/>
          </pc:sldLayoutMkLst>
        </pc:sldLayoutChg>
        <pc:sldLayoutChg chg="del">
          <pc:chgData name="Wallis, Deeann" userId="624450ec-2436-4aff-8993-592194acd881" providerId="ADAL" clId="{2E8B541E-162D-4ACF-9DDE-9003719A5286}" dt="2024-05-30T18:56:21.281" v="633" actId="47"/>
          <pc:sldLayoutMkLst>
            <pc:docMk/>
            <pc:sldMasterMk cId="1074965888" sldId="2147483663"/>
            <pc:sldLayoutMk cId="3993413317" sldId="2147483665"/>
          </pc:sldLayoutMkLst>
        </pc:sldLayoutChg>
        <pc:sldLayoutChg chg="del">
          <pc:chgData name="Wallis, Deeann" userId="624450ec-2436-4aff-8993-592194acd881" providerId="ADAL" clId="{2E8B541E-162D-4ACF-9DDE-9003719A5286}" dt="2024-05-30T18:56:21.281" v="633" actId="47"/>
          <pc:sldLayoutMkLst>
            <pc:docMk/>
            <pc:sldMasterMk cId="1074965888" sldId="2147483663"/>
            <pc:sldLayoutMk cId="1976051627" sldId="2147483666"/>
          </pc:sldLayoutMkLst>
        </pc:sldLayoutChg>
        <pc:sldLayoutChg chg="del">
          <pc:chgData name="Wallis, Deeann" userId="624450ec-2436-4aff-8993-592194acd881" providerId="ADAL" clId="{2E8B541E-162D-4ACF-9DDE-9003719A5286}" dt="2024-05-30T18:56:21.281" v="633" actId="47"/>
          <pc:sldLayoutMkLst>
            <pc:docMk/>
            <pc:sldMasterMk cId="1074965888" sldId="2147483663"/>
            <pc:sldLayoutMk cId="339457779" sldId="2147483667"/>
          </pc:sldLayoutMkLst>
        </pc:sldLayoutChg>
        <pc:sldLayoutChg chg="del">
          <pc:chgData name="Wallis, Deeann" userId="624450ec-2436-4aff-8993-592194acd881" providerId="ADAL" clId="{2E8B541E-162D-4ACF-9DDE-9003719A5286}" dt="2024-05-30T18:56:21.281" v="633" actId="47"/>
          <pc:sldLayoutMkLst>
            <pc:docMk/>
            <pc:sldMasterMk cId="1074965888" sldId="2147483663"/>
            <pc:sldLayoutMk cId="1560819783" sldId="2147483668"/>
          </pc:sldLayoutMkLst>
        </pc:sldLayoutChg>
      </pc:sldMasterChg>
    </pc:docChg>
  </pc:docChgLst>
  <pc:docChgLst>
    <pc:chgData name="Wallis, Deeann" userId="624450ec-2436-4aff-8993-592194acd881" providerId="ADAL" clId="{47FFFDBD-6FF9-48EB-A3AC-23C62812EA00}"/>
    <pc:docChg chg="undo custSel addSld delSld modSld">
      <pc:chgData name="Wallis, Deeann" userId="624450ec-2436-4aff-8993-592194acd881" providerId="ADAL" clId="{47FFFDBD-6FF9-48EB-A3AC-23C62812EA00}" dt="2024-06-02T21:04:11.114" v="633" actId="20577"/>
      <pc:docMkLst>
        <pc:docMk/>
      </pc:docMkLst>
      <pc:sldChg chg="addSp delSp modSp mod">
        <pc:chgData name="Wallis, Deeann" userId="624450ec-2436-4aff-8993-592194acd881" providerId="ADAL" clId="{47FFFDBD-6FF9-48EB-A3AC-23C62812EA00}" dt="2024-05-22T21:14:39.794" v="34" actId="1076"/>
        <pc:sldMkLst>
          <pc:docMk/>
          <pc:sldMk cId="717591146" sldId="257"/>
        </pc:sldMkLst>
        <pc:spChg chg="add mod">
          <ac:chgData name="Wallis, Deeann" userId="624450ec-2436-4aff-8993-592194acd881" providerId="ADAL" clId="{47FFFDBD-6FF9-48EB-A3AC-23C62812EA00}" dt="2024-05-22T21:13:04.137" v="16" actId="1076"/>
          <ac:spMkLst>
            <pc:docMk/>
            <pc:sldMk cId="717591146" sldId="257"/>
            <ac:spMk id="3" creationId="{A5C24C34-7B2E-7434-05EC-FBE4DD969551}"/>
          </ac:spMkLst>
        </pc:spChg>
        <pc:spChg chg="add mod">
          <ac:chgData name="Wallis, Deeann" userId="624450ec-2436-4aff-8993-592194acd881" providerId="ADAL" clId="{47FFFDBD-6FF9-48EB-A3AC-23C62812EA00}" dt="2024-05-22T21:13:04.137" v="16" actId="1076"/>
          <ac:spMkLst>
            <pc:docMk/>
            <pc:sldMk cId="717591146" sldId="257"/>
            <ac:spMk id="4" creationId="{5A3B643C-454D-C94D-1D3A-4A69013F6A18}"/>
          </ac:spMkLst>
        </pc:spChg>
        <pc:spChg chg="add mod">
          <ac:chgData name="Wallis, Deeann" userId="624450ec-2436-4aff-8993-592194acd881" providerId="ADAL" clId="{47FFFDBD-6FF9-48EB-A3AC-23C62812EA00}" dt="2024-05-22T21:13:04.137" v="16" actId="1076"/>
          <ac:spMkLst>
            <pc:docMk/>
            <pc:sldMk cId="717591146" sldId="257"/>
            <ac:spMk id="5" creationId="{2A7C18F9-99EE-BB42-DD5B-8441460F3BFC}"/>
          </ac:spMkLst>
        </pc:spChg>
        <pc:spChg chg="add mod">
          <ac:chgData name="Wallis, Deeann" userId="624450ec-2436-4aff-8993-592194acd881" providerId="ADAL" clId="{47FFFDBD-6FF9-48EB-A3AC-23C62812EA00}" dt="2024-05-22T21:13:04.137" v="16" actId="1076"/>
          <ac:spMkLst>
            <pc:docMk/>
            <pc:sldMk cId="717591146" sldId="257"/>
            <ac:spMk id="6" creationId="{0AF2E6CB-0C08-8E58-63A2-078EDB63A3CA}"/>
          </ac:spMkLst>
        </pc:spChg>
        <pc:spChg chg="add mod">
          <ac:chgData name="Wallis, Deeann" userId="624450ec-2436-4aff-8993-592194acd881" providerId="ADAL" clId="{47FFFDBD-6FF9-48EB-A3AC-23C62812EA00}" dt="2024-05-22T21:13:04.137" v="16" actId="1076"/>
          <ac:spMkLst>
            <pc:docMk/>
            <pc:sldMk cId="717591146" sldId="257"/>
            <ac:spMk id="8" creationId="{168F7FAA-D5E7-F830-CF39-79D9BCA5442A}"/>
          </ac:spMkLst>
        </pc:spChg>
        <pc:spChg chg="add mod">
          <ac:chgData name="Wallis, Deeann" userId="624450ec-2436-4aff-8993-592194acd881" providerId="ADAL" clId="{47FFFDBD-6FF9-48EB-A3AC-23C62812EA00}" dt="2024-05-22T21:13:04.137" v="16" actId="1076"/>
          <ac:spMkLst>
            <pc:docMk/>
            <pc:sldMk cId="717591146" sldId="257"/>
            <ac:spMk id="9" creationId="{FE7180DB-8105-F1D8-04E9-DD289A3E8930}"/>
          </ac:spMkLst>
        </pc:spChg>
        <pc:spChg chg="add mod">
          <ac:chgData name="Wallis, Deeann" userId="624450ec-2436-4aff-8993-592194acd881" providerId="ADAL" clId="{47FFFDBD-6FF9-48EB-A3AC-23C62812EA00}" dt="2024-05-22T21:13:04.137" v="16" actId="1076"/>
          <ac:spMkLst>
            <pc:docMk/>
            <pc:sldMk cId="717591146" sldId="257"/>
            <ac:spMk id="10" creationId="{7C766B51-37D5-ACD0-1A2C-EE6DB0239F3C}"/>
          </ac:spMkLst>
        </pc:spChg>
        <pc:spChg chg="add mod">
          <ac:chgData name="Wallis, Deeann" userId="624450ec-2436-4aff-8993-592194acd881" providerId="ADAL" clId="{47FFFDBD-6FF9-48EB-A3AC-23C62812EA00}" dt="2024-05-22T21:13:04.137" v="16" actId="1076"/>
          <ac:spMkLst>
            <pc:docMk/>
            <pc:sldMk cId="717591146" sldId="257"/>
            <ac:spMk id="11" creationId="{6CB0B8A3-2C23-1E1A-8586-4DCACEE9E1B8}"/>
          </ac:spMkLst>
        </pc:spChg>
        <pc:spChg chg="mod">
          <ac:chgData name="Wallis, Deeann" userId="624450ec-2436-4aff-8993-592194acd881" providerId="ADAL" clId="{47FFFDBD-6FF9-48EB-A3AC-23C62812EA00}" dt="2024-05-22T21:12:37.574" v="14" actId="1076"/>
          <ac:spMkLst>
            <pc:docMk/>
            <pc:sldMk cId="717591146" sldId="257"/>
            <ac:spMk id="13" creationId="{AFC909DA-913C-B6F0-3089-22771BA0FD4E}"/>
          </ac:spMkLst>
        </pc:spChg>
        <pc:spChg chg="mod">
          <ac:chgData name="Wallis, Deeann" userId="624450ec-2436-4aff-8993-592194acd881" providerId="ADAL" clId="{47FFFDBD-6FF9-48EB-A3AC-23C62812EA00}" dt="2024-05-22T21:12:21.602" v="12" actId="1076"/>
          <ac:spMkLst>
            <pc:docMk/>
            <pc:sldMk cId="717591146" sldId="257"/>
            <ac:spMk id="18" creationId="{748B9BE9-004F-4983-9596-7687D11E86DC}"/>
          </ac:spMkLst>
        </pc:spChg>
        <pc:spChg chg="mod">
          <ac:chgData name="Wallis, Deeann" userId="624450ec-2436-4aff-8993-592194acd881" providerId="ADAL" clId="{47FFFDBD-6FF9-48EB-A3AC-23C62812EA00}" dt="2024-05-22T21:12:31.544" v="13" actId="1076"/>
          <ac:spMkLst>
            <pc:docMk/>
            <pc:sldMk cId="717591146" sldId="257"/>
            <ac:spMk id="28" creationId="{AFC909DA-913C-B6F0-3089-22771BA0FD4E}"/>
          </ac:spMkLst>
        </pc:spChg>
        <pc:graphicFrameChg chg="mod">
          <ac:chgData name="Wallis, Deeann" userId="624450ec-2436-4aff-8993-592194acd881" providerId="ADAL" clId="{47FFFDBD-6FF9-48EB-A3AC-23C62812EA00}" dt="2024-05-22T21:14:14.319" v="31" actId="1076"/>
          <ac:graphicFrameMkLst>
            <pc:docMk/>
            <pc:sldMk cId="717591146" sldId="257"/>
            <ac:graphicFrameMk id="27" creationId="{56A91304-F17F-2C46-3ED2-DF05F4B3E8BD}"/>
          </ac:graphicFrameMkLst>
        </pc:graphicFrameChg>
        <pc:graphicFrameChg chg="mod">
          <ac:chgData name="Wallis, Deeann" userId="624450ec-2436-4aff-8993-592194acd881" providerId="ADAL" clId="{47FFFDBD-6FF9-48EB-A3AC-23C62812EA00}" dt="2024-05-22T21:14:39.794" v="34" actId="1076"/>
          <ac:graphicFrameMkLst>
            <pc:docMk/>
            <pc:sldMk cId="717591146" sldId="257"/>
            <ac:graphicFrameMk id="40" creationId="{660597E4-62E4-3A4C-9676-DC2F5E5EE0CC}"/>
          </ac:graphicFrameMkLst>
        </pc:graphicFrameChg>
        <pc:picChg chg="add mod">
          <ac:chgData name="Wallis, Deeann" userId="624450ec-2436-4aff-8993-592194acd881" providerId="ADAL" clId="{47FFFDBD-6FF9-48EB-A3AC-23C62812EA00}" dt="2024-05-22T21:13:04.137" v="16" actId="1076"/>
          <ac:picMkLst>
            <pc:docMk/>
            <pc:sldMk cId="717591146" sldId="257"/>
            <ac:picMk id="2" creationId="{B76A0D4F-7AEF-6FA6-4A6C-8D8A3D5A0B3D}"/>
          </ac:picMkLst>
        </pc:picChg>
        <pc:picChg chg="del mod">
          <ac:chgData name="Wallis, Deeann" userId="624450ec-2436-4aff-8993-592194acd881" providerId="ADAL" clId="{47FFFDBD-6FF9-48EB-A3AC-23C62812EA00}" dt="2024-05-22T21:13:14.460" v="17" actId="21"/>
          <ac:picMkLst>
            <pc:docMk/>
            <pc:sldMk cId="717591146" sldId="257"/>
            <ac:picMk id="7" creationId="{09B959CA-4795-EE0B-1D6D-EEBD54555072}"/>
          </ac:picMkLst>
        </pc:picChg>
        <pc:picChg chg="mod">
          <ac:chgData name="Wallis, Deeann" userId="624450ec-2436-4aff-8993-592194acd881" providerId="ADAL" clId="{47FFFDBD-6FF9-48EB-A3AC-23C62812EA00}" dt="2024-05-22T21:14:26.800" v="32" actId="1076"/>
          <ac:picMkLst>
            <pc:docMk/>
            <pc:sldMk cId="717591146" sldId="257"/>
            <ac:picMk id="32" creationId="{F33831D3-4259-49F8-8DD5-9C1894B66A4B}"/>
          </ac:picMkLst>
        </pc:picChg>
        <pc:picChg chg="mod">
          <ac:chgData name="Wallis, Deeann" userId="624450ec-2436-4aff-8993-592194acd881" providerId="ADAL" clId="{47FFFDBD-6FF9-48EB-A3AC-23C62812EA00}" dt="2024-05-22T21:14:30.568" v="33" actId="1076"/>
          <ac:picMkLst>
            <pc:docMk/>
            <pc:sldMk cId="717591146" sldId="257"/>
            <ac:picMk id="33" creationId="{4FBBFBBC-8D3C-DA6E-4906-CB924797FC95}"/>
          </ac:picMkLst>
        </pc:picChg>
      </pc:sldChg>
      <pc:sldChg chg="addSp modSp mod">
        <pc:chgData name="Wallis, Deeann" userId="624450ec-2436-4aff-8993-592194acd881" providerId="ADAL" clId="{47FFFDBD-6FF9-48EB-A3AC-23C62812EA00}" dt="2024-05-22T21:43:01.687" v="85" actId="27636"/>
        <pc:sldMkLst>
          <pc:docMk/>
          <pc:sldMk cId="112906126" sldId="262"/>
        </pc:sldMkLst>
        <pc:spChg chg="add mod">
          <ac:chgData name="Wallis, Deeann" userId="624450ec-2436-4aff-8993-592194acd881" providerId="ADAL" clId="{47FFFDBD-6FF9-48EB-A3AC-23C62812EA00}" dt="2024-05-22T21:43:01.687" v="85" actId="27636"/>
          <ac:spMkLst>
            <pc:docMk/>
            <pc:sldMk cId="112906126" sldId="262"/>
            <ac:spMk id="2" creationId="{86E58497-8D50-C4EA-BAEE-5890E84E5BFF}"/>
          </ac:spMkLst>
        </pc:spChg>
      </pc:sldChg>
      <pc:sldChg chg="addSp delSp modSp mod">
        <pc:chgData name="Wallis, Deeann" userId="624450ec-2436-4aff-8993-592194acd881" providerId="ADAL" clId="{47FFFDBD-6FF9-48EB-A3AC-23C62812EA00}" dt="2024-06-02T19:38:40.904" v="630" actId="1076"/>
        <pc:sldMkLst>
          <pc:docMk/>
          <pc:sldMk cId="1271470338" sldId="271"/>
        </pc:sldMkLst>
        <pc:spChg chg="del mod">
          <ac:chgData name="Wallis, Deeann" userId="624450ec-2436-4aff-8993-592194acd881" providerId="ADAL" clId="{47FFFDBD-6FF9-48EB-A3AC-23C62812EA00}" dt="2024-06-02T19:26:43.392" v="494" actId="478"/>
          <ac:spMkLst>
            <pc:docMk/>
            <pc:sldMk cId="1271470338" sldId="271"/>
            <ac:spMk id="2" creationId="{4D63761D-17E9-013A-0A7D-E35E3635E658}"/>
          </ac:spMkLst>
        </pc:spChg>
        <pc:spChg chg="del mod">
          <ac:chgData name="Wallis, Deeann" userId="624450ec-2436-4aff-8993-592194acd881" providerId="ADAL" clId="{47FFFDBD-6FF9-48EB-A3AC-23C62812EA00}" dt="2024-06-02T19:27:03.514" v="504" actId="478"/>
          <ac:spMkLst>
            <pc:docMk/>
            <pc:sldMk cId="1271470338" sldId="271"/>
            <ac:spMk id="7" creationId="{01D5F51B-77C0-2151-9140-9B8D945E4403}"/>
          </ac:spMkLst>
        </pc:spChg>
        <pc:spChg chg="del mod">
          <ac:chgData name="Wallis, Deeann" userId="624450ec-2436-4aff-8993-592194acd881" providerId="ADAL" clId="{47FFFDBD-6FF9-48EB-A3AC-23C62812EA00}" dt="2024-06-02T19:27:11.903" v="508" actId="478"/>
          <ac:spMkLst>
            <pc:docMk/>
            <pc:sldMk cId="1271470338" sldId="271"/>
            <ac:spMk id="11" creationId="{A4AA4549-7EC3-A538-451B-221C16E55BCA}"/>
          </ac:spMkLst>
        </pc:spChg>
        <pc:spChg chg="del mod">
          <ac:chgData name="Wallis, Deeann" userId="624450ec-2436-4aff-8993-592194acd881" providerId="ADAL" clId="{47FFFDBD-6FF9-48EB-A3AC-23C62812EA00}" dt="2024-06-02T19:27:17.023" v="511" actId="478"/>
          <ac:spMkLst>
            <pc:docMk/>
            <pc:sldMk cId="1271470338" sldId="271"/>
            <ac:spMk id="13" creationId="{F3512530-21E4-9FE6-1F9E-2F3FA4D25B48}"/>
          </ac:spMkLst>
        </pc:spChg>
        <pc:spChg chg="del mod">
          <ac:chgData name="Wallis, Deeann" userId="624450ec-2436-4aff-8993-592194acd881" providerId="ADAL" clId="{47FFFDBD-6FF9-48EB-A3AC-23C62812EA00}" dt="2024-06-02T19:27:05.432" v="505" actId="478"/>
          <ac:spMkLst>
            <pc:docMk/>
            <pc:sldMk cId="1271470338" sldId="271"/>
            <ac:spMk id="14" creationId="{31A8AC20-1B18-FA7F-9603-B12F36178BFC}"/>
          </ac:spMkLst>
        </pc:spChg>
        <pc:spChg chg="del mod">
          <ac:chgData name="Wallis, Deeann" userId="624450ec-2436-4aff-8993-592194acd881" providerId="ADAL" clId="{47FFFDBD-6FF9-48EB-A3AC-23C62812EA00}" dt="2024-06-02T19:27:10.090" v="507" actId="478"/>
          <ac:spMkLst>
            <pc:docMk/>
            <pc:sldMk cId="1271470338" sldId="271"/>
            <ac:spMk id="15" creationId="{00E5EDF2-4C49-D934-1A56-AE1F877E3039}"/>
          </ac:spMkLst>
        </pc:spChg>
        <pc:spChg chg="add del mod">
          <ac:chgData name="Wallis, Deeann" userId="624450ec-2436-4aff-8993-592194acd881" providerId="ADAL" clId="{47FFFDBD-6FF9-48EB-A3AC-23C62812EA00}" dt="2024-06-02T18:58:51.563" v="141"/>
          <ac:spMkLst>
            <pc:docMk/>
            <pc:sldMk cId="1271470338" sldId="271"/>
            <ac:spMk id="17" creationId="{5982F704-B4D3-4311-3399-28D1A8EBD3A1}"/>
          </ac:spMkLst>
        </pc:spChg>
        <pc:spChg chg="mod">
          <ac:chgData name="Wallis, Deeann" userId="624450ec-2436-4aff-8993-592194acd881" providerId="ADAL" clId="{47FFFDBD-6FF9-48EB-A3AC-23C62812EA00}" dt="2024-06-02T19:15:01" v="388" actId="14100"/>
          <ac:spMkLst>
            <pc:docMk/>
            <pc:sldMk cId="1271470338" sldId="271"/>
            <ac:spMk id="23" creationId="{2BF77E85-A99D-9A35-3584-4DA1BFDFAE61}"/>
          </ac:spMkLst>
        </pc:spChg>
        <pc:spChg chg="mod">
          <ac:chgData name="Wallis, Deeann" userId="624450ec-2436-4aff-8993-592194acd881" providerId="ADAL" clId="{47FFFDBD-6FF9-48EB-A3AC-23C62812EA00}" dt="2024-06-02T19:15:05.102" v="389" actId="14100"/>
          <ac:spMkLst>
            <pc:docMk/>
            <pc:sldMk cId="1271470338" sldId="271"/>
            <ac:spMk id="24" creationId="{A801B262-8835-F0FF-4FAC-5DD10FB2A593}"/>
          </ac:spMkLst>
        </pc:spChg>
        <pc:spChg chg="add mod">
          <ac:chgData name="Wallis, Deeann" userId="624450ec-2436-4aff-8993-592194acd881" providerId="ADAL" clId="{47FFFDBD-6FF9-48EB-A3AC-23C62812EA00}" dt="2024-06-02T19:28:28.287" v="514" actId="1076"/>
          <ac:spMkLst>
            <pc:docMk/>
            <pc:sldMk cId="1271470338" sldId="271"/>
            <ac:spMk id="30" creationId="{C99285A6-C6A9-665D-75C0-A3432799B8A6}"/>
          </ac:spMkLst>
        </pc:spChg>
        <pc:spChg chg="add mod">
          <ac:chgData name="Wallis, Deeann" userId="624450ec-2436-4aff-8993-592194acd881" providerId="ADAL" clId="{47FFFDBD-6FF9-48EB-A3AC-23C62812EA00}" dt="2024-06-02T19:14:09.015" v="386" actId="1038"/>
          <ac:spMkLst>
            <pc:docMk/>
            <pc:sldMk cId="1271470338" sldId="271"/>
            <ac:spMk id="31" creationId="{1BBC9B83-611C-EE28-B0F3-E067C3BE00AF}"/>
          </ac:spMkLst>
        </pc:spChg>
        <pc:spChg chg="add mod">
          <ac:chgData name="Wallis, Deeann" userId="624450ec-2436-4aff-8993-592194acd881" providerId="ADAL" clId="{47FFFDBD-6FF9-48EB-A3AC-23C62812EA00}" dt="2024-06-02T18:57:19.604" v="119" actId="1036"/>
          <ac:spMkLst>
            <pc:docMk/>
            <pc:sldMk cId="1271470338" sldId="271"/>
            <ac:spMk id="32" creationId="{9981F7D0-D5E7-EF77-759A-957338948C52}"/>
          </ac:spMkLst>
        </pc:spChg>
        <pc:spChg chg="add mod">
          <ac:chgData name="Wallis, Deeann" userId="624450ec-2436-4aff-8993-592194acd881" providerId="ADAL" clId="{47FFFDBD-6FF9-48EB-A3AC-23C62812EA00}" dt="2024-06-02T18:57:31.697" v="121" actId="1076"/>
          <ac:spMkLst>
            <pc:docMk/>
            <pc:sldMk cId="1271470338" sldId="271"/>
            <ac:spMk id="33" creationId="{6CACC8D8-8E72-D571-E169-BF07601CBF79}"/>
          </ac:spMkLst>
        </pc:spChg>
        <pc:spChg chg="add mod">
          <ac:chgData name="Wallis, Deeann" userId="624450ec-2436-4aff-8993-592194acd881" providerId="ADAL" clId="{47FFFDBD-6FF9-48EB-A3AC-23C62812EA00}" dt="2024-06-02T19:13:55.660" v="382" actId="1037"/>
          <ac:spMkLst>
            <pc:docMk/>
            <pc:sldMk cId="1271470338" sldId="271"/>
            <ac:spMk id="34" creationId="{528E8DF1-99E7-7A48-7DFE-DE67DBEA640D}"/>
          </ac:spMkLst>
        </pc:spChg>
        <pc:spChg chg="add mod">
          <ac:chgData name="Wallis, Deeann" userId="624450ec-2436-4aff-8993-592194acd881" providerId="ADAL" clId="{47FFFDBD-6FF9-48EB-A3AC-23C62812EA00}" dt="2024-06-02T19:04:13.641" v="232" actId="1076"/>
          <ac:spMkLst>
            <pc:docMk/>
            <pc:sldMk cId="1271470338" sldId="271"/>
            <ac:spMk id="35" creationId="{A1CC913B-CA57-8A8A-EF45-4DDE978F4D07}"/>
          </ac:spMkLst>
        </pc:spChg>
        <pc:spChg chg="add mod">
          <ac:chgData name="Wallis, Deeann" userId="624450ec-2436-4aff-8993-592194acd881" providerId="ADAL" clId="{47FFFDBD-6FF9-48EB-A3AC-23C62812EA00}" dt="2024-06-02T19:13:35.212" v="377" actId="1037"/>
          <ac:spMkLst>
            <pc:docMk/>
            <pc:sldMk cId="1271470338" sldId="271"/>
            <ac:spMk id="36" creationId="{EA249120-25B2-4E73-DF94-752F94FE123D}"/>
          </ac:spMkLst>
        </pc:spChg>
        <pc:spChg chg="add mod">
          <ac:chgData name="Wallis, Deeann" userId="624450ec-2436-4aff-8993-592194acd881" providerId="ADAL" clId="{47FFFDBD-6FF9-48EB-A3AC-23C62812EA00}" dt="2024-06-02T19:13:32.599" v="375" actId="1037"/>
          <ac:spMkLst>
            <pc:docMk/>
            <pc:sldMk cId="1271470338" sldId="271"/>
            <ac:spMk id="37" creationId="{D41A5E11-C42B-B602-967E-E45A33851BC6}"/>
          </ac:spMkLst>
        </pc:spChg>
        <pc:spChg chg="add mod">
          <ac:chgData name="Wallis, Deeann" userId="624450ec-2436-4aff-8993-592194acd881" providerId="ADAL" clId="{47FFFDBD-6FF9-48EB-A3AC-23C62812EA00}" dt="2024-06-02T19:13:50.253" v="380" actId="1076"/>
          <ac:spMkLst>
            <pc:docMk/>
            <pc:sldMk cId="1271470338" sldId="271"/>
            <ac:spMk id="38" creationId="{54596C50-4367-711E-6A65-9887F7B39F47}"/>
          </ac:spMkLst>
        </pc:spChg>
        <pc:spChg chg="add mod">
          <ac:chgData name="Wallis, Deeann" userId="624450ec-2436-4aff-8993-592194acd881" providerId="ADAL" clId="{47FFFDBD-6FF9-48EB-A3AC-23C62812EA00}" dt="2024-06-02T19:13:44.329" v="379" actId="1076"/>
          <ac:spMkLst>
            <pc:docMk/>
            <pc:sldMk cId="1271470338" sldId="271"/>
            <ac:spMk id="39" creationId="{01F997EE-DC2D-0A99-232E-E2BECE57A83E}"/>
          </ac:spMkLst>
        </pc:spChg>
        <pc:spChg chg="add mod">
          <ac:chgData name="Wallis, Deeann" userId="624450ec-2436-4aff-8993-592194acd881" providerId="ADAL" clId="{47FFFDBD-6FF9-48EB-A3AC-23C62812EA00}" dt="2024-06-02T19:00:38.013" v="169" actId="1076"/>
          <ac:spMkLst>
            <pc:docMk/>
            <pc:sldMk cId="1271470338" sldId="271"/>
            <ac:spMk id="40" creationId="{B53DD425-8CE4-30C7-3A00-6B6485323540}"/>
          </ac:spMkLst>
        </pc:spChg>
        <pc:spChg chg="add mod">
          <ac:chgData name="Wallis, Deeann" userId="624450ec-2436-4aff-8993-592194acd881" providerId="ADAL" clId="{47FFFDBD-6FF9-48EB-A3AC-23C62812EA00}" dt="2024-06-02T19:00:46.530" v="179" actId="1038"/>
          <ac:spMkLst>
            <pc:docMk/>
            <pc:sldMk cId="1271470338" sldId="271"/>
            <ac:spMk id="41" creationId="{ECB6CCDB-7045-F4F2-5D8D-9AA3C5FA691B}"/>
          </ac:spMkLst>
        </pc:spChg>
        <pc:spChg chg="add mod">
          <ac:chgData name="Wallis, Deeann" userId="624450ec-2436-4aff-8993-592194acd881" providerId="ADAL" clId="{47FFFDBD-6FF9-48EB-A3AC-23C62812EA00}" dt="2024-06-02T19:00:41.614" v="175" actId="1038"/>
          <ac:spMkLst>
            <pc:docMk/>
            <pc:sldMk cId="1271470338" sldId="271"/>
            <ac:spMk id="42" creationId="{38CF11A4-81EA-D5A1-1F3A-CEE0D2480669}"/>
          </ac:spMkLst>
        </pc:spChg>
        <pc:spChg chg="add mod">
          <ac:chgData name="Wallis, Deeann" userId="624450ec-2436-4aff-8993-592194acd881" providerId="ADAL" clId="{47FFFDBD-6FF9-48EB-A3AC-23C62812EA00}" dt="2024-06-02T19:26:53.025" v="498" actId="571"/>
          <ac:spMkLst>
            <pc:docMk/>
            <pc:sldMk cId="1271470338" sldId="271"/>
            <ac:spMk id="43" creationId="{1ED8E207-9F27-B241-5BCB-3B84910770B7}"/>
          </ac:spMkLst>
        </pc:spChg>
        <pc:spChg chg="add mod">
          <ac:chgData name="Wallis, Deeann" userId="624450ec-2436-4aff-8993-592194acd881" providerId="ADAL" clId="{47FFFDBD-6FF9-48EB-A3AC-23C62812EA00}" dt="2024-06-02T19:37:32.300" v="621" actId="14100"/>
          <ac:spMkLst>
            <pc:docMk/>
            <pc:sldMk cId="1271470338" sldId="271"/>
            <ac:spMk id="44" creationId="{748EEF65-98FE-D7D7-DB2C-C0C422BD180F}"/>
          </ac:spMkLst>
        </pc:spChg>
        <pc:spChg chg="add mod">
          <ac:chgData name="Wallis, Deeann" userId="624450ec-2436-4aff-8993-592194acd881" providerId="ADAL" clId="{47FFFDBD-6FF9-48EB-A3AC-23C62812EA00}" dt="2024-06-02T19:26:53.025" v="498" actId="571"/>
          <ac:spMkLst>
            <pc:docMk/>
            <pc:sldMk cId="1271470338" sldId="271"/>
            <ac:spMk id="45" creationId="{ACF7FAB9-E4E8-32A8-28C2-0D0BBD9CA2CB}"/>
          </ac:spMkLst>
        </pc:spChg>
        <pc:spChg chg="add mod">
          <ac:chgData name="Wallis, Deeann" userId="624450ec-2436-4aff-8993-592194acd881" providerId="ADAL" clId="{47FFFDBD-6FF9-48EB-A3AC-23C62812EA00}" dt="2024-06-02T19:26:53.025" v="498" actId="571"/>
          <ac:spMkLst>
            <pc:docMk/>
            <pc:sldMk cId="1271470338" sldId="271"/>
            <ac:spMk id="46" creationId="{EFED0A15-D22A-E4AA-CEEF-1A88CC7133F6}"/>
          </ac:spMkLst>
        </pc:spChg>
        <pc:spChg chg="add mod">
          <ac:chgData name="Wallis, Deeann" userId="624450ec-2436-4aff-8993-592194acd881" providerId="ADAL" clId="{47FFFDBD-6FF9-48EB-A3AC-23C62812EA00}" dt="2024-06-02T19:26:53.025" v="498" actId="571"/>
          <ac:spMkLst>
            <pc:docMk/>
            <pc:sldMk cId="1271470338" sldId="271"/>
            <ac:spMk id="47" creationId="{77AB13EC-8C98-A753-D8E6-958326E735AA}"/>
          </ac:spMkLst>
        </pc:spChg>
        <pc:spChg chg="add del mod">
          <ac:chgData name="Wallis, Deeann" userId="624450ec-2436-4aff-8993-592194acd881" providerId="ADAL" clId="{47FFFDBD-6FF9-48EB-A3AC-23C62812EA00}" dt="2024-06-02T19:05:09.843" v="245" actId="478"/>
          <ac:spMkLst>
            <pc:docMk/>
            <pc:sldMk cId="1271470338" sldId="271"/>
            <ac:spMk id="48" creationId="{436F9D03-6BF8-6D8A-C830-C4E53D8834F8}"/>
          </ac:spMkLst>
        </pc:spChg>
        <pc:spChg chg="add mod">
          <ac:chgData name="Wallis, Deeann" userId="624450ec-2436-4aff-8993-592194acd881" providerId="ADAL" clId="{47FFFDBD-6FF9-48EB-A3AC-23C62812EA00}" dt="2024-06-02T19:26:53.025" v="498" actId="571"/>
          <ac:spMkLst>
            <pc:docMk/>
            <pc:sldMk cId="1271470338" sldId="271"/>
            <ac:spMk id="49" creationId="{D838E9B5-73F3-46DF-D48F-CDEDAEB155B0}"/>
          </ac:spMkLst>
        </pc:spChg>
        <pc:spChg chg="add mod">
          <ac:chgData name="Wallis, Deeann" userId="624450ec-2436-4aff-8993-592194acd881" providerId="ADAL" clId="{47FFFDBD-6FF9-48EB-A3AC-23C62812EA00}" dt="2024-06-02T19:26:53.025" v="498" actId="571"/>
          <ac:spMkLst>
            <pc:docMk/>
            <pc:sldMk cId="1271470338" sldId="271"/>
            <ac:spMk id="50" creationId="{ECB6FB93-F04E-B5E7-42F7-9E092F351BE0}"/>
          </ac:spMkLst>
        </pc:spChg>
        <pc:spChg chg="add mod">
          <ac:chgData name="Wallis, Deeann" userId="624450ec-2436-4aff-8993-592194acd881" providerId="ADAL" clId="{47FFFDBD-6FF9-48EB-A3AC-23C62812EA00}" dt="2024-06-02T19:26:53.025" v="498" actId="571"/>
          <ac:spMkLst>
            <pc:docMk/>
            <pc:sldMk cId="1271470338" sldId="271"/>
            <ac:spMk id="51" creationId="{84CA5642-88D7-7962-C3BE-E6A17AC02C00}"/>
          </ac:spMkLst>
        </pc:spChg>
        <pc:spChg chg="add del mod">
          <ac:chgData name="Wallis, Deeann" userId="624450ec-2436-4aff-8993-592194acd881" providerId="ADAL" clId="{47FFFDBD-6FF9-48EB-A3AC-23C62812EA00}" dt="2024-06-02T19:31:16.824" v="549" actId="478"/>
          <ac:spMkLst>
            <pc:docMk/>
            <pc:sldMk cId="1271470338" sldId="271"/>
            <ac:spMk id="52" creationId="{18CDC45E-9EAD-97A7-E088-95B31CF4C227}"/>
          </ac:spMkLst>
        </pc:spChg>
        <pc:spChg chg="mod">
          <ac:chgData name="Wallis, Deeann" userId="624450ec-2436-4aff-8993-592194acd881" providerId="ADAL" clId="{47FFFDBD-6FF9-48EB-A3AC-23C62812EA00}" dt="2024-06-02T19:36:22.500" v="610" actId="1038"/>
          <ac:spMkLst>
            <pc:docMk/>
            <pc:sldMk cId="1271470338" sldId="271"/>
            <ac:spMk id="54" creationId="{61C7F81C-74CB-C4F5-DFDE-262C17433790}"/>
          </ac:spMkLst>
        </pc:spChg>
        <pc:spChg chg="mod">
          <ac:chgData name="Wallis, Deeann" userId="624450ec-2436-4aff-8993-592194acd881" providerId="ADAL" clId="{47FFFDBD-6FF9-48EB-A3AC-23C62812EA00}" dt="2024-06-02T19:35:46.288" v="603" actId="1038"/>
          <ac:spMkLst>
            <pc:docMk/>
            <pc:sldMk cId="1271470338" sldId="271"/>
            <ac:spMk id="55" creationId="{B83785F1-8BF5-2FA9-D808-FF03B268D584}"/>
          </ac:spMkLst>
        </pc:spChg>
        <pc:spChg chg="mod">
          <ac:chgData name="Wallis, Deeann" userId="624450ec-2436-4aff-8993-592194acd881" providerId="ADAL" clId="{47FFFDBD-6FF9-48EB-A3AC-23C62812EA00}" dt="2024-06-02T19:35:38.909" v="600" actId="1038"/>
          <ac:spMkLst>
            <pc:docMk/>
            <pc:sldMk cId="1271470338" sldId="271"/>
            <ac:spMk id="56" creationId="{83B204BF-4D21-4194-4561-FC6D87B8A736}"/>
          </ac:spMkLst>
        </pc:spChg>
        <pc:spChg chg="del mod">
          <ac:chgData name="Wallis, Deeann" userId="624450ec-2436-4aff-8993-592194acd881" providerId="ADAL" clId="{47FFFDBD-6FF9-48EB-A3AC-23C62812EA00}" dt="2024-06-02T19:27:19.604" v="512" actId="478"/>
          <ac:spMkLst>
            <pc:docMk/>
            <pc:sldMk cId="1271470338" sldId="271"/>
            <ac:spMk id="57" creationId="{536A4D0B-1912-AE46-A7C2-1B78332CC15E}"/>
          </ac:spMkLst>
        </pc:spChg>
        <pc:spChg chg="mod">
          <ac:chgData name="Wallis, Deeann" userId="624450ec-2436-4aff-8993-592194acd881" providerId="ADAL" clId="{47FFFDBD-6FF9-48EB-A3AC-23C62812EA00}" dt="2024-06-02T19:35:48.208" v="604" actId="1076"/>
          <ac:spMkLst>
            <pc:docMk/>
            <pc:sldMk cId="1271470338" sldId="271"/>
            <ac:spMk id="60" creationId="{376B5F71-929D-323B-EDBD-A05C0AC775B2}"/>
          </ac:spMkLst>
        </pc:spChg>
        <pc:spChg chg="mod">
          <ac:chgData name="Wallis, Deeann" userId="624450ec-2436-4aff-8993-592194acd881" providerId="ADAL" clId="{47FFFDBD-6FF9-48EB-A3AC-23C62812EA00}" dt="2024-06-02T19:26:53.025" v="498" actId="571"/>
          <ac:spMkLst>
            <pc:docMk/>
            <pc:sldMk cId="1271470338" sldId="271"/>
            <ac:spMk id="61" creationId="{14574B9D-7C40-1108-EB4B-4F6B52A093F4}"/>
          </ac:spMkLst>
        </pc:spChg>
        <pc:spChg chg="mod">
          <ac:chgData name="Wallis, Deeann" userId="624450ec-2436-4aff-8993-592194acd881" providerId="ADAL" clId="{47FFFDBD-6FF9-48EB-A3AC-23C62812EA00}" dt="2024-06-02T19:26:53.025" v="498" actId="571"/>
          <ac:spMkLst>
            <pc:docMk/>
            <pc:sldMk cId="1271470338" sldId="271"/>
            <ac:spMk id="62" creationId="{7FD781C0-1CCA-2D41-FF93-440134DD1D15}"/>
          </ac:spMkLst>
        </pc:spChg>
        <pc:spChg chg="del mod">
          <ac:chgData name="Wallis, Deeann" userId="624450ec-2436-4aff-8993-592194acd881" providerId="ADAL" clId="{47FFFDBD-6FF9-48EB-A3AC-23C62812EA00}" dt="2024-06-02T19:26:55.121" v="499" actId="478"/>
          <ac:spMkLst>
            <pc:docMk/>
            <pc:sldMk cId="1271470338" sldId="271"/>
            <ac:spMk id="63" creationId="{0687E7C0-678A-E514-5E3B-8F527C49D8BC}"/>
          </ac:spMkLst>
        </pc:spChg>
        <pc:spChg chg="add del mod">
          <ac:chgData name="Wallis, Deeann" userId="624450ec-2436-4aff-8993-592194acd881" providerId="ADAL" clId="{47FFFDBD-6FF9-48EB-A3AC-23C62812EA00}" dt="2024-06-02T19:26:03.719" v="491" actId="478"/>
          <ac:spMkLst>
            <pc:docMk/>
            <pc:sldMk cId="1271470338" sldId="271"/>
            <ac:spMk id="1025" creationId="{BE0E962B-A359-3DA6-EB33-67E0C424DB55}"/>
          </ac:spMkLst>
        </pc:spChg>
        <pc:spChg chg="add mod">
          <ac:chgData name="Wallis, Deeann" userId="624450ec-2436-4aff-8993-592194acd881" providerId="ADAL" clId="{47FFFDBD-6FF9-48EB-A3AC-23C62812EA00}" dt="2024-06-02T19:36:54.065" v="612" actId="1076"/>
          <ac:spMkLst>
            <pc:docMk/>
            <pc:sldMk cId="1271470338" sldId="271"/>
            <ac:spMk id="1027" creationId="{850E02B5-9D0C-A2DE-693E-F097A53B495A}"/>
          </ac:spMkLst>
        </pc:spChg>
        <pc:spChg chg="add mod">
          <ac:chgData name="Wallis, Deeann" userId="624450ec-2436-4aff-8993-592194acd881" providerId="ADAL" clId="{47FFFDBD-6FF9-48EB-A3AC-23C62812EA00}" dt="2024-06-02T19:35:26.937" v="593" actId="1076"/>
          <ac:spMkLst>
            <pc:docMk/>
            <pc:sldMk cId="1271470338" sldId="271"/>
            <ac:spMk id="1029" creationId="{7CAA44C8-CE02-11C0-3BD1-A77F58E03E37}"/>
          </ac:spMkLst>
        </pc:spChg>
        <pc:spChg chg="add mod">
          <ac:chgData name="Wallis, Deeann" userId="624450ec-2436-4aff-8993-592194acd881" providerId="ADAL" clId="{47FFFDBD-6FF9-48EB-A3AC-23C62812EA00}" dt="2024-06-02T19:38:40.904" v="630" actId="1076"/>
          <ac:spMkLst>
            <pc:docMk/>
            <pc:sldMk cId="1271470338" sldId="271"/>
            <ac:spMk id="1030" creationId="{D7C05920-C8F9-0DD3-EBE8-4A087D685A1C}"/>
          </ac:spMkLst>
        </pc:spChg>
        <pc:spChg chg="add mod">
          <ac:chgData name="Wallis, Deeann" userId="624450ec-2436-4aff-8993-592194acd881" providerId="ADAL" clId="{47FFFDBD-6FF9-48EB-A3AC-23C62812EA00}" dt="2024-06-02T19:33:26.435" v="579" actId="1076"/>
          <ac:spMkLst>
            <pc:docMk/>
            <pc:sldMk cId="1271470338" sldId="271"/>
            <ac:spMk id="1031" creationId="{153BA374-0E1C-0EE8-317E-697A65F182ED}"/>
          </ac:spMkLst>
        </pc:spChg>
        <pc:spChg chg="add mod">
          <ac:chgData name="Wallis, Deeann" userId="624450ec-2436-4aff-8993-592194acd881" providerId="ADAL" clId="{47FFFDBD-6FF9-48EB-A3AC-23C62812EA00}" dt="2024-06-02T19:29:44.149" v="522" actId="1076"/>
          <ac:spMkLst>
            <pc:docMk/>
            <pc:sldMk cId="1271470338" sldId="271"/>
            <ac:spMk id="1033" creationId="{A9EA88EA-C4F9-1A39-D51F-333101F5E8DB}"/>
          </ac:spMkLst>
        </pc:spChg>
        <pc:spChg chg="add mod">
          <ac:chgData name="Wallis, Deeann" userId="624450ec-2436-4aff-8993-592194acd881" providerId="ADAL" clId="{47FFFDBD-6FF9-48EB-A3AC-23C62812EA00}" dt="2024-06-02T19:38:27.570" v="629" actId="1076"/>
          <ac:spMkLst>
            <pc:docMk/>
            <pc:sldMk cId="1271470338" sldId="271"/>
            <ac:spMk id="1035" creationId="{A93885B2-3AC9-111C-8CEB-C80D162FABF4}"/>
          </ac:spMkLst>
        </pc:spChg>
        <pc:spChg chg="add mod">
          <ac:chgData name="Wallis, Deeann" userId="624450ec-2436-4aff-8993-592194acd881" providerId="ADAL" clId="{47FFFDBD-6FF9-48EB-A3AC-23C62812EA00}" dt="2024-06-02T19:38:23.153" v="628" actId="1076"/>
          <ac:spMkLst>
            <pc:docMk/>
            <pc:sldMk cId="1271470338" sldId="271"/>
            <ac:spMk id="1037" creationId="{6115229B-CF7D-1DF7-8DBF-9DCC6F66095E}"/>
          </ac:spMkLst>
        </pc:spChg>
        <pc:spChg chg="add mod">
          <ac:chgData name="Wallis, Deeann" userId="624450ec-2436-4aff-8993-592194acd881" providerId="ADAL" clId="{47FFFDBD-6FF9-48EB-A3AC-23C62812EA00}" dt="2024-06-02T19:38:16.830" v="627" actId="1076"/>
          <ac:spMkLst>
            <pc:docMk/>
            <pc:sldMk cId="1271470338" sldId="271"/>
            <ac:spMk id="1038" creationId="{883208C2-CC0E-C78F-1AAF-497044E53E80}"/>
          </ac:spMkLst>
        </pc:spChg>
        <pc:spChg chg="add mod">
          <ac:chgData name="Wallis, Deeann" userId="624450ec-2436-4aff-8993-592194acd881" providerId="ADAL" clId="{47FFFDBD-6FF9-48EB-A3AC-23C62812EA00}" dt="2024-06-02T19:38:10.642" v="626" actId="1076"/>
          <ac:spMkLst>
            <pc:docMk/>
            <pc:sldMk cId="1271470338" sldId="271"/>
            <ac:spMk id="1039" creationId="{8C0FF7C2-AC57-C902-7DEA-EF95D40202D4}"/>
          </ac:spMkLst>
        </pc:spChg>
        <pc:spChg chg="add del mod">
          <ac:chgData name="Wallis, Deeann" userId="624450ec-2436-4aff-8993-592194acd881" providerId="ADAL" clId="{47FFFDBD-6FF9-48EB-A3AC-23C62812EA00}" dt="2024-06-02T19:24:16.904" v="482" actId="478"/>
          <ac:spMkLst>
            <pc:docMk/>
            <pc:sldMk cId="1271470338" sldId="271"/>
            <ac:spMk id="1040" creationId="{94D4CED4-3289-2C2F-7502-95A77A138593}"/>
          </ac:spMkLst>
        </pc:spChg>
        <pc:spChg chg="add mod">
          <ac:chgData name="Wallis, Deeann" userId="624450ec-2436-4aff-8993-592194acd881" providerId="ADAL" clId="{47FFFDBD-6FF9-48EB-A3AC-23C62812EA00}" dt="2024-06-02T19:25:21.309" v="486" actId="1076"/>
          <ac:spMkLst>
            <pc:docMk/>
            <pc:sldMk cId="1271470338" sldId="271"/>
            <ac:spMk id="1041" creationId="{191819C9-5627-B1F5-601C-B725CB72DAB4}"/>
          </ac:spMkLst>
        </pc:spChg>
        <pc:spChg chg="add mod">
          <ac:chgData name="Wallis, Deeann" userId="624450ec-2436-4aff-8993-592194acd881" providerId="ADAL" clId="{47FFFDBD-6FF9-48EB-A3AC-23C62812EA00}" dt="2024-06-02T19:37:59.341" v="624" actId="1076"/>
          <ac:spMkLst>
            <pc:docMk/>
            <pc:sldMk cId="1271470338" sldId="271"/>
            <ac:spMk id="1042" creationId="{16A9039E-8201-867D-B546-8AA07C346321}"/>
          </ac:spMkLst>
        </pc:spChg>
        <pc:spChg chg="add mod">
          <ac:chgData name="Wallis, Deeann" userId="624450ec-2436-4aff-8993-592194acd881" providerId="ADAL" clId="{47FFFDBD-6FF9-48EB-A3AC-23C62812EA00}" dt="2024-06-02T19:38:02.897" v="625" actId="1076"/>
          <ac:spMkLst>
            <pc:docMk/>
            <pc:sldMk cId="1271470338" sldId="271"/>
            <ac:spMk id="1043" creationId="{76E43510-98D4-6C43-6ADB-40E6AB7AD6C9}"/>
          </ac:spMkLst>
        </pc:spChg>
        <pc:spChg chg="add del mod">
          <ac:chgData name="Wallis, Deeann" userId="624450ec-2436-4aff-8993-592194acd881" providerId="ADAL" clId="{47FFFDBD-6FF9-48EB-A3AC-23C62812EA00}" dt="2024-06-02T19:26:59.784" v="503" actId="478"/>
          <ac:spMkLst>
            <pc:docMk/>
            <pc:sldMk cId="1271470338" sldId="271"/>
            <ac:spMk id="1044" creationId="{A573867C-2DA5-07DF-B520-7530A5A7DF46}"/>
          </ac:spMkLst>
        </pc:spChg>
        <pc:spChg chg="add del mod">
          <ac:chgData name="Wallis, Deeann" userId="624450ec-2436-4aff-8993-592194acd881" providerId="ADAL" clId="{47FFFDBD-6FF9-48EB-A3AC-23C62812EA00}" dt="2024-06-02T19:27:14.864" v="510" actId="478"/>
          <ac:spMkLst>
            <pc:docMk/>
            <pc:sldMk cId="1271470338" sldId="271"/>
            <ac:spMk id="1045" creationId="{1DDA33A1-4C02-F18E-D44B-7267FF7F6E8E}"/>
          </ac:spMkLst>
        </pc:spChg>
        <pc:spChg chg="add del mod">
          <ac:chgData name="Wallis, Deeann" userId="624450ec-2436-4aff-8993-592194acd881" providerId="ADAL" clId="{47FFFDBD-6FF9-48EB-A3AC-23C62812EA00}" dt="2024-06-02T19:27:07.834" v="506" actId="478"/>
          <ac:spMkLst>
            <pc:docMk/>
            <pc:sldMk cId="1271470338" sldId="271"/>
            <ac:spMk id="1046" creationId="{7691E67D-F138-3EA0-3D29-EC9BFA43B7F0}"/>
          </ac:spMkLst>
        </pc:spChg>
        <pc:spChg chg="add del mod">
          <ac:chgData name="Wallis, Deeann" userId="624450ec-2436-4aff-8993-592194acd881" providerId="ADAL" clId="{47FFFDBD-6FF9-48EB-A3AC-23C62812EA00}" dt="2024-06-02T19:26:55.121" v="499" actId="478"/>
          <ac:spMkLst>
            <pc:docMk/>
            <pc:sldMk cId="1271470338" sldId="271"/>
            <ac:spMk id="1047" creationId="{A7088AA4-63A7-EA22-D8B0-6DDF61880421}"/>
          </ac:spMkLst>
        </pc:spChg>
        <pc:spChg chg="add del mod">
          <ac:chgData name="Wallis, Deeann" userId="624450ec-2436-4aff-8993-592194acd881" providerId="ADAL" clId="{47FFFDBD-6FF9-48EB-A3AC-23C62812EA00}" dt="2024-06-02T19:26:55.121" v="499" actId="478"/>
          <ac:spMkLst>
            <pc:docMk/>
            <pc:sldMk cId="1271470338" sldId="271"/>
            <ac:spMk id="1048" creationId="{79E0E6C1-3B5D-8F57-E0BD-3A21344A969A}"/>
          </ac:spMkLst>
        </pc:spChg>
        <pc:spChg chg="add del mod">
          <ac:chgData name="Wallis, Deeann" userId="624450ec-2436-4aff-8993-592194acd881" providerId="ADAL" clId="{47FFFDBD-6FF9-48EB-A3AC-23C62812EA00}" dt="2024-06-02T19:26:55.121" v="499" actId="478"/>
          <ac:spMkLst>
            <pc:docMk/>
            <pc:sldMk cId="1271470338" sldId="271"/>
            <ac:spMk id="1049" creationId="{4A7DFFCA-0764-70CE-A436-39679F3C3704}"/>
          </ac:spMkLst>
        </pc:spChg>
        <pc:spChg chg="add del mod">
          <ac:chgData name="Wallis, Deeann" userId="624450ec-2436-4aff-8993-592194acd881" providerId="ADAL" clId="{47FFFDBD-6FF9-48EB-A3AC-23C62812EA00}" dt="2024-06-02T19:26:55.121" v="499" actId="478"/>
          <ac:spMkLst>
            <pc:docMk/>
            <pc:sldMk cId="1271470338" sldId="271"/>
            <ac:spMk id="1050" creationId="{995C1B2C-031E-1446-50F9-15C14BE5BD30}"/>
          </ac:spMkLst>
        </pc:spChg>
        <pc:spChg chg="add del mod">
          <ac:chgData name="Wallis, Deeann" userId="624450ec-2436-4aff-8993-592194acd881" providerId="ADAL" clId="{47FFFDBD-6FF9-48EB-A3AC-23C62812EA00}" dt="2024-06-02T19:26:55.121" v="499" actId="478"/>
          <ac:spMkLst>
            <pc:docMk/>
            <pc:sldMk cId="1271470338" sldId="271"/>
            <ac:spMk id="1051" creationId="{19F4AB01-BF31-8B8C-CBEB-765978D8C4EF}"/>
          </ac:spMkLst>
        </pc:spChg>
        <pc:spChg chg="add mod">
          <ac:chgData name="Wallis, Deeann" userId="624450ec-2436-4aff-8993-592194acd881" providerId="ADAL" clId="{47FFFDBD-6FF9-48EB-A3AC-23C62812EA00}" dt="2024-06-02T19:32:57.682" v="577" actId="1076"/>
          <ac:spMkLst>
            <pc:docMk/>
            <pc:sldMk cId="1271470338" sldId="271"/>
            <ac:spMk id="1052" creationId="{9A4D58C9-5FF6-B701-5889-837BEEF3792B}"/>
          </ac:spMkLst>
        </pc:spChg>
        <pc:grpChg chg="mod">
          <ac:chgData name="Wallis, Deeann" userId="624450ec-2436-4aff-8993-592194acd881" providerId="ADAL" clId="{47FFFDBD-6FF9-48EB-A3AC-23C62812EA00}" dt="2024-06-02T19:35:33.541" v="594" actId="1076"/>
          <ac:grpSpMkLst>
            <pc:docMk/>
            <pc:sldMk cId="1271470338" sldId="271"/>
            <ac:grpSpMk id="16" creationId="{EC00E86C-6DCD-6D65-55E7-8CC3A4FA2799}"/>
          </ac:grpSpMkLst>
        </pc:grpChg>
        <pc:grpChg chg="mod">
          <ac:chgData name="Wallis, Deeann" userId="624450ec-2436-4aff-8993-592194acd881" providerId="ADAL" clId="{47FFFDBD-6FF9-48EB-A3AC-23C62812EA00}" dt="2024-06-02T19:15:01" v="388" actId="14100"/>
          <ac:grpSpMkLst>
            <pc:docMk/>
            <pc:sldMk cId="1271470338" sldId="271"/>
            <ac:grpSpMk id="58" creationId="{562027BB-5CA2-18B8-2A7F-CD9A38884E0D}"/>
          </ac:grpSpMkLst>
        </pc:grpChg>
        <pc:grpChg chg="mod">
          <ac:chgData name="Wallis, Deeann" userId="624450ec-2436-4aff-8993-592194acd881" providerId="ADAL" clId="{47FFFDBD-6FF9-48EB-A3AC-23C62812EA00}" dt="2024-06-02T19:15:05.102" v="389" actId="14100"/>
          <ac:grpSpMkLst>
            <pc:docMk/>
            <pc:sldMk cId="1271470338" sldId="271"/>
            <ac:grpSpMk id="59" creationId="{99F0AD5C-1B8E-0FDF-E1AC-DF4140D52ECF}"/>
          </ac:grpSpMkLst>
        </pc:grpChg>
        <pc:grpChg chg="mod">
          <ac:chgData name="Wallis, Deeann" userId="624450ec-2436-4aff-8993-592194acd881" providerId="ADAL" clId="{47FFFDBD-6FF9-48EB-A3AC-23C62812EA00}" dt="2024-06-02T19:26:53.025" v="498" actId="571"/>
          <ac:grpSpMkLst>
            <pc:docMk/>
            <pc:sldMk cId="1271470338" sldId="271"/>
            <ac:grpSpMk id="1024" creationId="{2EC0D7B4-A794-02A0-84F0-09DF536A291D}"/>
          </ac:grpSpMkLst>
        </pc:grpChg>
        <pc:picChg chg="add mod">
          <ac:chgData name="Wallis, Deeann" userId="624450ec-2436-4aff-8993-592194acd881" providerId="ADAL" clId="{47FFFDBD-6FF9-48EB-A3AC-23C62812EA00}" dt="2024-06-02T19:12:37.424" v="372" actId="1036"/>
          <ac:picMkLst>
            <pc:docMk/>
            <pc:sldMk cId="1271470338" sldId="271"/>
            <ac:picMk id="4" creationId="{38708259-AF2A-F932-8BD9-54A195256826}"/>
          </ac:picMkLst>
        </pc:picChg>
        <pc:picChg chg="add mod">
          <ac:chgData name="Wallis, Deeann" userId="624450ec-2436-4aff-8993-592194acd881" providerId="ADAL" clId="{47FFFDBD-6FF9-48EB-A3AC-23C62812EA00}" dt="2024-06-02T19:37:50.444" v="623" actId="1076"/>
          <ac:picMkLst>
            <pc:docMk/>
            <pc:sldMk cId="1271470338" sldId="271"/>
            <ac:picMk id="6" creationId="{CCACD5A2-444E-C81B-D3BC-1C65BC51F88A}"/>
          </ac:picMkLst>
        </pc:picChg>
        <pc:picChg chg="del mod">
          <ac:chgData name="Wallis, Deeann" userId="624450ec-2436-4aff-8993-592194acd881" providerId="ADAL" clId="{47FFFDBD-6FF9-48EB-A3AC-23C62812EA00}" dt="2024-06-02T19:26:40.815" v="493" actId="478"/>
          <ac:picMkLst>
            <pc:docMk/>
            <pc:sldMk cId="1271470338" sldId="271"/>
            <ac:picMk id="53" creationId="{1ED4C8F9-4D00-2667-E0E9-04B936B0F87B}"/>
          </ac:picMkLst>
        </pc:picChg>
        <pc:picChg chg="mod">
          <ac:chgData name="Wallis, Deeann" userId="624450ec-2436-4aff-8993-592194acd881" providerId="ADAL" clId="{47FFFDBD-6FF9-48EB-A3AC-23C62812EA00}" dt="2024-06-02T19:15:01" v="388" actId="14100"/>
          <ac:picMkLst>
            <pc:docMk/>
            <pc:sldMk cId="1271470338" sldId="271"/>
            <ac:picMk id="1034" creationId="{17394FAC-69D8-0E97-25B8-4D526B0D3E6A}"/>
          </ac:picMkLst>
        </pc:picChg>
        <pc:picChg chg="mod">
          <ac:chgData name="Wallis, Deeann" userId="624450ec-2436-4aff-8993-592194acd881" providerId="ADAL" clId="{47FFFDBD-6FF9-48EB-A3AC-23C62812EA00}" dt="2024-06-02T19:15:05.102" v="389" actId="14100"/>
          <ac:picMkLst>
            <pc:docMk/>
            <pc:sldMk cId="1271470338" sldId="271"/>
            <ac:picMk id="1036" creationId="{E34C52D3-22BA-6550-70BD-E442A15AA12A}"/>
          </ac:picMkLst>
        </pc:picChg>
      </pc:sldChg>
      <pc:sldChg chg="modNotesTx">
        <pc:chgData name="Wallis, Deeann" userId="624450ec-2436-4aff-8993-592194acd881" providerId="ADAL" clId="{47FFFDBD-6FF9-48EB-A3AC-23C62812EA00}" dt="2024-06-02T21:04:05.830" v="631" actId="20577"/>
        <pc:sldMkLst>
          <pc:docMk/>
          <pc:sldMk cId="4106249868" sldId="277"/>
        </pc:sldMkLst>
      </pc:sldChg>
      <pc:sldChg chg="modNotesTx">
        <pc:chgData name="Wallis, Deeann" userId="624450ec-2436-4aff-8993-592194acd881" providerId="ADAL" clId="{47FFFDBD-6FF9-48EB-A3AC-23C62812EA00}" dt="2024-06-02T21:04:11.114" v="633" actId="20577"/>
        <pc:sldMkLst>
          <pc:docMk/>
          <pc:sldMk cId="2653356026" sldId="280"/>
        </pc:sldMkLst>
      </pc:sldChg>
      <pc:sldChg chg="delSp modSp mod">
        <pc:chgData name="Wallis, Deeann" userId="624450ec-2436-4aff-8993-592194acd881" providerId="ADAL" clId="{47FFFDBD-6FF9-48EB-A3AC-23C62812EA00}" dt="2024-05-22T21:10:52.959" v="2" actId="21"/>
        <pc:sldMkLst>
          <pc:docMk/>
          <pc:sldMk cId="3796534110" sldId="285"/>
        </pc:sldMkLst>
        <pc:picChg chg="mod">
          <ac:chgData name="Wallis, Deeann" userId="624450ec-2436-4aff-8993-592194acd881" providerId="ADAL" clId="{47FFFDBD-6FF9-48EB-A3AC-23C62812EA00}" dt="2024-05-22T19:48:45.435" v="0" actId="1076"/>
          <ac:picMkLst>
            <pc:docMk/>
            <pc:sldMk cId="3796534110" sldId="285"/>
            <ac:picMk id="5" creationId="{01D25549-C947-6572-A9E5-28AD50FB3D98}"/>
          </ac:picMkLst>
        </pc:picChg>
        <pc:picChg chg="del mod">
          <ac:chgData name="Wallis, Deeann" userId="624450ec-2436-4aff-8993-592194acd881" providerId="ADAL" clId="{47FFFDBD-6FF9-48EB-A3AC-23C62812EA00}" dt="2024-05-22T21:10:52.959" v="2" actId="21"/>
          <ac:picMkLst>
            <pc:docMk/>
            <pc:sldMk cId="3796534110" sldId="285"/>
            <ac:picMk id="7" creationId="{59AB397A-28B7-C346-154C-5B74F97E6AA6}"/>
          </ac:picMkLst>
        </pc:picChg>
      </pc:sldChg>
      <pc:sldChg chg="addSp modSp mod">
        <pc:chgData name="Wallis, Deeann" userId="624450ec-2436-4aff-8993-592194acd881" providerId="ADAL" clId="{47FFFDBD-6FF9-48EB-A3AC-23C62812EA00}" dt="2024-05-22T21:14:03.328" v="30" actId="20577"/>
        <pc:sldMkLst>
          <pc:docMk/>
          <pc:sldMk cId="1228655777" sldId="287"/>
        </pc:sldMkLst>
        <pc:spChg chg="add mod">
          <ac:chgData name="Wallis, Deeann" userId="624450ec-2436-4aff-8993-592194acd881" providerId="ADAL" clId="{47FFFDBD-6FF9-48EB-A3AC-23C62812EA00}" dt="2024-05-22T21:13:57.533" v="27" actId="20577"/>
          <ac:spMkLst>
            <pc:docMk/>
            <pc:sldMk cId="1228655777" sldId="287"/>
            <ac:spMk id="4" creationId="{3720F012-AF40-95C4-F9F6-FA2B4FDDD75C}"/>
          </ac:spMkLst>
        </pc:spChg>
        <pc:spChg chg="add mod">
          <ac:chgData name="Wallis, Deeann" userId="624450ec-2436-4aff-8993-592194acd881" providerId="ADAL" clId="{47FFFDBD-6FF9-48EB-A3AC-23C62812EA00}" dt="2024-05-22T21:14:03.328" v="30" actId="20577"/>
          <ac:spMkLst>
            <pc:docMk/>
            <pc:sldMk cId="1228655777" sldId="287"/>
            <ac:spMk id="5" creationId="{D6A12B45-879D-DB78-A0BC-DF964FED4F59}"/>
          </ac:spMkLst>
        </pc:spChg>
        <pc:spChg chg="mod">
          <ac:chgData name="Wallis, Deeann" userId="624450ec-2436-4aff-8993-592194acd881" providerId="ADAL" clId="{47FFFDBD-6FF9-48EB-A3AC-23C62812EA00}" dt="2024-05-22T21:13:47.738" v="23" actId="1076"/>
          <ac:spMkLst>
            <pc:docMk/>
            <pc:sldMk cId="1228655777" sldId="287"/>
            <ac:spMk id="16" creationId="{17832723-45AF-7E5A-DBDB-B87187A8520E}"/>
          </ac:spMkLst>
        </pc:spChg>
        <pc:picChg chg="add mod">
          <ac:chgData name="Wallis, Deeann" userId="624450ec-2436-4aff-8993-592194acd881" providerId="ADAL" clId="{47FFFDBD-6FF9-48EB-A3AC-23C62812EA00}" dt="2024-05-22T21:13:29.852" v="20" actId="1076"/>
          <ac:picMkLst>
            <pc:docMk/>
            <pc:sldMk cId="1228655777" sldId="287"/>
            <ac:picMk id="2" creationId="{09B959CA-4795-EE0B-1D6D-EEBD54555072}"/>
          </ac:picMkLst>
        </pc:picChg>
        <pc:picChg chg="add mod">
          <ac:chgData name="Wallis, Deeann" userId="624450ec-2436-4aff-8993-592194acd881" providerId="ADAL" clId="{47FFFDBD-6FF9-48EB-A3AC-23C62812EA00}" dt="2024-05-22T21:13:44.723" v="22" actId="1076"/>
          <ac:picMkLst>
            <pc:docMk/>
            <pc:sldMk cId="1228655777" sldId="287"/>
            <ac:picMk id="3" creationId="{3D62B572-7438-0A93-0B28-1499319699B3}"/>
          </ac:picMkLst>
        </pc:picChg>
        <pc:picChg chg="add mod">
          <ac:chgData name="Wallis, Deeann" userId="624450ec-2436-4aff-8993-592194acd881" providerId="ADAL" clId="{47FFFDBD-6FF9-48EB-A3AC-23C62812EA00}" dt="2024-05-22T21:13:22.476" v="18" actId="1076"/>
          <ac:picMkLst>
            <pc:docMk/>
            <pc:sldMk cId="1228655777" sldId="287"/>
            <ac:picMk id="7" creationId="{59AB397A-28B7-C346-154C-5B74F97E6AA6}"/>
          </ac:picMkLst>
        </pc:picChg>
      </pc:sldChg>
      <pc:sldChg chg="addSp delSp modSp new del mod">
        <pc:chgData name="Wallis, Deeann" userId="624450ec-2436-4aff-8993-592194acd881" providerId="ADAL" clId="{47FFFDBD-6FF9-48EB-A3AC-23C62812EA00}" dt="2024-05-22T21:37:12.465" v="80" actId="47"/>
        <pc:sldMkLst>
          <pc:docMk/>
          <pc:sldMk cId="2716019950" sldId="288"/>
        </pc:sldMkLst>
        <pc:spChg chg="del mod">
          <ac:chgData name="Wallis, Deeann" userId="624450ec-2436-4aff-8993-592194acd881" providerId="ADAL" clId="{47FFFDBD-6FF9-48EB-A3AC-23C62812EA00}" dt="2024-05-22T21:37:01.666" v="73" actId="21"/>
          <ac:spMkLst>
            <pc:docMk/>
            <pc:sldMk cId="2716019950" sldId="288"/>
            <ac:spMk id="2" creationId="{86E58497-8D50-C4EA-BAEE-5890E84E5BFF}"/>
          </ac:spMkLst>
        </pc:spChg>
        <pc:spChg chg="add mod">
          <ac:chgData name="Wallis, Deeann" userId="624450ec-2436-4aff-8993-592194acd881" providerId="ADAL" clId="{47FFFDBD-6FF9-48EB-A3AC-23C62812EA00}" dt="2024-05-22T21:37:01.666" v="73" actId="21"/>
          <ac:spMkLst>
            <pc:docMk/>
            <pc:sldMk cId="2716019950" sldId="288"/>
            <ac:spMk id="5" creationId="{EBB14115-3DBE-015F-8475-F62A1074CD60}"/>
          </ac:spMkLst>
        </pc:spChg>
      </pc:sldChg>
      <pc:sldChg chg="del">
        <pc:chgData name="Wallis, Deeann" userId="624450ec-2436-4aff-8993-592194acd881" providerId="ADAL" clId="{47FFFDBD-6FF9-48EB-A3AC-23C62812EA00}" dt="2024-06-02T19:10:01.707" v="335" actId="47"/>
        <pc:sldMkLst>
          <pc:docMk/>
          <pc:sldMk cId="1009493001" sldId="28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9CC289-4ED0-4463-9410-B2ECACA8460C}" type="datetimeFigureOut">
              <a:rPr lang="en-US" smtClean="0"/>
              <a:t>6/1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2EFAB7-4F57-4268-9183-BD60CC9996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3546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Supplemental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2EFAB7-4F57-4268-9183-BD60CC9996F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0640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Supplemental Figure 1: </a:t>
            </a:r>
            <a:r>
              <a:rPr lang="en-US" sz="1200" b="1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NFs</a:t>
            </a:r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reated with </a:t>
            </a:r>
            <a:r>
              <a:rPr lang="en-US" sz="1200" b="1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lumetinib</a:t>
            </a:r>
            <a:r>
              <a:rPr lang="en-US" sz="1200" b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hibit decreased calcium and opioid signaling A) Fibroblasts and Opioid signaling </a:t>
            </a:r>
            <a:r>
              <a:rPr lang="en-US" sz="1200" b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Dot plot of </a:t>
            </a:r>
            <a:r>
              <a:rPr lang="en-US" sz="120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es related to calcium signaling Fibroblasts. C) Dot plot of genes related to Calcium signaling in Myeloid cells. D) Dot plot of genes related to Calcium signaling in Endothelial</a:t>
            </a:r>
            <a:r>
              <a:rPr lang="en-US" sz="1200" baseline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1 cells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2EFAB7-4F57-4268-9183-BD60CC9996F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981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upplemental figure 2 Differentially expressed genes from fibroblast clusters depicted in Figure 3E.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2EFAB7-4F57-4268-9183-BD60CC9996F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93075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 Fig 5 Cell chat ingoing and outgoing signals in untreated</a:t>
            </a:r>
            <a:r>
              <a:rPr lang="en-US" baseline="0" dirty="0"/>
              <a:t> control and selumetinib treated tumor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32EFAB7-4F57-4268-9183-BD60CC9996FF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06770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6. Gene expression comparison of cellular components and extracellular matrix of </a:t>
            </a:r>
            <a:r>
              <a:rPr lang="en-US" dirty="0" err="1"/>
              <a:t>cNFs</a:t>
            </a:r>
            <a:r>
              <a:rPr lang="en-US" dirty="0"/>
              <a:t> treated with selumetinib. A) 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32EFAB7-4F57-4268-9183-BD60CC9996FF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3313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093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218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000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8DA41-ED3F-45F2-A2CB-E7C456FBE965}" type="datetimeFigureOut">
              <a:rPr lang="en-US" smtClean="0"/>
              <a:t>6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C87DBB-0853-4BBA-990E-CCFF84E2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2648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328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957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1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542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1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353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1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0588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162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6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122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6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454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2" r:id="rId1"/>
    <p:sldLayoutId id="2147483653" r:id="rId2"/>
    <p:sldLayoutId id="2147483654" r:id="rId3"/>
    <p:sldLayoutId id="2147483655" r:id="rId4"/>
    <p:sldLayoutId id="2147483656" r:id="rId5"/>
    <p:sldLayoutId id="2147483657" r:id="rId6"/>
    <p:sldLayoutId id="2147483658" r:id="rId7"/>
    <p:sldLayoutId id="2147483659" r:id="rId8"/>
    <p:sldLayoutId id="2147483660" r:id="rId9"/>
    <p:sldLayoutId id="2147483661" r:id="rId10"/>
    <p:sldLayoutId id="2147483662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33B51D8-145B-D18C-03FE-090128AC8155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/>
              <a:t>Supplemental Figures</a:t>
            </a:r>
          </a:p>
        </p:txBody>
      </p:sp>
    </p:spTree>
    <p:extLst>
      <p:ext uri="{BB962C8B-B14F-4D97-AF65-F5344CB8AC3E}">
        <p14:creationId xmlns:p14="http://schemas.microsoft.com/office/powerpoint/2010/main" val="37868069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 descr="A graph of different colored shapes&#10;&#10;Description automatically generated with medium confidence">
            <a:extLst>
              <a:ext uri="{FF2B5EF4-FFF2-40B4-BE49-F238E27FC236}">
                <a16:creationId xmlns:a16="http://schemas.microsoft.com/office/drawing/2014/main" xmlns="" id="{48E8F549-56FA-6725-6C96-62A9105ABC6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9323" y="1592162"/>
            <a:ext cx="2936425" cy="2704587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17832723-45AF-7E5A-DBDB-B87187A8520E}"/>
              </a:ext>
            </a:extLst>
          </p:cNvPr>
          <p:cNvSpPr txBox="1"/>
          <p:nvPr/>
        </p:nvSpPr>
        <p:spPr>
          <a:xfrm>
            <a:off x="223350" y="1607911"/>
            <a:ext cx="732603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b="1"/>
              <a:t>A)</a:t>
            </a:r>
          </a:p>
        </p:txBody>
      </p:sp>
      <p:pic>
        <p:nvPicPr>
          <p:cNvPr id="21" name="Picture 20" descr="A graph with colored lines&#10;&#10;Description automatically generated">
            <a:extLst>
              <a:ext uri="{FF2B5EF4-FFF2-40B4-BE49-F238E27FC236}">
                <a16:creationId xmlns:a16="http://schemas.microsoft.com/office/drawing/2014/main" xmlns="" id="{CB39AEA8-4779-B1EC-670D-4874FBD00E9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8926" y="1452600"/>
            <a:ext cx="2893218" cy="2893218"/>
          </a:xfrm>
          <a:prstGeom prst="rect">
            <a:avLst/>
          </a:prstGeom>
        </p:spPr>
      </p:pic>
      <p:pic>
        <p:nvPicPr>
          <p:cNvPr id="7" name="Picture 6" descr="A close-up of a bar code&#10;&#10;Description automatically generated">
            <a:extLst>
              <a:ext uri="{FF2B5EF4-FFF2-40B4-BE49-F238E27FC236}">
                <a16:creationId xmlns:a16="http://schemas.microsoft.com/office/drawing/2014/main" xmlns="" id="{59AB397A-28B7-C346-154C-5B74F97E6AA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48" y="6920029"/>
            <a:ext cx="7772400" cy="1554480"/>
          </a:xfrm>
          <a:prstGeom prst="rect">
            <a:avLst/>
          </a:prstGeom>
        </p:spPr>
      </p:pic>
      <p:pic>
        <p:nvPicPr>
          <p:cNvPr id="2" name="Picture 1" descr="A map of different colored shapes&#10;&#10;Description automatically generated">
            <a:extLst>
              <a:ext uri="{FF2B5EF4-FFF2-40B4-BE49-F238E27FC236}">
                <a16:creationId xmlns:a16="http://schemas.microsoft.com/office/drawing/2014/main" xmlns="" id="{09B959CA-4795-EE0B-1D6D-EEBD5455507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495"/>
          <a:stretch/>
        </p:blipFill>
        <p:spPr>
          <a:xfrm>
            <a:off x="955953" y="4316614"/>
            <a:ext cx="2959795" cy="2417968"/>
          </a:xfrm>
          <a:prstGeom prst="rect">
            <a:avLst/>
          </a:prstGeom>
        </p:spPr>
      </p:pic>
      <p:pic>
        <p:nvPicPr>
          <p:cNvPr id="3" name="Picture 2" descr="A map of different colored shapes&#10;&#10;Description automatically generated">
            <a:extLst>
              <a:ext uri="{FF2B5EF4-FFF2-40B4-BE49-F238E27FC236}">
                <a16:creationId xmlns:a16="http://schemas.microsoft.com/office/drawing/2014/main" xmlns="" id="{3D62B572-7438-0A93-0B28-1499319699B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272" t="31777" b="32172"/>
          <a:stretch/>
        </p:blipFill>
        <p:spPr>
          <a:xfrm>
            <a:off x="4314166" y="4965182"/>
            <a:ext cx="1211073" cy="115003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3720F012-AF40-95C4-F9F6-FA2B4FDDD75C}"/>
              </a:ext>
            </a:extLst>
          </p:cNvPr>
          <p:cNvSpPr txBox="1"/>
          <p:nvPr/>
        </p:nvSpPr>
        <p:spPr>
          <a:xfrm>
            <a:off x="235035" y="4131167"/>
            <a:ext cx="732603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b="1" dirty="0"/>
              <a:t>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D6A12B45-879D-DB78-A0BC-DF964FED4F59}"/>
              </a:ext>
            </a:extLst>
          </p:cNvPr>
          <p:cNvSpPr txBox="1"/>
          <p:nvPr/>
        </p:nvSpPr>
        <p:spPr>
          <a:xfrm>
            <a:off x="246720" y="6839870"/>
            <a:ext cx="732603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b="1" dirty="0"/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12286557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different sizes of dna&#10;&#10;Description automatically generated with medium confidence">
            <a:extLst>
              <a:ext uri="{FF2B5EF4-FFF2-40B4-BE49-F238E27FC236}">
                <a16:creationId xmlns:a16="http://schemas.microsoft.com/office/drawing/2014/main" xmlns="" id="{B6217F3F-6EFA-EC43-7660-68E4810E171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5815" y="8221156"/>
            <a:ext cx="2981022" cy="178861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AEFD9C5D-22B8-6EC7-0ED8-4AF0915F0DF6}"/>
              </a:ext>
            </a:extLst>
          </p:cNvPr>
          <p:cNvSpPr txBox="1"/>
          <p:nvPr/>
        </p:nvSpPr>
        <p:spPr>
          <a:xfrm>
            <a:off x="5020674" y="7595097"/>
            <a:ext cx="1040949" cy="2100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65" b="1"/>
              <a:t>Endothelial Cells 1</a:t>
            </a:r>
          </a:p>
        </p:txBody>
      </p:sp>
      <p:pic>
        <p:nvPicPr>
          <p:cNvPr id="19" name="Picture 18" descr="A diagram of dna gene&#10;&#10;Description automatically generated with medium confidence">
            <a:extLst>
              <a:ext uri="{FF2B5EF4-FFF2-40B4-BE49-F238E27FC236}">
                <a16:creationId xmlns:a16="http://schemas.microsoft.com/office/drawing/2014/main" xmlns="" id="{EEA934F9-0203-9790-6E8C-08520F51C87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350" y="8171129"/>
            <a:ext cx="3677279" cy="183864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7AF3EBAB-A830-C1F5-CDE6-6E99BE1005F4}"/>
              </a:ext>
            </a:extLst>
          </p:cNvPr>
          <p:cNvSpPr txBox="1"/>
          <p:nvPr/>
        </p:nvSpPr>
        <p:spPr>
          <a:xfrm>
            <a:off x="1926742" y="6909433"/>
            <a:ext cx="684505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65" b="1"/>
              <a:t>Myeloid Cells</a:t>
            </a:r>
          </a:p>
        </p:txBody>
      </p:sp>
      <p:pic>
        <p:nvPicPr>
          <p:cNvPr id="21" name="Picture 20" descr="A diagram of a number of red and blue dots&#10;&#10;Description automatically generated">
            <a:extLst>
              <a:ext uri="{FF2B5EF4-FFF2-40B4-BE49-F238E27FC236}">
                <a16:creationId xmlns:a16="http://schemas.microsoft.com/office/drawing/2014/main" xmlns="" id="{78CB7F82-B8A2-8E0E-E3CD-AF20D596AFF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4629" y="5858017"/>
            <a:ext cx="3703394" cy="1851697"/>
          </a:xfrm>
          <a:prstGeom prst="rect">
            <a:avLst/>
          </a:prstGeom>
        </p:spPr>
      </p:pic>
      <p:pic>
        <p:nvPicPr>
          <p:cNvPr id="22" name="Picture 21" descr="A diagram of a number of cells&#10;&#10;Description automatically generated with medium confidence">
            <a:extLst>
              <a:ext uri="{FF2B5EF4-FFF2-40B4-BE49-F238E27FC236}">
                <a16:creationId xmlns:a16="http://schemas.microsoft.com/office/drawing/2014/main" xmlns="" id="{5B62EE96-FD58-9E53-CC18-AC61D49E9EF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323"/>
          <a:stretch/>
        </p:blipFill>
        <p:spPr>
          <a:xfrm>
            <a:off x="367351" y="5889809"/>
            <a:ext cx="3518849" cy="1819905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18FD9AD9-22F8-AF57-0783-2506C8438A4C}"/>
              </a:ext>
            </a:extLst>
          </p:cNvPr>
          <p:cNvSpPr txBox="1"/>
          <p:nvPr/>
        </p:nvSpPr>
        <p:spPr>
          <a:xfrm>
            <a:off x="1127044" y="5706184"/>
            <a:ext cx="1093940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b="1"/>
              <a:t>Fibroblast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15355F5F-3663-B01A-6D55-4B11F28951FD}"/>
              </a:ext>
            </a:extLst>
          </p:cNvPr>
          <p:cNvSpPr txBox="1"/>
          <p:nvPr/>
        </p:nvSpPr>
        <p:spPr>
          <a:xfrm>
            <a:off x="3771309" y="254217"/>
            <a:ext cx="817616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/>
              <a:t>B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18FD9AD9-22F8-AF57-0783-2506C8438A4C}"/>
              </a:ext>
            </a:extLst>
          </p:cNvPr>
          <p:cNvSpPr txBox="1"/>
          <p:nvPr/>
        </p:nvSpPr>
        <p:spPr>
          <a:xfrm>
            <a:off x="5020674" y="5708651"/>
            <a:ext cx="1093940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b="1"/>
              <a:t>Fibroblasts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15355F5F-3663-B01A-6D55-4B11F28951FD}"/>
              </a:ext>
            </a:extLst>
          </p:cNvPr>
          <p:cNvSpPr txBox="1"/>
          <p:nvPr/>
        </p:nvSpPr>
        <p:spPr>
          <a:xfrm>
            <a:off x="56237" y="255860"/>
            <a:ext cx="639058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/>
              <a:t>A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15355F5F-3663-B01A-6D55-4B11F28951FD}"/>
              </a:ext>
            </a:extLst>
          </p:cNvPr>
          <p:cNvSpPr txBox="1"/>
          <p:nvPr/>
        </p:nvSpPr>
        <p:spPr>
          <a:xfrm>
            <a:off x="56237" y="2514872"/>
            <a:ext cx="925952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/>
              <a:t>C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15355F5F-3663-B01A-6D55-4B11F28951FD}"/>
              </a:ext>
            </a:extLst>
          </p:cNvPr>
          <p:cNvSpPr txBox="1"/>
          <p:nvPr/>
        </p:nvSpPr>
        <p:spPr>
          <a:xfrm>
            <a:off x="3810510" y="2537005"/>
            <a:ext cx="468600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/>
              <a:t>D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18FD9AD9-22F8-AF57-0783-2506C8438A4C}"/>
              </a:ext>
            </a:extLst>
          </p:cNvPr>
          <p:cNvSpPr txBox="1"/>
          <p:nvPr/>
        </p:nvSpPr>
        <p:spPr>
          <a:xfrm>
            <a:off x="1379772" y="7966839"/>
            <a:ext cx="1093940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b="1"/>
              <a:t>Myeloid Cells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18FD9AD9-22F8-AF57-0783-2506C8438A4C}"/>
              </a:ext>
            </a:extLst>
          </p:cNvPr>
          <p:cNvSpPr txBox="1"/>
          <p:nvPr/>
        </p:nvSpPr>
        <p:spPr>
          <a:xfrm>
            <a:off x="5020674" y="7976169"/>
            <a:ext cx="1542741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b="1" dirty="0"/>
              <a:t>Endothelial 1 Cells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17840EB8-9264-C72A-00BE-B25D86437E81}"/>
              </a:ext>
            </a:extLst>
          </p:cNvPr>
          <p:cNvGrpSpPr/>
          <p:nvPr/>
        </p:nvGrpSpPr>
        <p:grpSpPr>
          <a:xfrm>
            <a:off x="4044629" y="2899480"/>
            <a:ext cx="2879775" cy="2806704"/>
            <a:chOff x="5579445" y="3560081"/>
            <a:chExt cx="3991286" cy="3050977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A9D98A7E-38B5-19CF-7F66-CF0289B70A81}"/>
                </a:ext>
              </a:extLst>
            </p:cNvPr>
            <p:cNvSpPr txBox="1"/>
            <p:nvPr/>
          </p:nvSpPr>
          <p:spPr>
            <a:xfrm>
              <a:off x="6492246" y="3560081"/>
              <a:ext cx="21656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Keratinocytes</a:t>
              </a:r>
            </a:p>
          </p:txBody>
        </p:sp>
        <p:pic>
          <p:nvPicPr>
            <p:cNvPr id="10" name="Picture 9" descr="A graph showing a path of signals&#10;&#10;Description automatically generated with medium confidence">
              <a:extLst>
                <a:ext uri="{FF2B5EF4-FFF2-40B4-BE49-F238E27FC236}">
                  <a16:creationId xmlns:a16="http://schemas.microsoft.com/office/drawing/2014/main" xmlns="" id="{7A315344-C95A-5163-C29B-02CCBE0A4E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2702"/>
            <a:stretch/>
          </p:blipFill>
          <p:spPr>
            <a:xfrm>
              <a:off x="5579445" y="3867858"/>
              <a:ext cx="3991286" cy="2743200"/>
            </a:xfrm>
            <a:prstGeom prst="rect">
              <a:avLst/>
            </a:prstGeom>
          </p:spPr>
        </p:pic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18CE6C1A-A2DC-DFC4-110C-58BEF89FF92C}"/>
              </a:ext>
            </a:extLst>
          </p:cNvPr>
          <p:cNvGrpSpPr/>
          <p:nvPr/>
        </p:nvGrpSpPr>
        <p:grpSpPr>
          <a:xfrm>
            <a:off x="4037593" y="233283"/>
            <a:ext cx="2865885" cy="2756473"/>
            <a:chOff x="5605127" y="310534"/>
            <a:chExt cx="3972035" cy="2996374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510653BD-8125-1629-E541-9AF016F26175}"/>
                </a:ext>
              </a:extLst>
            </p:cNvPr>
            <p:cNvSpPr txBox="1"/>
            <p:nvPr/>
          </p:nvSpPr>
          <p:spPr>
            <a:xfrm>
              <a:off x="6492246" y="310534"/>
              <a:ext cx="21656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Melanocytes</a:t>
              </a:r>
            </a:p>
          </p:txBody>
        </p:sp>
        <p:pic>
          <p:nvPicPr>
            <p:cNvPr id="13" name="Picture 12" descr="A graph with blue squares and black text&#10;&#10;Description automatically generated">
              <a:extLst>
                <a:ext uri="{FF2B5EF4-FFF2-40B4-BE49-F238E27FC236}">
                  <a16:creationId xmlns:a16="http://schemas.microsoft.com/office/drawing/2014/main" xmlns="" id="{9B0AA9C8-0227-1B5C-985B-002AFD67D2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3122"/>
            <a:stretch/>
          </p:blipFill>
          <p:spPr>
            <a:xfrm>
              <a:off x="5605127" y="563708"/>
              <a:ext cx="3972035" cy="2743200"/>
            </a:xfrm>
            <a:prstGeom prst="rect">
              <a:avLst/>
            </a:prstGeom>
          </p:spPr>
        </p:pic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947CFD3B-7585-9FAE-D2C4-023A8A7ED1FD}"/>
              </a:ext>
            </a:extLst>
          </p:cNvPr>
          <p:cNvGrpSpPr/>
          <p:nvPr/>
        </p:nvGrpSpPr>
        <p:grpSpPr>
          <a:xfrm>
            <a:off x="360703" y="2936698"/>
            <a:ext cx="2926074" cy="2806703"/>
            <a:chOff x="770010" y="3560082"/>
            <a:chExt cx="4055455" cy="3050976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6A0C9F56-EC76-2AB7-5BA1-6C5A52036AE1}"/>
                </a:ext>
              </a:extLst>
            </p:cNvPr>
            <p:cNvSpPr txBox="1"/>
            <p:nvPr/>
          </p:nvSpPr>
          <p:spPr>
            <a:xfrm>
              <a:off x="1633092" y="3560082"/>
              <a:ext cx="21656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Pericytes</a:t>
              </a:r>
            </a:p>
          </p:txBody>
        </p:sp>
        <p:pic>
          <p:nvPicPr>
            <p:cNvPr id="16" name="Picture 15" descr="A diagram of a path&#10;&#10;Description automatically generated">
              <a:extLst>
                <a:ext uri="{FF2B5EF4-FFF2-40B4-BE49-F238E27FC236}">
                  <a16:creationId xmlns:a16="http://schemas.microsoft.com/office/drawing/2014/main" xmlns="" id="{36C63BBF-E5C0-B049-5C44-A2FE2945ECF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1298"/>
            <a:stretch/>
          </p:blipFill>
          <p:spPr>
            <a:xfrm>
              <a:off x="770010" y="3867858"/>
              <a:ext cx="4055455" cy="2743200"/>
            </a:xfrm>
            <a:prstGeom prst="rect">
              <a:avLst/>
            </a:prstGeom>
          </p:spPr>
        </p:pic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16155895-9E51-2D71-9FA2-1428D4A89CD2}"/>
              </a:ext>
            </a:extLst>
          </p:cNvPr>
          <p:cNvSpPr txBox="1"/>
          <p:nvPr/>
        </p:nvSpPr>
        <p:spPr>
          <a:xfrm>
            <a:off x="3923709" y="5570082"/>
            <a:ext cx="817616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dirty="0"/>
              <a:t>F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9DBB4F3A-6607-8DC8-FC6C-ADD9098772F0}"/>
              </a:ext>
            </a:extLst>
          </p:cNvPr>
          <p:cNvSpPr txBox="1"/>
          <p:nvPr/>
        </p:nvSpPr>
        <p:spPr>
          <a:xfrm>
            <a:off x="208637" y="5571725"/>
            <a:ext cx="639058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dirty="0"/>
              <a:t>E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C982D55B-4296-138A-A654-A29B84237D00}"/>
              </a:ext>
            </a:extLst>
          </p:cNvPr>
          <p:cNvSpPr txBox="1"/>
          <p:nvPr/>
        </p:nvSpPr>
        <p:spPr>
          <a:xfrm>
            <a:off x="208637" y="7830737"/>
            <a:ext cx="925952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dirty="0"/>
              <a:t>G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CB38EFE2-CAC0-B712-55F0-E92A3ACA65A8}"/>
              </a:ext>
            </a:extLst>
          </p:cNvPr>
          <p:cNvSpPr txBox="1"/>
          <p:nvPr/>
        </p:nvSpPr>
        <p:spPr>
          <a:xfrm>
            <a:off x="3962910" y="7852870"/>
            <a:ext cx="468600" cy="2689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dirty="0"/>
              <a:t>H)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xmlns="" id="{69E824D8-0458-7F51-8F55-3A7D4FDF5466}"/>
              </a:ext>
            </a:extLst>
          </p:cNvPr>
          <p:cNvGrpSpPr/>
          <p:nvPr/>
        </p:nvGrpSpPr>
        <p:grpSpPr>
          <a:xfrm>
            <a:off x="375766" y="213623"/>
            <a:ext cx="2865885" cy="2776133"/>
            <a:chOff x="811721" y="147479"/>
            <a:chExt cx="3972035" cy="3150439"/>
          </a:xfrm>
        </p:grpSpPr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CABA4E25-7E2D-49FD-4CCC-F0595CC29BFA}"/>
                </a:ext>
              </a:extLst>
            </p:cNvPr>
            <p:cNvSpPr txBox="1"/>
            <p:nvPr/>
          </p:nvSpPr>
          <p:spPr>
            <a:xfrm>
              <a:off x="1698105" y="147479"/>
              <a:ext cx="2165684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Endothelial Cells 2</a:t>
              </a:r>
            </a:p>
          </p:txBody>
        </p:sp>
        <p:pic>
          <p:nvPicPr>
            <p:cNvPr id="36" name="Picture 35" descr="A diagram of a path&#10;&#10;Description automatically generated">
              <a:extLst>
                <a:ext uri="{FF2B5EF4-FFF2-40B4-BE49-F238E27FC236}">
                  <a16:creationId xmlns:a16="http://schemas.microsoft.com/office/drawing/2014/main" xmlns="" id="{17E94A66-87C5-BAED-0943-FE2A048BFA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3122"/>
            <a:stretch/>
          </p:blipFill>
          <p:spPr>
            <a:xfrm>
              <a:off x="811721" y="554718"/>
              <a:ext cx="3972035" cy="27432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29061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Content Placeholder 6" descr="A group of black and white lines&#10;&#10;Description automatically generated">
            <a:extLst>
              <a:ext uri="{FF2B5EF4-FFF2-40B4-BE49-F238E27FC236}">
                <a16:creationId xmlns:a16="http://schemas.microsoft.com/office/drawing/2014/main" xmlns="" id="{5AD8BDC3-F54C-F452-E380-1386A5C9FCA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3549" y="713426"/>
            <a:ext cx="5965302" cy="8631548"/>
          </a:xfrm>
        </p:spPr>
      </p:pic>
    </p:spTree>
    <p:extLst>
      <p:ext uri="{BB962C8B-B14F-4D97-AF65-F5344CB8AC3E}">
        <p14:creationId xmlns:p14="http://schemas.microsoft.com/office/powerpoint/2010/main" val="2808757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 up of a pattern&#10;&#10;Description automatically generated">
            <a:extLst>
              <a:ext uri="{FF2B5EF4-FFF2-40B4-BE49-F238E27FC236}">
                <a16:creationId xmlns:a16="http://schemas.microsoft.com/office/drawing/2014/main" xmlns="" id="{0C419375-0AEA-CD9E-18D4-7B97D28B7C2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69" y="1817810"/>
            <a:ext cx="3694668" cy="184733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6135CD6-50F6-1748-3C7D-EF1408E10B06}"/>
              </a:ext>
            </a:extLst>
          </p:cNvPr>
          <p:cNvSpPr txBox="1"/>
          <p:nvPr/>
        </p:nvSpPr>
        <p:spPr>
          <a:xfrm>
            <a:off x="531341" y="1110393"/>
            <a:ext cx="16300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 Ligand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509A5B7D-FEA3-F67B-7CA3-33900C29DA88}"/>
              </a:ext>
            </a:extLst>
          </p:cNvPr>
          <p:cNvSpPr txBox="1"/>
          <p:nvPr/>
        </p:nvSpPr>
        <p:spPr>
          <a:xfrm>
            <a:off x="4359070" y="1110393"/>
            <a:ext cx="18635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 Receptor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03871C3-F862-DE82-470C-BFF14891FE8D}"/>
              </a:ext>
            </a:extLst>
          </p:cNvPr>
          <p:cNvSpPr txBox="1"/>
          <p:nvPr/>
        </p:nvSpPr>
        <p:spPr>
          <a:xfrm>
            <a:off x="531341" y="4524283"/>
            <a:ext cx="1647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reated Ligand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CC4B8E0E-9BBB-32AB-199C-EBC9ADFE6A8F}"/>
              </a:ext>
            </a:extLst>
          </p:cNvPr>
          <p:cNvSpPr txBox="1"/>
          <p:nvPr/>
        </p:nvSpPr>
        <p:spPr>
          <a:xfrm>
            <a:off x="4359070" y="4524283"/>
            <a:ext cx="18810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reated Receptors</a:t>
            </a:r>
          </a:p>
        </p:txBody>
      </p:sp>
      <p:pic>
        <p:nvPicPr>
          <p:cNvPr id="13" name="Picture 12" descr="A close up of a pattern&#10;&#10;Description automatically generated">
            <a:extLst>
              <a:ext uri="{FF2B5EF4-FFF2-40B4-BE49-F238E27FC236}">
                <a16:creationId xmlns:a16="http://schemas.microsoft.com/office/drawing/2014/main" xmlns="" id="{A4DEBE30-019A-021B-98CD-48B4B7DEAF4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1705588"/>
            <a:ext cx="3919111" cy="1959556"/>
          </a:xfrm>
          <a:prstGeom prst="rect">
            <a:avLst/>
          </a:prstGeom>
        </p:spPr>
      </p:pic>
      <p:pic>
        <p:nvPicPr>
          <p:cNvPr id="15" name="Picture 14" descr="A close up of a pattern&#10;&#10;Description automatically generated">
            <a:extLst>
              <a:ext uri="{FF2B5EF4-FFF2-40B4-BE49-F238E27FC236}">
                <a16:creationId xmlns:a16="http://schemas.microsoft.com/office/drawing/2014/main" xmlns="" id="{5D2CFD5E-CE1C-73D8-EC09-DBCBFDFA1D3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141" y="5119477"/>
            <a:ext cx="3694670" cy="1847335"/>
          </a:xfrm>
          <a:prstGeom prst="rect">
            <a:avLst/>
          </a:prstGeom>
        </p:spPr>
      </p:pic>
      <p:pic>
        <p:nvPicPr>
          <p:cNvPr id="17" name="Picture 16" descr="A close up of a pattern&#10;&#10;Description automatically generated">
            <a:extLst>
              <a:ext uri="{FF2B5EF4-FFF2-40B4-BE49-F238E27FC236}">
                <a16:creationId xmlns:a16="http://schemas.microsoft.com/office/drawing/2014/main" xmlns="" id="{20A035A1-E9CA-7558-807A-3AC5E5A13D4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3589" y="5119478"/>
            <a:ext cx="3694670" cy="18473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1939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7D28070D-D6A7-3CA5-D3C1-57179F9960F9}"/>
              </a:ext>
            </a:extLst>
          </p:cNvPr>
          <p:cNvGrpSpPr/>
          <p:nvPr/>
        </p:nvGrpSpPr>
        <p:grpSpPr>
          <a:xfrm>
            <a:off x="95057" y="2919778"/>
            <a:ext cx="1849807" cy="4568417"/>
            <a:chOff x="363218" y="205570"/>
            <a:chExt cx="2150227" cy="6601630"/>
          </a:xfrm>
        </p:grpSpPr>
        <p:pic>
          <p:nvPicPr>
            <p:cNvPr id="5" name="Picture 4" descr="A green and white rectangular pattern&#10;&#10;Description automatically generated">
              <a:extLst>
                <a:ext uri="{FF2B5EF4-FFF2-40B4-BE49-F238E27FC236}">
                  <a16:creationId xmlns:a16="http://schemas.microsoft.com/office/drawing/2014/main" xmlns="" id="{1EDC2B48-540C-FD02-42F7-F8FB32BB18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91" r="6926"/>
            <a:stretch/>
          </p:blipFill>
          <p:spPr>
            <a:xfrm>
              <a:off x="363218" y="406400"/>
              <a:ext cx="2150227" cy="64008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89EAE03E-2044-30CF-E661-0148F0844DDA}"/>
                </a:ext>
              </a:extLst>
            </p:cNvPr>
            <p:cNvSpPr txBox="1"/>
            <p:nvPr/>
          </p:nvSpPr>
          <p:spPr>
            <a:xfrm>
              <a:off x="847667" y="205570"/>
              <a:ext cx="1025237" cy="4219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8"/>
                <a:t>Control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8DA49533-3516-88F8-6105-144292DA4263}"/>
              </a:ext>
            </a:extLst>
          </p:cNvPr>
          <p:cNvGrpSpPr/>
          <p:nvPr/>
        </p:nvGrpSpPr>
        <p:grpSpPr>
          <a:xfrm>
            <a:off x="3960058" y="2919778"/>
            <a:ext cx="1967313" cy="4593132"/>
            <a:chOff x="3289992" y="43934"/>
            <a:chExt cx="2150226" cy="6585466"/>
          </a:xfrm>
        </p:grpSpPr>
        <p:pic>
          <p:nvPicPr>
            <p:cNvPr id="9" name="Picture 8" descr="A green and black rectangular pattern&#10;&#10;Description automatically generated with medium confidence">
              <a:extLst>
                <a:ext uri="{FF2B5EF4-FFF2-40B4-BE49-F238E27FC236}">
                  <a16:creationId xmlns:a16="http://schemas.microsoft.com/office/drawing/2014/main" xmlns="" id="{D67AA83C-219C-F0C3-E5C1-F4F60941B3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98" r="7720"/>
            <a:stretch/>
          </p:blipFill>
          <p:spPr>
            <a:xfrm>
              <a:off x="3289992" y="228600"/>
              <a:ext cx="2150226" cy="640080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B02D41B4-AD06-A571-1D9F-5451A661362A}"/>
                </a:ext>
              </a:extLst>
            </p:cNvPr>
            <p:cNvSpPr txBox="1"/>
            <p:nvPr/>
          </p:nvSpPr>
          <p:spPr>
            <a:xfrm>
              <a:off x="3817390" y="43934"/>
              <a:ext cx="1025238" cy="4219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8"/>
                <a:t>Treated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xmlns="" id="{56AF93CB-2DBB-D314-279F-35DEA2DE0C8F}"/>
              </a:ext>
            </a:extLst>
          </p:cNvPr>
          <p:cNvGrpSpPr/>
          <p:nvPr/>
        </p:nvGrpSpPr>
        <p:grpSpPr>
          <a:xfrm>
            <a:off x="5868607" y="2924931"/>
            <a:ext cx="1738487" cy="4563264"/>
            <a:chOff x="8807334" y="120103"/>
            <a:chExt cx="2150228" cy="6601630"/>
          </a:xfrm>
        </p:grpSpPr>
        <p:pic>
          <p:nvPicPr>
            <p:cNvPr id="15" name="Picture 14" descr="A green and white rectangular pattern&#10;&#10;Description automatically generated">
              <a:extLst>
                <a:ext uri="{FF2B5EF4-FFF2-40B4-BE49-F238E27FC236}">
                  <a16:creationId xmlns:a16="http://schemas.microsoft.com/office/drawing/2014/main" xmlns="" id="{E650BE2E-EA5A-21B3-4099-424053D9B0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67" r="7450"/>
            <a:stretch/>
          </p:blipFill>
          <p:spPr>
            <a:xfrm>
              <a:off x="8807334" y="320933"/>
              <a:ext cx="2150228" cy="640080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AA0A51AA-B3ED-E36B-5936-233F7AB97C09}"/>
                </a:ext>
              </a:extLst>
            </p:cNvPr>
            <p:cNvSpPr txBox="1"/>
            <p:nvPr/>
          </p:nvSpPr>
          <p:spPr>
            <a:xfrm>
              <a:off x="9355515" y="120103"/>
              <a:ext cx="1025236" cy="4219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8"/>
                <a:t>Treated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xmlns="" id="{C65E8ABB-C079-7E05-9F04-6A3EC72EBF95}"/>
              </a:ext>
            </a:extLst>
          </p:cNvPr>
          <p:cNvGrpSpPr/>
          <p:nvPr/>
        </p:nvGrpSpPr>
        <p:grpSpPr>
          <a:xfrm>
            <a:off x="1934265" y="2895063"/>
            <a:ext cx="1951935" cy="4568417"/>
            <a:chOff x="6301045" y="120103"/>
            <a:chExt cx="2150227" cy="6601630"/>
          </a:xfrm>
        </p:grpSpPr>
        <p:pic>
          <p:nvPicPr>
            <p:cNvPr id="13" name="Picture 12" descr="A green and white rectangles&#10;&#10;Description automatically generated">
              <a:extLst>
                <a:ext uri="{FF2B5EF4-FFF2-40B4-BE49-F238E27FC236}">
                  <a16:creationId xmlns:a16="http://schemas.microsoft.com/office/drawing/2014/main" xmlns="" id="{DBBCC3FD-2827-6068-F74E-3051D7D4DA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84" r="8332"/>
            <a:stretch/>
          </p:blipFill>
          <p:spPr>
            <a:xfrm>
              <a:off x="6301045" y="320933"/>
              <a:ext cx="2150227" cy="6400800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E084230D-9E0B-6BA7-1827-4B77FBB8C5FF}"/>
                </a:ext>
              </a:extLst>
            </p:cNvPr>
            <p:cNvSpPr txBox="1"/>
            <p:nvPr/>
          </p:nvSpPr>
          <p:spPr>
            <a:xfrm>
              <a:off x="6871853" y="120103"/>
              <a:ext cx="1025237" cy="4219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48"/>
                <a:t>Contro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062498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graph of cell growth&#10;&#10;Description automatically generated with medium confidence">
            <a:extLst>
              <a:ext uri="{FF2B5EF4-FFF2-40B4-BE49-F238E27FC236}">
                <a16:creationId xmlns:a16="http://schemas.microsoft.com/office/drawing/2014/main" xmlns="" id="{D86D63FB-9734-D7DD-117E-25F896756A6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801" y="3018137"/>
            <a:ext cx="3770344" cy="2827757"/>
          </a:xfrm>
        </p:spPr>
      </p:pic>
      <p:pic>
        <p:nvPicPr>
          <p:cNvPr id="7" name="Picture 6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xmlns="" id="{772AB83A-CD73-976F-5D41-C27476292CA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9001" y="2008810"/>
            <a:ext cx="3553399" cy="604078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11B02067-5C15-3D69-F86D-2D30C9928328}"/>
              </a:ext>
            </a:extLst>
          </p:cNvPr>
          <p:cNvSpPr/>
          <p:nvPr/>
        </p:nvSpPr>
        <p:spPr>
          <a:xfrm>
            <a:off x="1206500" y="4445000"/>
            <a:ext cx="1336675" cy="857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0B0DEBFD-5C71-67A4-7404-769E3C545DE8}"/>
              </a:ext>
            </a:extLst>
          </p:cNvPr>
          <p:cNvSpPr/>
          <p:nvPr/>
        </p:nvSpPr>
        <p:spPr>
          <a:xfrm>
            <a:off x="650875" y="4090045"/>
            <a:ext cx="1927225" cy="857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xmlns="" id="{11B02067-5C15-3D69-F86D-2D30C9928328}"/>
              </a:ext>
            </a:extLst>
          </p:cNvPr>
          <p:cNvSpPr/>
          <p:nvPr/>
        </p:nvSpPr>
        <p:spPr>
          <a:xfrm>
            <a:off x="1092200" y="5407025"/>
            <a:ext cx="1336675" cy="857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4391030" y="587216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391030" y="7100885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291590" y="6610347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291590" y="5312487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444561" y="4717177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328705" y="4576602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301688" y="2447492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B30F360D-07B2-83DE-DF54-F5E00B7E5617}"/>
              </a:ext>
            </a:extLst>
          </p:cNvPr>
          <p:cNvSpPr txBox="1"/>
          <p:nvPr/>
        </p:nvSpPr>
        <p:spPr>
          <a:xfrm>
            <a:off x="357338" y="2572356"/>
            <a:ext cx="680035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200" dirty="0">
                <a:cs typeface="Calibri"/>
              </a:rPr>
              <a:t>A</a:t>
            </a:r>
            <a:endParaRPr lang="en-US" sz="12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C778D716-1B0D-763E-F1E8-DBBF6BE5059B}"/>
              </a:ext>
            </a:extLst>
          </p:cNvPr>
          <p:cNvSpPr txBox="1"/>
          <p:nvPr/>
        </p:nvSpPr>
        <p:spPr>
          <a:xfrm>
            <a:off x="4090907" y="1630198"/>
            <a:ext cx="680035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200" dirty="0">
                <a:cs typeface="Calibri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533560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561B96906EFEC47B1D263A3D6B277AD" ma:contentTypeVersion="17" ma:contentTypeDescription="Create a new document." ma:contentTypeScope="" ma:versionID="4cb9f0348524dd15b89aaae89cc53763">
  <xsd:schema xmlns:xsd="http://www.w3.org/2001/XMLSchema" xmlns:xs="http://www.w3.org/2001/XMLSchema" xmlns:p="http://schemas.microsoft.com/office/2006/metadata/properties" xmlns:ns3="c7572b7e-25bd-4ac4-af75-f178f188d268" xmlns:ns4="71b0d506-90e4-470b-addb-1f87510432bf" targetNamespace="http://schemas.microsoft.com/office/2006/metadata/properties" ma:root="true" ma:fieldsID="62318bc7f80e7f0e3f4eb3e3f85f1fea" ns3:_="" ns4:_="">
    <xsd:import namespace="c7572b7e-25bd-4ac4-af75-f178f188d268"/>
    <xsd:import namespace="71b0d506-90e4-470b-addb-1f87510432bf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OCR" minOccurs="0"/>
                <xsd:element ref="ns4:MediaServiceEventHashCode" minOccurs="0"/>
                <xsd:element ref="ns4:MediaServiceGenerationTime" minOccurs="0"/>
                <xsd:element ref="ns4:MediaServiceAutoKeyPoints" minOccurs="0"/>
                <xsd:element ref="ns4:MediaServiceKeyPoints" minOccurs="0"/>
                <xsd:element ref="ns4:MediaServiceLocation" minOccurs="0"/>
                <xsd:element ref="ns4:_activity" minOccurs="0"/>
                <xsd:element ref="ns4:MediaLengthInSeconds" minOccurs="0"/>
                <xsd:element ref="ns4:MediaServiceObjectDetectorVersions" minOccurs="0"/>
                <xsd:element ref="ns4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7572b7e-25bd-4ac4-af75-f178f188d268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1b0d506-90e4-470b-addb-1f87510432b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4" nillable="true" ma:displayName="MediaServiceAutoTags" ma:description="" ma:internalName="MediaServiceAutoTags" ma:readOnly="true">
      <xsd:simpleType>
        <xsd:restriction base="dms:Text"/>
      </xsd:simpleType>
    </xsd:element>
    <xsd:element name="MediaServiceOCR" ma:index="15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71b0d506-90e4-470b-addb-1f87510432bf" xsi:nil="true"/>
  </documentManagement>
</p:properties>
</file>

<file path=customXml/itemProps1.xml><?xml version="1.0" encoding="utf-8"?>
<ds:datastoreItem xmlns:ds="http://schemas.openxmlformats.org/officeDocument/2006/customXml" ds:itemID="{283643FF-83CE-4F33-A1A8-0446D1FF137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7572b7e-25bd-4ac4-af75-f178f188d268"/>
    <ds:schemaRef ds:uri="71b0d506-90e4-470b-addb-1f87510432b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0F1B6C46-3F1B-44D1-B3B6-78BD210CBFE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9C6ECBF-6711-49A2-8073-43DE491F8D45}">
  <ds:schemaRefs>
    <ds:schemaRef ds:uri="http://purl.org/dc/dcmitype/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purl.org/dc/terms/"/>
    <ds:schemaRef ds:uri="http://schemas.microsoft.com/office/2006/documentManagement/types"/>
    <ds:schemaRef ds:uri="http://schemas.openxmlformats.org/package/2006/metadata/core-properties"/>
    <ds:schemaRef ds:uri="71b0d506-90e4-470b-addb-1f87510432bf"/>
    <ds:schemaRef ds:uri="c7572b7e-25bd-4ac4-af75-f178f188d268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19</TotalTime>
  <Words>183</Words>
  <Application>Microsoft Office PowerPoint</Application>
  <PresentationFormat>Custom</PresentationFormat>
  <Paragraphs>49</Paragraphs>
  <Slides>7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Supplemental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for cNF Paper</dc:title>
  <dc:creator>Church, Cameron Lee</dc:creator>
  <cp:lastModifiedBy>Sagashreshvaran S Shankar R</cp:lastModifiedBy>
  <cp:revision>44</cp:revision>
  <dcterms:created xsi:type="dcterms:W3CDTF">2023-08-19T23:28:51Z</dcterms:created>
  <dcterms:modified xsi:type="dcterms:W3CDTF">2024-06-13T04:44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561B96906EFEC47B1D263A3D6B277AD</vt:lpwstr>
  </property>
</Properties>
</file>